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5" d="100"/>
          <a:sy n="95" d="100"/>
        </p:scale>
        <p:origin x="44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uti Kanste" userId="S::okanste@univ.yo.oulu.fi::5a27512f-7597-4f2d-8106-1c09e87ac418" providerId="AD" clId="Web-{E1897C27-1C09-43DE-8166-EB00545FF1AE}"/>
    <pc:docChg chg="modSld">
      <pc:chgData name="Outi Kanste" userId="S::okanste@univ.yo.oulu.fi::5a27512f-7597-4f2d-8106-1c09e87ac418" providerId="AD" clId="Web-{E1897C27-1C09-43DE-8166-EB00545FF1AE}" dt="2026-02-19T04:34:17.341" v="0" actId="20577"/>
      <pc:docMkLst>
        <pc:docMk/>
      </pc:docMkLst>
      <pc:sldChg chg="modSp">
        <pc:chgData name="Outi Kanste" userId="S::okanste@univ.yo.oulu.fi::5a27512f-7597-4f2d-8106-1c09e87ac418" providerId="AD" clId="Web-{E1897C27-1C09-43DE-8166-EB00545FF1AE}" dt="2026-02-19T04:34:17.341" v="0" actId="20577"/>
        <pc:sldMkLst>
          <pc:docMk/>
          <pc:sldMk cId="726214043" sldId="260"/>
        </pc:sldMkLst>
        <pc:graphicFrameChg chg="modGraphic">
          <ac:chgData name="Outi Kanste" userId="S::okanste@univ.yo.oulu.fi::5a27512f-7597-4f2d-8106-1c09e87ac418" providerId="AD" clId="Web-{E1897C27-1C09-43DE-8166-EB00545FF1AE}" dt="2026-02-19T04:34:17.341" v="0" actId="20577"/>
          <ac:graphicFrameMkLst>
            <pc:docMk/>
            <pc:sldMk cId="726214043" sldId="260"/>
            <ac:graphicFrameMk id="5" creationId="{38DC22AF-B9D7-843C-EBEC-A9AB656AECEF}"/>
          </ac:graphicFrameMkLst>
        </pc:graphicFrameChg>
      </pc:sldChg>
    </pc:docChg>
  </pc:docChgLst>
  <pc:docChgLst>
    <pc:chgData name="Outi Kanste" userId="5a27512f-7597-4f2d-8106-1c09e87ac418" providerId="ADAL" clId="{34A5ABE1-39FF-4956-985E-847BD423F6A1}"/>
    <pc:docChg chg="custSel modSld">
      <pc:chgData name="Outi Kanste" userId="5a27512f-7597-4f2d-8106-1c09e87ac418" providerId="ADAL" clId="{34A5ABE1-39FF-4956-985E-847BD423F6A1}" dt="2026-02-19T05:36:37.419" v="8" actId="20577"/>
      <pc:docMkLst>
        <pc:docMk/>
      </pc:docMkLst>
      <pc:sldChg chg="modSp mod">
        <pc:chgData name="Outi Kanste" userId="5a27512f-7597-4f2d-8106-1c09e87ac418" providerId="ADAL" clId="{34A5ABE1-39FF-4956-985E-847BD423F6A1}" dt="2026-02-19T05:36:37.419" v="8" actId="20577"/>
        <pc:sldMkLst>
          <pc:docMk/>
          <pc:sldMk cId="726214043" sldId="260"/>
        </pc:sldMkLst>
        <pc:graphicFrameChg chg="modGraphic">
          <ac:chgData name="Outi Kanste" userId="5a27512f-7597-4f2d-8106-1c09e87ac418" providerId="ADAL" clId="{34A5ABE1-39FF-4956-985E-847BD423F6A1}" dt="2026-02-19T05:36:37.419" v="8" actId="20577"/>
          <ac:graphicFrameMkLst>
            <pc:docMk/>
            <pc:sldMk cId="726214043" sldId="260"/>
            <ac:graphicFrameMk id="5" creationId="{38DC22AF-B9D7-843C-EBEC-A9AB656AECEF}"/>
          </ac:graphicFrameMkLst>
        </pc:graphicFrameChg>
      </pc:sldChg>
    </pc:docChg>
  </pc:docChgLst>
</pc:chgInfo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3">
  <dgm:title val=""/>
  <dgm:desc val=""/>
  <dgm:catLst>
    <dgm:cat type="mainScheme" pri="10300"/>
  </dgm:catLst>
  <dgm:styleLbl name="node0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lignNode1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node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lnNode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vennNode1">
    <dgm:fillClrLst meth="repeat">
      <a:schemeClr val="dk2">
        <a:alpha val="50000"/>
      </a:schemeClr>
    </dgm:fillClrLst>
    <dgm:linClrLst meth="repeat">
      <a:schemeClr val="lt2"/>
    </dgm:linClrLst>
    <dgm:effectClrLst/>
    <dgm:txLinClrLst/>
    <dgm:txFillClrLst/>
    <dgm:txEffectClrLst/>
  </dgm:styleLbl>
  <dgm:styleLbl name="node2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node3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node4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fgImgPlace1">
    <dgm:fillClrLst meth="repeat">
      <a:schemeClr val="dk2">
        <a:tint val="50000"/>
      </a:schemeClr>
    </dgm:fillClrLst>
    <dgm:linClrLst meth="repeat">
      <a:schemeClr val="lt2"/>
    </dgm:linClrLst>
    <dgm:effectClrLst/>
    <dgm:txLinClrLst/>
    <dgm:txFillClrLst meth="repeat">
      <a:schemeClr val="lt2"/>
    </dgm:txFillClrLst>
    <dgm:txEffectClrLst/>
  </dgm:styleLbl>
  <dgm:styleLbl name="alignImgPlace1">
    <dgm:fillClrLst meth="repeat">
      <a:schemeClr val="dk2">
        <a:tint val="5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2"/>
    </dgm:txFillClrLst>
    <dgm:txEffectClrLst/>
  </dgm:styleLbl>
  <dgm:styleLbl name="bgImgPlace1">
    <dgm:fillClrLst meth="repeat">
      <a:schemeClr val="dk2">
        <a:tint val="5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2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callout">
    <dgm:fillClrLst meth="repeat">
      <a:schemeClr val="dk2"/>
    </dgm:fillClrLst>
    <dgm:linClrLst meth="repeat">
      <a:schemeClr val="dk2">
        <a:tint val="50000"/>
      </a:schemeClr>
    </dgm:linClrLst>
    <dgm:effectClrLst/>
    <dgm:txLinClrLst/>
    <dgm:txFillClrLst meth="repeat">
      <a:schemeClr val="lt2"/>
    </dgm:txFillClrLst>
    <dgm:txEffectClrLst/>
  </dgm:styleLbl>
  <dgm:styleLbl name="asst0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2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3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4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lt2"/>
    </dgm:txFillClrLst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2">
        <a:alpha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2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2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93F0751-D47E-4BB9-B645-6BEEAFE2C817}" type="doc">
      <dgm:prSet loTypeId="urn:microsoft.com/office/officeart/2005/8/layout/hierarchy3" loCatId="hierarchy" qsTypeId="urn:microsoft.com/office/officeart/2005/8/quickstyle/simple1" qsCatId="simple" csTypeId="urn:microsoft.com/office/officeart/2005/8/colors/accent0_3" csCatId="mainScheme" phldr="1"/>
      <dgm:spPr/>
      <dgm:t>
        <a:bodyPr/>
        <a:lstStyle/>
        <a:p>
          <a:endParaRPr lang="fi-FI"/>
        </a:p>
      </dgm:t>
    </dgm:pt>
    <dgm:pt modelId="{297261F1-B47E-4081-8072-475D81429D3F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fi-FI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Developing leadership growth through onboarding</a:t>
          </a:r>
        </a:p>
      </dgm:t>
    </dgm:pt>
    <dgm:pt modelId="{65AF07E4-9CE7-456F-B0A0-CCA5B6EA9C41}" type="parTrans" cxnId="{DA205D1B-D030-4C7D-A83D-0C92CB60429A}">
      <dgm:prSet/>
      <dgm:spPr/>
      <dgm:t>
        <a:bodyPr/>
        <a:lstStyle/>
        <a:p>
          <a:endParaRPr lang="fi-FI"/>
        </a:p>
      </dgm:t>
    </dgm:pt>
    <dgm:pt modelId="{27756B92-734E-45A5-872E-99594912BCEE}" type="sibTrans" cxnId="{DA205D1B-D030-4C7D-A83D-0C92CB60429A}">
      <dgm:prSet/>
      <dgm:spPr/>
      <dgm:t>
        <a:bodyPr/>
        <a:lstStyle/>
        <a:p>
          <a:endParaRPr lang="fi-FI"/>
        </a:p>
      </dgm:t>
    </dgm:pt>
    <dgm:pt modelId="{9E929A1C-7E79-4F59-BF92-1EC752367064}">
      <dgm:prSet phldrT="[Text]" custT="1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Increasing motivation for the manager position with onboarding </a:t>
          </a:r>
        </a:p>
      </dgm:t>
    </dgm:pt>
    <dgm:pt modelId="{A50B0178-386D-4B04-97AC-0F1BA17C552B}" type="parTrans" cxnId="{63CAF0D3-832B-4F19-80C3-6F1D5F289524}">
      <dgm:prSet/>
      <dgm:spPr/>
      <dgm:t>
        <a:bodyPr/>
        <a:lstStyle/>
        <a:p>
          <a:endParaRPr lang="fi-FI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BFC792B-1CEB-4FBE-A8F6-E0B6286194E5}" type="sibTrans" cxnId="{63CAF0D3-832B-4F19-80C3-6F1D5F289524}">
      <dgm:prSet/>
      <dgm:spPr/>
      <dgm:t>
        <a:bodyPr/>
        <a:lstStyle/>
        <a:p>
          <a:endParaRPr lang="fi-FI"/>
        </a:p>
      </dgm:t>
    </dgm:pt>
    <dgm:pt modelId="{5EB792F6-8149-4598-BF41-27A8C76D4E62}">
      <dgm:prSet phldrT="[Text]" custT="1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Developing attachment to the role of manager 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754FF20-94C7-4043-8AD6-612DEBA9F151}" type="parTrans" cxnId="{E96F1264-2FBE-4B5C-8F21-48B96A7121AA}">
      <dgm:prSet/>
      <dgm:spPr>
        <a:ln>
          <a:solidFill>
            <a:schemeClr val="tx1"/>
          </a:solidFill>
        </a:ln>
      </dgm:spPr>
      <dgm:t>
        <a:bodyPr/>
        <a:lstStyle/>
        <a:p>
          <a:endParaRPr lang="fi-FI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998111D-14D5-4C53-B1A7-42363988C1AC}" type="sibTrans" cxnId="{E96F1264-2FBE-4B5C-8F21-48B96A7121AA}">
      <dgm:prSet/>
      <dgm:spPr/>
      <dgm:t>
        <a:bodyPr/>
        <a:lstStyle/>
        <a:p>
          <a:endParaRPr lang="fi-FI"/>
        </a:p>
      </dgm:t>
    </dgm:pt>
    <dgm:pt modelId="{080216A2-EFD9-4017-85D0-DD531BB8A780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fi-FI" dirty="0">
              <a:solidFill>
                <a:schemeClr val="tx1"/>
              </a:solidFill>
              <a:latin typeface="Times New Roman"/>
              <a:cs typeface="Times New Roman"/>
            </a:rPr>
            <a:t>Strengthening workplace bounds through onboarding</a:t>
          </a:r>
        </a:p>
      </dgm:t>
    </dgm:pt>
    <dgm:pt modelId="{18F5D4BE-AB2C-4969-ADD3-8D3D8F35CC32}" type="parTrans" cxnId="{ED5E65C4-1936-4E0F-BB21-82E9CF9C8B87}">
      <dgm:prSet/>
      <dgm:spPr/>
      <dgm:t>
        <a:bodyPr/>
        <a:lstStyle/>
        <a:p>
          <a:endParaRPr lang="fi-FI"/>
        </a:p>
      </dgm:t>
    </dgm:pt>
    <dgm:pt modelId="{EC203338-8153-45EB-B7DA-01C648C1EE18}" type="sibTrans" cxnId="{ED5E65C4-1936-4E0F-BB21-82E9CF9C8B87}">
      <dgm:prSet/>
      <dgm:spPr/>
      <dgm:t>
        <a:bodyPr/>
        <a:lstStyle/>
        <a:p>
          <a:endParaRPr lang="fi-FI"/>
        </a:p>
      </dgm:t>
    </dgm:pt>
    <dgm:pt modelId="{F36AE307-C90B-4AB6-A594-E607BC09EF70}">
      <dgm:prSet/>
      <dgm:spPr>
        <a:noFill/>
        <a:ln>
          <a:solidFill>
            <a:schemeClr val="tx1"/>
          </a:solidFill>
        </a:ln>
      </dgm:spPr>
      <dgm:t>
        <a:bodyPr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fi-FI" dirty="0">
              <a:solidFill>
                <a:schemeClr val="tx1"/>
              </a:solidFill>
              <a:latin typeface="Times New Roman"/>
              <a:cs typeface="Times New Roman"/>
            </a:rPr>
            <a:t>Ensuring well-rounded onboarding support</a:t>
          </a:r>
          <a:endParaRPr lang="fi-FI" dirty="0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B7C2F43-750A-4A8C-9945-E2AD3F81E77F}" type="parTrans" cxnId="{0C88727F-394A-4E98-94A2-1E987A7BB28E}">
      <dgm:prSet/>
      <dgm:spPr/>
      <dgm:t>
        <a:bodyPr/>
        <a:lstStyle/>
        <a:p>
          <a:endParaRPr lang="fi-FI"/>
        </a:p>
      </dgm:t>
    </dgm:pt>
    <dgm:pt modelId="{15451F22-553A-44F3-B3E5-A2E71543CE5A}" type="sibTrans" cxnId="{0C88727F-394A-4E98-94A2-1E987A7BB28E}">
      <dgm:prSet/>
      <dgm:spPr/>
      <dgm:t>
        <a:bodyPr/>
        <a:lstStyle/>
        <a:p>
          <a:endParaRPr lang="fi-FI"/>
        </a:p>
      </dgm:t>
    </dgm:pt>
    <dgm:pt modelId="{DC867B4B-A820-42FF-BACF-A0E8628C5955}">
      <dgm:prSet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fi-FI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larifying leadership foundations in onboarding</a:t>
          </a:r>
        </a:p>
      </dgm:t>
    </dgm:pt>
    <dgm:pt modelId="{66CB9B47-1B6F-4AF4-AF7E-8E7C8D771BE0}" type="parTrans" cxnId="{051EE112-55BA-4737-B45A-C4723C2D6FEA}">
      <dgm:prSet/>
      <dgm:spPr/>
      <dgm:t>
        <a:bodyPr/>
        <a:lstStyle/>
        <a:p>
          <a:endParaRPr lang="fi-FI"/>
        </a:p>
      </dgm:t>
    </dgm:pt>
    <dgm:pt modelId="{13E4B097-3195-4682-9FD2-E6407A5671E7}" type="sibTrans" cxnId="{051EE112-55BA-4737-B45A-C4723C2D6FEA}">
      <dgm:prSet/>
      <dgm:spPr/>
      <dgm:t>
        <a:bodyPr/>
        <a:lstStyle/>
        <a:p>
          <a:endParaRPr lang="fi-FI"/>
        </a:p>
      </dgm:t>
    </dgm:pt>
    <dgm:pt modelId="{B8ECFFBD-07BD-4193-8F11-82F35AC636CE}">
      <dgm:prSet/>
      <dgm:spPr>
        <a:noFill/>
        <a:ln>
          <a:solidFill>
            <a:schemeClr val="tx1"/>
          </a:solidFill>
        </a:ln>
      </dgm:spPr>
      <dgm:t>
        <a:bodyPr/>
        <a:lstStyle/>
        <a:p>
          <a:pPr rtl="0"/>
          <a:r>
            <a:rPr lang="fi-FI" dirty="0">
              <a:solidFill>
                <a:schemeClr val="tx1"/>
              </a:solidFill>
              <a:latin typeface="Times New Roman"/>
              <a:cs typeface="Times New Roman"/>
            </a:rPr>
            <a:t>Designing a high-standard  and up-to-</a:t>
          </a:r>
          <a:r>
            <a:rPr lang="fi-FI" dirty="0" err="1">
              <a:solidFill>
                <a:schemeClr val="tx1"/>
              </a:solidFill>
              <a:latin typeface="Times New Roman"/>
              <a:cs typeface="Times New Roman"/>
            </a:rPr>
            <a:t>date</a:t>
          </a:r>
          <a:r>
            <a:rPr lang="fi-FI" dirty="0">
              <a:solidFill>
                <a:schemeClr val="tx1"/>
              </a:solidFill>
              <a:latin typeface="Times New Roman"/>
              <a:cs typeface="Times New Roman"/>
            </a:rPr>
            <a:t> onboarding process</a:t>
          </a:r>
        </a:p>
      </dgm:t>
    </dgm:pt>
    <dgm:pt modelId="{AC5F1FE9-FE99-4A10-BAD9-B42D7701399D}" type="parTrans" cxnId="{67C107F7-6E99-4502-815F-7D3202F4D294}">
      <dgm:prSet/>
      <dgm:spPr/>
      <dgm:t>
        <a:bodyPr/>
        <a:lstStyle/>
        <a:p>
          <a:endParaRPr lang="fi-FI"/>
        </a:p>
      </dgm:t>
    </dgm:pt>
    <dgm:pt modelId="{05E9DA59-9F12-494D-BEE3-8238BE691661}" type="sibTrans" cxnId="{67C107F7-6E99-4502-815F-7D3202F4D294}">
      <dgm:prSet/>
      <dgm:spPr/>
      <dgm:t>
        <a:bodyPr/>
        <a:lstStyle/>
        <a:p>
          <a:endParaRPr lang="fi-FI"/>
        </a:p>
      </dgm:t>
    </dgm:pt>
    <dgm:pt modelId="{44AA9650-19D7-470B-908F-5A9769B3401B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rtl="0"/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Thorough overview of required managerial and leadership qualities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gm:t>
    </dgm:pt>
    <dgm:pt modelId="{4233DC9A-F633-494E-AD57-B74858058BA5}" type="parTrans" cxnId="{69ED217D-E5AB-439A-AB1E-4C0570386A1B}">
      <dgm:prSet/>
      <dgm:spPr/>
      <dgm:t>
        <a:bodyPr/>
        <a:lstStyle/>
        <a:p>
          <a:endParaRPr lang="fi-FI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CE25AA9-04DA-4D5C-91C8-B3E54AA13C7E}" type="sibTrans" cxnId="{69ED217D-E5AB-439A-AB1E-4C0570386A1B}">
      <dgm:prSet/>
      <dgm:spPr/>
      <dgm:t>
        <a:bodyPr/>
        <a:lstStyle/>
        <a:p>
          <a:endParaRPr lang="fi-FI"/>
        </a:p>
      </dgm:t>
    </dgm:pt>
    <dgm:pt modelId="{222D38C2-1955-4DCC-B96C-556179080A76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Highlighting theoretical and practical aspects of management work in onboarding 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gm:t>
    </dgm:pt>
    <dgm:pt modelId="{A28C5AF5-8334-4553-9D15-827FCCE27E62}" type="parTrans" cxnId="{12AE555F-BF8C-4328-A91B-A7EB26270DE5}">
      <dgm:prSet/>
      <dgm:spPr>
        <a:ln>
          <a:solidFill>
            <a:schemeClr val="tx1"/>
          </a:solidFill>
        </a:ln>
      </dgm:spPr>
      <dgm:t>
        <a:bodyPr/>
        <a:lstStyle/>
        <a:p>
          <a:endParaRPr lang="fi-FI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365377D-E868-425F-A471-0BED27C01600}" type="sibTrans" cxnId="{12AE555F-BF8C-4328-A91B-A7EB26270DE5}">
      <dgm:prSet/>
      <dgm:spPr/>
      <dgm:t>
        <a:bodyPr/>
        <a:lstStyle/>
        <a:p>
          <a:endParaRPr lang="fi-FI"/>
        </a:p>
      </dgm:t>
    </dgm:pt>
    <dgm:pt modelId="{29BDDE00-60A0-4927-88FE-53B31686FD82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Constructing technology-enhanced onboarding 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B37F87B-B9D8-4ADC-8806-3F7694FDEE0E}" type="parTrans" cxnId="{EE58E7AB-8AD3-445B-8D76-E14364BCFED2}">
      <dgm:prSet/>
      <dgm:spPr/>
      <dgm:t>
        <a:bodyPr/>
        <a:lstStyle/>
        <a:p>
          <a:endParaRPr lang="fi-FI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DCE6546-9E26-4AAB-9C50-477E20312F22}" type="sibTrans" cxnId="{EE58E7AB-8AD3-445B-8D76-E14364BCFED2}">
      <dgm:prSet/>
      <dgm:spPr/>
      <dgm:t>
        <a:bodyPr/>
        <a:lstStyle/>
        <a:p>
          <a:endParaRPr lang="fi-FI"/>
        </a:p>
      </dgm:t>
    </dgm:pt>
    <dgm:pt modelId="{F5E20EA8-EEFF-4ED3-8E08-9BAB1CB1C5A6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rtl="0"/>
          <a:r>
            <a: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Designing structured and well-planned content for onboarding 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5F20FC7-470C-45C3-941D-97A0EE3E2009}" type="parTrans" cxnId="{525369B2-E555-4BA4-90F7-74AA2DA9CAFC}">
      <dgm:prSet/>
      <dgm:spPr>
        <a:ln>
          <a:solidFill>
            <a:schemeClr val="tx1"/>
          </a:solidFill>
        </a:ln>
      </dgm:spPr>
      <dgm:t>
        <a:bodyPr/>
        <a:lstStyle/>
        <a:p>
          <a:endParaRPr lang="fi-FI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ED03595-9DCF-48AE-B9E2-3F4B31B6075C}" type="sibTrans" cxnId="{525369B2-E555-4BA4-90F7-74AA2DA9CAFC}">
      <dgm:prSet/>
      <dgm:spPr/>
      <dgm:t>
        <a:bodyPr/>
        <a:lstStyle/>
        <a:p>
          <a:endParaRPr lang="fi-FI"/>
        </a:p>
      </dgm:t>
    </dgm:pt>
    <dgm:pt modelId="{0DFF0C05-9C69-4ED9-94D2-2FDE7282B4B6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algn="l" rtl="0"/>
          <a:r>
            <a: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Receiving support from the work community </a:t>
          </a:r>
          <a:endParaRPr lang="fi-FI" sz="1000" dirty="0">
            <a:latin typeface="Times New Roman"/>
            <a:cs typeface="Times New Roman"/>
          </a:endParaRPr>
        </a:p>
      </dgm:t>
    </dgm:pt>
    <dgm:pt modelId="{34BC541A-547D-448E-89A0-7A57401B86DF}" type="parTrans" cxnId="{171073DA-463C-4BFF-ABCD-8EF3E28FD85C}">
      <dgm:prSet/>
      <dgm:spPr/>
      <dgm:t>
        <a:bodyPr/>
        <a:lstStyle/>
        <a:p>
          <a:endParaRPr lang="fi-FI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05046EC-DA8B-45EB-99AE-1AEA03ACDDC2}" type="sibTrans" cxnId="{171073DA-463C-4BFF-ABCD-8EF3E28FD85C}">
      <dgm:prSet/>
      <dgm:spPr/>
      <dgm:t>
        <a:bodyPr/>
        <a:lstStyle/>
        <a:p>
          <a:endParaRPr lang="fi-FI"/>
        </a:p>
      </dgm:t>
    </dgm:pt>
    <dgm:pt modelId="{93B39D24-82A3-43AF-ABD4-2EAE2A701584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algn="l"/>
          <a:r>
            <a: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Getting organisational support during onboarding 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71903E8-8D60-4FD4-BDEB-07D086B43978}" type="parTrans" cxnId="{3945E9B3-8C93-4247-9803-C5C15F224608}">
      <dgm:prSet/>
      <dgm:spPr>
        <a:ln>
          <a:solidFill>
            <a:schemeClr val="tx1"/>
          </a:solidFill>
        </a:ln>
      </dgm:spPr>
      <dgm:t>
        <a:bodyPr/>
        <a:lstStyle/>
        <a:p>
          <a:endParaRPr lang="fi-FI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AD44546-204D-4031-AF11-2D69786A1FDE}" type="sibTrans" cxnId="{3945E9B3-8C93-4247-9803-C5C15F224608}">
      <dgm:prSet/>
      <dgm:spPr/>
      <dgm:t>
        <a:bodyPr/>
        <a:lstStyle/>
        <a:p>
          <a:endParaRPr lang="fi-FI"/>
        </a:p>
      </dgm:t>
    </dgm:pt>
    <dgm:pt modelId="{5DDEBA9C-B63C-43C5-9D57-54767F35CE3D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algn="l"/>
          <a:r>
            <a: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Familiarisation with the organisational working environment during onboarding  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F786998-1123-420F-B3B8-A4E68067FF90}" type="parTrans" cxnId="{7080323A-1FBE-4C33-B35B-320E8F2241F1}">
      <dgm:prSet/>
      <dgm:spPr/>
      <dgm:t>
        <a:bodyPr/>
        <a:lstStyle/>
        <a:p>
          <a:endParaRPr lang="fi-FI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677A488-3BC2-4160-B6D5-65F3570F019D}" type="sibTrans" cxnId="{7080323A-1FBE-4C33-B35B-320E8F2241F1}">
      <dgm:prSet/>
      <dgm:spPr/>
      <dgm:t>
        <a:bodyPr/>
        <a:lstStyle/>
        <a:p>
          <a:endParaRPr lang="fi-FI"/>
        </a:p>
      </dgm:t>
    </dgm:pt>
    <dgm:pt modelId="{9FB30D70-5F68-4597-8A56-D1A8E64DE511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algn="l"/>
          <a:r>
            <a: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Orientation on the work community during onboarding </a:t>
          </a:r>
          <a:endParaRPr lang="fi-FI" sz="1000" i="0" dirty="0">
            <a:latin typeface="Times New Roman"/>
            <a:cs typeface="Times New Roman"/>
          </a:endParaRPr>
        </a:p>
      </dgm:t>
    </dgm:pt>
    <dgm:pt modelId="{5FC7FCB2-AFBD-4F22-BE6E-7870B17B29DB}" type="parTrans" cxnId="{7CD7C3AF-E3A9-414A-99B7-CDC528A2D1EF}">
      <dgm:prSet/>
      <dgm:spPr>
        <a:ln>
          <a:solidFill>
            <a:schemeClr val="tx1"/>
          </a:solidFill>
        </a:ln>
      </dgm:spPr>
      <dgm:t>
        <a:bodyPr/>
        <a:lstStyle/>
        <a:p>
          <a:endParaRPr lang="fi-FI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6ACC729-5C02-4A7F-9C39-446D67A89B2E}" type="sibTrans" cxnId="{7CD7C3AF-E3A9-414A-99B7-CDC528A2D1EF}">
      <dgm:prSet/>
      <dgm:spPr/>
      <dgm:t>
        <a:bodyPr/>
        <a:lstStyle/>
        <a:p>
          <a:endParaRPr lang="fi-FI"/>
        </a:p>
      </dgm:t>
    </dgm:pt>
    <dgm:pt modelId="{2625232C-CF28-41CD-BCE2-4A7053ED617D}">
      <dgm:prSet/>
      <dgm:spPr>
        <a:noFill/>
        <a:ln>
          <a:solidFill>
            <a:schemeClr val="tx1"/>
          </a:solidFill>
        </a:ln>
      </dgm:spPr>
      <dgm:t>
        <a:bodyPr/>
        <a:lstStyle/>
        <a:p>
          <a:pPr algn="l"/>
          <a:endParaRPr lang="fi-FI" sz="800" i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42677F7-92DF-4763-B2A6-23399022B84C}" type="parTrans" cxnId="{5E933EC7-1435-4635-9827-9147499EC467}">
      <dgm:prSet/>
      <dgm:spPr/>
      <dgm:t>
        <a:bodyPr/>
        <a:lstStyle/>
        <a:p>
          <a:endParaRPr lang="fi-FI"/>
        </a:p>
      </dgm:t>
    </dgm:pt>
    <dgm:pt modelId="{FCC54A7B-448F-466F-B03A-5F652185F065}" type="sibTrans" cxnId="{5E933EC7-1435-4635-9827-9147499EC467}">
      <dgm:prSet/>
      <dgm:spPr/>
      <dgm:t>
        <a:bodyPr/>
        <a:lstStyle/>
        <a:p>
          <a:endParaRPr lang="fi-FI"/>
        </a:p>
      </dgm:t>
    </dgm:pt>
    <dgm:pt modelId="{A0CEF768-7728-4132-A981-ED989985080F}">
      <dgm:prSet custT="1"/>
      <dgm:spPr/>
      <dgm:t>
        <a:bodyPr/>
        <a:lstStyle/>
        <a:p>
          <a:pPr algn="l"/>
          <a:endParaRPr lang="fi-FI" sz="1000">
            <a:latin typeface="Times New Roman"/>
            <a:cs typeface="Times New Roman"/>
          </a:endParaRPr>
        </a:p>
      </dgm:t>
    </dgm:pt>
    <dgm:pt modelId="{42EA6686-8073-4C55-BB60-445182F24AA8}" type="parTrans" cxnId="{6796908F-C1B8-41A9-A214-0446D6CAB285}">
      <dgm:prSet/>
      <dgm:spPr/>
      <dgm:t>
        <a:bodyPr/>
        <a:lstStyle/>
        <a:p>
          <a:endParaRPr lang="fi-FI"/>
        </a:p>
      </dgm:t>
    </dgm:pt>
    <dgm:pt modelId="{25E5B05C-4801-4250-93A4-867CFC2C5D82}" type="sibTrans" cxnId="{6796908F-C1B8-41A9-A214-0446D6CAB285}">
      <dgm:prSet/>
      <dgm:spPr/>
      <dgm:t>
        <a:bodyPr/>
        <a:lstStyle/>
        <a:p>
          <a:endParaRPr lang="fi-FI"/>
        </a:p>
      </dgm:t>
    </dgm:pt>
    <dgm:pt modelId="{57013B7D-D6B4-4F4D-99B9-7C03A52D51FD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marL="0" lvl="0" indent="0" algn="l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Individually tailoring 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</dgm:t>
    </dgm:pt>
    <dgm:pt modelId="{87D99917-73A7-4372-8991-450DB201FA27}" type="parTrans" cxnId="{41EEF3BB-F8B2-4797-B42B-3D020FCB74D1}">
      <dgm:prSet/>
      <dgm:spPr>
        <a:ln>
          <a:solidFill>
            <a:schemeClr val="tx1"/>
          </a:solidFill>
        </a:ln>
      </dgm:spPr>
      <dgm:t>
        <a:bodyPr/>
        <a:lstStyle/>
        <a:p>
          <a:endParaRPr lang="en-US"/>
        </a:p>
      </dgm:t>
    </dgm:pt>
    <dgm:pt modelId="{AAC5403C-1C94-418B-94BE-597806E9E52F}" type="sibTrans" cxnId="{41EEF3BB-F8B2-4797-B42B-3D020FCB74D1}">
      <dgm:prSet/>
      <dgm:spPr/>
      <dgm:t>
        <a:bodyPr/>
        <a:lstStyle/>
        <a:p>
          <a:endParaRPr lang="en-US"/>
        </a:p>
      </dgm:t>
    </dgm:pt>
    <dgm:pt modelId="{03463784-F76F-4DA8-9126-19A615600ABC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algn="l">
            <a:buNone/>
          </a:pPr>
          <a:r>
            <a:rPr lang="en-GB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Investing proper resources for onboarding 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</dgm:t>
    </dgm:pt>
    <dgm:pt modelId="{86C41EAC-5A50-484B-AA3F-D7C380B3245D}" type="parTrans" cxnId="{D88C7958-D7EA-4D85-B17A-99F689642B94}">
      <dgm:prSet/>
      <dgm:spPr>
        <a:ln>
          <a:solidFill>
            <a:schemeClr val="tx1"/>
          </a:solidFill>
        </a:ln>
      </dgm:spPr>
      <dgm:t>
        <a:bodyPr/>
        <a:lstStyle/>
        <a:p>
          <a:endParaRPr lang="en-US"/>
        </a:p>
      </dgm:t>
    </dgm:pt>
    <dgm:pt modelId="{50B24858-AF7E-4304-B387-523CAB17423B}" type="sibTrans" cxnId="{D88C7958-D7EA-4D85-B17A-99F689642B94}">
      <dgm:prSet/>
      <dgm:spPr/>
      <dgm:t>
        <a:bodyPr/>
        <a:lstStyle/>
        <a:p>
          <a:endParaRPr lang="en-US"/>
        </a:p>
      </dgm:t>
    </dgm:pt>
    <dgm:pt modelId="{7A342A2B-8DAD-4672-9A4B-1E6980E71830}">
      <dgm:prSet phldrT="[Text]" custT="1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Increasing attraction to the position with onboarding</a:t>
          </a:r>
        </a:p>
      </dgm:t>
    </dgm:pt>
    <dgm:pt modelId="{60D0E8F8-B918-42B2-A4AB-FA90144E0F83}" type="parTrans" cxnId="{8C0C4B6F-1E4E-4D07-A0AB-258B483D65D2}">
      <dgm:prSet/>
      <dgm:spPr/>
      <dgm:t>
        <a:bodyPr/>
        <a:lstStyle/>
        <a:p>
          <a:endParaRPr lang="en-US"/>
        </a:p>
      </dgm:t>
    </dgm:pt>
    <dgm:pt modelId="{12FD97A2-45C0-4FBA-AEA7-19A28F398238}" type="sibTrans" cxnId="{8C0C4B6F-1E4E-4D07-A0AB-258B483D65D2}">
      <dgm:prSet/>
      <dgm:spPr/>
      <dgm:t>
        <a:bodyPr/>
        <a:lstStyle/>
        <a:p>
          <a:endParaRPr lang="en-US"/>
        </a:p>
      </dgm:t>
    </dgm:pt>
    <dgm:pt modelId="{011521D6-CD2E-401D-B6FF-CD0DE01F0EF4}">
      <dgm:prSet phldrT="[Text]" custT="1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Increasing the commitment of the front-line nurse manager to their work through onboarding</a:t>
          </a:r>
        </a:p>
      </dgm:t>
    </dgm:pt>
    <dgm:pt modelId="{8DDB9F96-41BA-4B92-A605-98BBB49FCF26}" type="parTrans" cxnId="{16371616-6619-4498-9A80-33AEFB04AA30}">
      <dgm:prSet/>
      <dgm:spPr/>
      <dgm:t>
        <a:bodyPr/>
        <a:lstStyle/>
        <a:p>
          <a:endParaRPr lang="en-US"/>
        </a:p>
      </dgm:t>
    </dgm:pt>
    <dgm:pt modelId="{5B7D905B-0390-4441-9E73-64D0340A71EA}" type="sibTrans" cxnId="{16371616-6619-4498-9A80-33AEFB04AA30}">
      <dgm:prSet/>
      <dgm:spPr/>
      <dgm:t>
        <a:bodyPr/>
        <a:lstStyle/>
        <a:p>
          <a:endParaRPr lang="en-US"/>
        </a:p>
      </dgm:t>
    </dgm:pt>
    <dgm:pt modelId="{611E7A9C-196C-4A17-A7A2-A0B8B708E605}">
      <dgm:prSet phldrT="[Text]" custT="1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Growing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into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anagerial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rol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during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8881E2C-45FD-46B7-8EDC-E0DB7F97128E}" type="parTrans" cxnId="{8A796850-4160-4C5F-A366-63DB6AE70868}">
      <dgm:prSet/>
      <dgm:spPr/>
      <dgm:t>
        <a:bodyPr/>
        <a:lstStyle/>
        <a:p>
          <a:endParaRPr lang="en-US"/>
        </a:p>
      </dgm:t>
    </dgm:pt>
    <dgm:pt modelId="{A5A04712-1B4F-467F-9AE0-7AB73111626A}" type="sibTrans" cxnId="{8A796850-4160-4C5F-A366-63DB6AE70868}">
      <dgm:prSet/>
      <dgm:spPr/>
      <dgm:t>
        <a:bodyPr/>
        <a:lstStyle/>
        <a:p>
          <a:endParaRPr lang="en-US"/>
        </a:p>
      </dgm:t>
    </dgm:pt>
    <dgm:pt modelId="{CDCCDA22-9AAE-4E96-88F7-DD4A4E8D8CB0}">
      <dgm:prSet phldrT="[Text]" custT="1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learly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highlighting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job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description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and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responsibilitie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of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anager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7FF50F7-B7EC-46DF-A7AD-CA9A53A965FC}" type="parTrans" cxnId="{0E90A6CD-F849-481D-BEDD-5638A3D53AED}">
      <dgm:prSet/>
      <dgm:spPr/>
      <dgm:t>
        <a:bodyPr/>
        <a:lstStyle/>
        <a:p>
          <a:endParaRPr lang="en-US"/>
        </a:p>
      </dgm:t>
    </dgm:pt>
    <dgm:pt modelId="{D4E9B2FD-4509-4BFF-97C4-E468704F8B51}" type="sibTrans" cxnId="{0E90A6CD-F849-481D-BEDD-5638A3D53AED}">
      <dgm:prSet/>
      <dgm:spPr/>
      <dgm:t>
        <a:bodyPr/>
        <a:lstStyle/>
        <a:p>
          <a:endParaRPr lang="en-US"/>
        </a:p>
      </dgm:t>
    </dgm:pt>
    <dgm:pt modelId="{BAFB43B3-5BA5-45A5-8D23-521FE6920C66}">
      <dgm:prSet/>
      <dgm:spPr/>
      <dgm:t>
        <a:bodyPr/>
        <a:lstStyle/>
        <a:p>
          <a:pPr rtl="0"/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Building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mpetenc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related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to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managerial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work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gm:t>
    </dgm:pt>
    <dgm:pt modelId="{B2A46E3F-45B8-4644-8CF8-EB44DBED1464}" type="parTrans" cxnId="{91EBD8FB-3D0F-429F-9743-6E6C1827C834}">
      <dgm:prSet/>
      <dgm:spPr/>
      <dgm:t>
        <a:bodyPr/>
        <a:lstStyle/>
        <a:p>
          <a:endParaRPr lang="en-US"/>
        </a:p>
      </dgm:t>
    </dgm:pt>
    <dgm:pt modelId="{7BED8A7A-F4E3-4120-A0E1-AF42C3A4B89A}" type="sibTrans" cxnId="{91EBD8FB-3D0F-429F-9743-6E6C1827C834}">
      <dgm:prSet/>
      <dgm:spPr/>
      <dgm:t>
        <a:bodyPr/>
        <a:lstStyle/>
        <a:p>
          <a:endParaRPr lang="en-US"/>
        </a:p>
      </dgm:t>
    </dgm:pt>
    <dgm:pt modelId="{E22BC852-6AF9-470E-BE5B-26EA51BCBB11}">
      <dgm:prSet/>
      <dgm:spPr/>
      <dgm:t>
        <a:bodyPr/>
        <a:lstStyle/>
        <a:p>
          <a:pPr rtl="0"/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nsur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mpetenc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in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h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ervic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hain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management</a:t>
          </a:r>
        </a:p>
      </dgm:t>
    </dgm:pt>
    <dgm:pt modelId="{27115AF9-1271-44FC-8C35-E8F7DF739076}" type="parTrans" cxnId="{906863D8-39E6-433F-9C4F-BC10DB2E0889}">
      <dgm:prSet/>
      <dgm:spPr/>
      <dgm:t>
        <a:bodyPr/>
        <a:lstStyle/>
        <a:p>
          <a:endParaRPr lang="en-US"/>
        </a:p>
      </dgm:t>
    </dgm:pt>
    <dgm:pt modelId="{AAFBF712-FC91-4A8B-B1F3-8C74A4D59D98}" type="sibTrans" cxnId="{906863D8-39E6-433F-9C4F-BC10DB2E0889}">
      <dgm:prSet/>
      <dgm:spPr/>
      <dgm:t>
        <a:bodyPr/>
        <a:lstStyle/>
        <a:p>
          <a:endParaRPr lang="en-US"/>
        </a:p>
      </dgm:t>
    </dgm:pt>
    <dgm:pt modelId="{ED7A4674-DA27-4317-B778-0BA4FCE9724B}">
      <dgm:prSet/>
      <dgm:spPr/>
      <dgm:t>
        <a:bodyPr/>
        <a:lstStyle/>
        <a:p>
          <a:pPr rtl="0"/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elf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-management and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leadership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kill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as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art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of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gm:t>
    </dgm:pt>
    <dgm:pt modelId="{42C88B20-37E8-4313-A978-AE3527ACCDC4}" type="parTrans" cxnId="{3C70AC89-D8B3-4A0A-AC2D-DD7FE15F664C}">
      <dgm:prSet/>
      <dgm:spPr/>
      <dgm:t>
        <a:bodyPr/>
        <a:lstStyle/>
        <a:p>
          <a:endParaRPr lang="en-US"/>
        </a:p>
      </dgm:t>
    </dgm:pt>
    <dgm:pt modelId="{895DCD8B-E5F7-4A55-B258-D6EF32143B6B}" type="sibTrans" cxnId="{3C70AC89-D8B3-4A0A-AC2D-DD7FE15F664C}">
      <dgm:prSet/>
      <dgm:spPr/>
      <dgm:t>
        <a:bodyPr/>
        <a:lstStyle/>
        <a:p>
          <a:endParaRPr lang="en-US"/>
        </a:p>
      </dgm:t>
    </dgm:pt>
    <dgm:pt modelId="{ABBB9EE4-0A81-45DE-8CB2-C11436DAA077}">
      <dgm:prSet/>
      <dgm:spPr/>
      <dgm:t>
        <a:bodyPr/>
        <a:lstStyle/>
        <a:p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nclud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management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ractice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and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heorie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in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gm:t>
    </dgm:pt>
    <dgm:pt modelId="{A0ECDD02-C11B-4A08-9293-E3207BFA19A9}" type="parTrans" cxnId="{E42CC3E0-1C5D-4A02-A752-B6E7FA3693CE}">
      <dgm:prSet/>
      <dgm:spPr/>
      <dgm:t>
        <a:bodyPr/>
        <a:lstStyle/>
        <a:p>
          <a:endParaRPr lang="en-US"/>
        </a:p>
      </dgm:t>
    </dgm:pt>
    <dgm:pt modelId="{246A7579-C681-4BAC-A5F2-9179969C7646}" type="sibTrans" cxnId="{E42CC3E0-1C5D-4A02-A752-B6E7FA3693CE}">
      <dgm:prSet/>
      <dgm:spPr/>
      <dgm:t>
        <a:bodyPr/>
        <a:lstStyle/>
        <a:p>
          <a:endParaRPr lang="en-US"/>
        </a:p>
      </dgm:t>
    </dgm:pt>
    <dgm:pt modelId="{EDA613EA-62A5-438B-BECC-F592F0CD08BF}">
      <dgm:prSet/>
      <dgm:spPr/>
      <dgm:t>
        <a:bodyPr/>
        <a:lstStyle/>
        <a:p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Orientation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on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human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resource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management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ractice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dur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gm:t>
    </dgm:pt>
    <dgm:pt modelId="{7A028AE3-65DD-44D5-BCE3-87B46C2DEFB7}" type="parTrans" cxnId="{1A8109E3-DCBF-4136-A634-575322B50A72}">
      <dgm:prSet/>
      <dgm:spPr/>
      <dgm:t>
        <a:bodyPr/>
        <a:lstStyle/>
        <a:p>
          <a:endParaRPr lang="en-US"/>
        </a:p>
      </dgm:t>
    </dgm:pt>
    <dgm:pt modelId="{E7CDAC86-985B-48DC-8A8A-DD41526D27B6}" type="sibTrans" cxnId="{1A8109E3-DCBF-4136-A634-575322B50A72}">
      <dgm:prSet/>
      <dgm:spPr/>
      <dgm:t>
        <a:bodyPr/>
        <a:lstStyle/>
        <a:p>
          <a:endParaRPr lang="en-US"/>
        </a:p>
      </dgm:t>
    </dgm:pt>
    <dgm:pt modelId="{F2442C08-3556-4A62-9016-5CF2273C2006}">
      <dgm:prSet/>
      <dgm:spPr/>
      <dgm:t>
        <a:bodyPr/>
        <a:lstStyle/>
        <a:p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ientation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on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echnological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ystem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FA89687-AF21-4118-9C91-B45961419DD0}" type="parTrans" cxnId="{897BA7E6-F4B8-4C08-A11F-1D65DB7A97B9}">
      <dgm:prSet/>
      <dgm:spPr/>
      <dgm:t>
        <a:bodyPr/>
        <a:lstStyle/>
        <a:p>
          <a:endParaRPr lang="en-US"/>
        </a:p>
      </dgm:t>
    </dgm:pt>
    <dgm:pt modelId="{7572CAD0-DA83-468C-96E7-0AB1C3C3C624}" type="sibTrans" cxnId="{897BA7E6-F4B8-4C08-A11F-1D65DB7A97B9}">
      <dgm:prSet/>
      <dgm:spPr/>
      <dgm:t>
        <a:bodyPr/>
        <a:lstStyle/>
        <a:p>
          <a:endParaRPr lang="en-US"/>
        </a:p>
      </dgm:t>
    </dgm:pt>
    <dgm:pt modelId="{4B008D41-2728-4EA6-A964-76BD415F05AE}">
      <dgm:prSet/>
      <dgm:spPr/>
      <dgm:t>
        <a:bodyPr/>
        <a:lstStyle/>
        <a:p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hallenge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relating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to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echnological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ool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during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3DF0071-62E4-48BB-BC9A-8D764B127C7B}" type="parTrans" cxnId="{C321CA46-332A-43B0-9413-EC87C4329428}">
      <dgm:prSet/>
      <dgm:spPr/>
      <dgm:t>
        <a:bodyPr/>
        <a:lstStyle/>
        <a:p>
          <a:endParaRPr lang="en-US"/>
        </a:p>
      </dgm:t>
    </dgm:pt>
    <dgm:pt modelId="{9371E4D9-982C-4D07-873F-A0AC1B850DA1}" type="sibTrans" cxnId="{C321CA46-332A-43B0-9413-EC87C4329428}">
      <dgm:prSet/>
      <dgm:spPr/>
      <dgm:t>
        <a:bodyPr/>
        <a:lstStyle/>
        <a:p>
          <a:endParaRPr lang="en-US"/>
        </a:p>
      </dgm:t>
    </dgm:pt>
    <dgm:pt modelId="{37A4A9C7-17F1-47A9-B079-F49C9DA9791B}">
      <dgm:prSet/>
      <dgm:spPr/>
      <dgm:t>
        <a:bodyPr/>
        <a:lstStyle/>
        <a:p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lear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digital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ientation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aterial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to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upport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13ADE65-A626-427B-850B-D5C240DB0E77}" type="parTrans" cxnId="{BD261780-30C9-4F06-9E8A-637121B0625C}">
      <dgm:prSet/>
      <dgm:spPr/>
      <dgm:t>
        <a:bodyPr/>
        <a:lstStyle/>
        <a:p>
          <a:endParaRPr lang="en-US"/>
        </a:p>
      </dgm:t>
    </dgm:pt>
    <dgm:pt modelId="{81DBC288-EBFD-4F6E-BF71-49E6E07CFB3E}" type="sibTrans" cxnId="{BD261780-30C9-4F06-9E8A-637121B0625C}">
      <dgm:prSet/>
      <dgm:spPr/>
      <dgm:t>
        <a:bodyPr/>
        <a:lstStyle/>
        <a:p>
          <a:endParaRPr lang="en-US"/>
        </a:p>
      </dgm:t>
    </dgm:pt>
    <dgm:pt modelId="{D952E32F-E49D-4E36-980F-AB3070184515}">
      <dgm:prSet/>
      <dgm:spPr/>
      <dgm:t>
        <a:bodyPr/>
        <a:lstStyle/>
        <a:p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Using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functional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ool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and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environment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in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F0F259E-F733-437F-BA86-6564A3149EF3}" type="parTrans" cxnId="{27F5CCAC-B938-4297-8A82-5F3B15D92C86}">
      <dgm:prSet/>
      <dgm:spPr/>
      <dgm:t>
        <a:bodyPr/>
        <a:lstStyle/>
        <a:p>
          <a:endParaRPr lang="en-US"/>
        </a:p>
      </dgm:t>
    </dgm:pt>
    <dgm:pt modelId="{0A820BCB-A5DF-4CE9-AF77-BD4E42D6EA90}" type="sibTrans" cxnId="{27F5CCAC-B938-4297-8A82-5F3B15D92C86}">
      <dgm:prSet/>
      <dgm:spPr/>
      <dgm:t>
        <a:bodyPr/>
        <a:lstStyle/>
        <a:p>
          <a:endParaRPr lang="en-US"/>
        </a:p>
      </dgm:t>
    </dgm:pt>
    <dgm:pt modelId="{8BC2E66F-731A-46EA-9259-F00C3B6FEE11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rtl="0"/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Using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up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-to-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dat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ientation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aterial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upport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C101435-5E8F-45D4-9A32-76F653569F0F}" type="parTrans" cxnId="{93E33367-0544-4B2F-B4DD-FB974E2FE88B}">
      <dgm:prSet/>
      <dgm:spPr/>
      <dgm:t>
        <a:bodyPr/>
        <a:lstStyle/>
        <a:p>
          <a:endParaRPr lang="en-US"/>
        </a:p>
      </dgm:t>
    </dgm:pt>
    <dgm:pt modelId="{2B1229EB-AECB-4E05-90D7-090BBEDE7090}" type="sibTrans" cxnId="{93E33367-0544-4B2F-B4DD-FB974E2FE88B}">
      <dgm:prSet/>
      <dgm:spPr/>
      <dgm:t>
        <a:bodyPr/>
        <a:lstStyle/>
        <a:p>
          <a:endParaRPr lang="en-US"/>
        </a:p>
      </dgm:t>
    </dgm:pt>
    <dgm:pt modelId="{8166AFF3-841C-4469-A984-03D0021E2262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rtl="0"/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tructurality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of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4A1CAAA-5F63-4E20-83E7-95394816AC24}" type="parTrans" cxnId="{580B0402-8F3B-41A6-8956-8DDC48CAA00E}">
      <dgm:prSet/>
      <dgm:spPr/>
      <dgm:t>
        <a:bodyPr/>
        <a:lstStyle/>
        <a:p>
          <a:endParaRPr lang="en-US"/>
        </a:p>
      </dgm:t>
    </dgm:pt>
    <dgm:pt modelId="{47F584DE-0298-4272-9627-68D41C0B6141}" type="sibTrans" cxnId="{580B0402-8F3B-41A6-8956-8DDC48CAA00E}">
      <dgm:prSet/>
      <dgm:spPr/>
      <dgm:t>
        <a:bodyPr/>
        <a:lstStyle/>
        <a:p>
          <a:endParaRPr lang="en-US"/>
        </a:p>
      </dgm:t>
    </dgm:pt>
    <dgm:pt modelId="{0300C804-132B-4963-8252-6E02B4F5B108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marL="0" lvl="0" indent="0" algn="l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Arial" panose="020B0604020202020204" pitchFamily="34" charset="0"/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Proactivity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from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th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new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manager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in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adequat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om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</dgm:t>
    </dgm:pt>
    <dgm:pt modelId="{BA002FB6-604B-4083-83F8-086C720F2F08}" type="parTrans" cxnId="{F6530EF3-BFA2-4638-BD80-5EB2C5C47126}">
      <dgm:prSet/>
      <dgm:spPr/>
      <dgm:t>
        <a:bodyPr/>
        <a:lstStyle/>
        <a:p>
          <a:endParaRPr lang="en-US"/>
        </a:p>
      </dgm:t>
    </dgm:pt>
    <dgm:pt modelId="{597B167D-37E8-4D53-9D18-A6CA6C8189FB}" type="sibTrans" cxnId="{F6530EF3-BFA2-4638-BD80-5EB2C5C47126}">
      <dgm:prSet/>
      <dgm:spPr/>
      <dgm:t>
        <a:bodyPr/>
        <a:lstStyle/>
        <a:p>
          <a:endParaRPr lang="en-US"/>
        </a:p>
      </dgm:t>
    </dgm:pt>
    <dgm:pt modelId="{B4197589-FB93-4EAF-BA08-67ADD7E567B7}">
      <dgm:prSet custT="1"/>
      <dgm:spPr>
        <a:noFill/>
        <a:ln>
          <a:solidFill>
            <a:schemeClr val="tx1"/>
          </a:solidFill>
        </a:ln>
      </dgm:spPr>
      <dgm:t>
        <a:bodyPr/>
        <a:lstStyle/>
        <a:p>
          <a:pPr marL="0" lvl="0" indent="0" algn="l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Arial" panose="020B0604020202020204" pitchFamily="34" charset="0"/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Customis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onboard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to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th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need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of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th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individual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</dgm:t>
    </dgm:pt>
    <dgm:pt modelId="{AE174E02-237C-4C8E-8CF2-B09E9A757DC5}" type="parTrans" cxnId="{B4D9E7FD-5F80-4601-AD83-3FC77F5C8ADF}">
      <dgm:prSet/>
      <dgm:spPr/>
      <dgm:t>
        <a:bodyPr/>
        <a:lstStyle/>
        <a:p>
          <a:endParaRPr lang="en-US"/>
        </a:p>
      </dgm:t>
    </dgm:pt>
    <dgm:pt modelId="{0C8D6C1B-472D-4FE5-8E95-2D012B05C770}" type="sibTrans" cxnId="{B4D9E7FD-5F80-4601-AD83-3FC77F5C8ADF}">
      <dgm:prSet/>
      <dgm:spPr/>
      <dgm:t>
        <a:bodyPr/>
        <a:lstStyle/>
        <a:p>
          <a:endParaRPr lang="en-US"/>
        </a:p>
      </dgm:t>
    </dgm:pt>
    <dgm:pt modelId="{1CF7D7CA-1F01-44AA-9811-D9C19122DBBA}">
      <dgm:prSet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Allocat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adequat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tim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for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</dgm:t>
    </dgm:pt>
    <dgm:pt modelId="{7721E666-65A9-4F9B-9245-A13452DB1E91}" type="parTrans" cxnId="{BCDCEA09-6E58-4D97-AB6B-8B28BCE4F7C3}">
      <dgm:prSet/>
      <dgm:spPr/>
      <dgm:t>
        <a:bodyPr/>
        <a:lstStyle/>
        <a:p>
          <a:endParaRPr lang="en-US"/>
        </a:p>
      </dgm:t>
    </dgm:pt>
    <dgm:pt modelId="{7CAD9F83-C75D-4438-8148-ED98009F2CC1}" type="sibTrans" cxnId="{BCDCEA09-6E58-4D97-AB6B-8B28BCE4F7C3}">
      <dgm:prSet/>
      <dgm:spPr/>
      <dgm:t>
        <a:bodyPr/>
        <a:lstStyle/>
        <a:p>
          <a:endParaRPr lang="en-US"/>
        </a:p>
      </dgm:t>
    </dgm:pt>
    <dgm:pt modelId="{9E29546F-8092-46C0-8BA5-43575C7B3AE4}">
      <dgm:prSet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Appoint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a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support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person to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coordinat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</dgm:t>
    </dgm:pt>
    <dgm:pt modelId="{8E19DEE0-C468-463B-8710-1DC253C69049}" type="parTrans" cxnId="{E9F81D49-A8BE-4635-8795-4AA5AC2CB083}">
      <dgm:prSet/>
      <dgm:spPr/>
      <dgm:t>
        <a:bodyPr/>
        <a:lstStyle/>
        <a:p>
          <a:endParaRPr lang="en-US"/>
        </a:p>
      </dgm:t>
    </dgm:pt>
    <dgm:pt modelId="{71D663F8-7F15-4F8E-B9AD-081EEBE0F201}" type="sibTrans" cxnId="{E9F81D49-A8BE-4635-8795-4AA5AC2CB083}">
      <dgm:prSet/>
      <dgm:spPr/>
      <dgm:t>
        <a:bodyPr/>
        <a:lstStyle/>
        <a:p>
          <a:endParaRPr lang="en-US"/>
        </a:p>
      </dgm:t>
    </dgm:pt>
    <dgm:pt modelId="{E8AAAD70-5BDF-440F-8A73-ED43FD473D86}">
      <dgm:prSet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Involv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specialist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in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interdiciplinary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</dgm:t>
    </dgm:pt>
    <dgm:pt modelId="{0398A42D-A088-40AD-B347-7DAAF07E43A4}" type="parTrans" cxnId="{E12015CD-DBF7-4F51-AC7C-A2502BD151B8}">
      <dgm:prSet/>
      <dgm:spPr/>
      <dgm:t>
        <a:bodyPr/>
        <a:lstStyle/>
        <a:p>
          <a:endParaRPr lang="en-US"/>
        </a:p>
      </dgm:t>
    </dgm:pt>
    <dgm:pt modelId="{5B2614FF-A06B-492D-8B18-7BAB10AD68BD}" type="sibTrans" cxnId="{E12015CD-DBF7-4F51-AC7C-A2502BD151B8}">
      <dgm:prSet/>
      <dgm:spPr/>
      <dgm:t>
        <a:bodyPr/>
        <a:lstStyle/>
        <a:p>
          <a:endParaRPr lang="en-US"/>
        </a:p>
      </dgm:t>
    </dgm:pt>
    <dgm:pt modelId="{E53BD961-CED2-4F02-A553-B7FBEE94C8E1}">
      <dgm:prSet/>
      <dgm:spPr/>
      <dgm:t>
        <a:bodyPr/>
        <a:lstStyle/>
        <a:p>
          <a:pPr algn="l" rtl="0"/>
          <a:r>
            <a:rPr lang="fi-FI" sz="1000" dirty="0" err="1">
              <a:latin typeface="Times New Roman"/>
              <a:cs typeface="Times New Roman"/>
            </a:rPr>
            <a:t>Getting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versitile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assistance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from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collegues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during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onboarding</a:t>
          </a:r>
          <a:endParaRPr lang="fi-FI" sz="1000" dirty="0">
            <a:latin typeface="Times New Roman"/>
            <a:cs typeface="Times New Roman"/>
          </a:endParaRPr>
        </a:p>
      </dgm:t>
    </dgm:pt>
    <dgm:pt modelId="{F76F3F1F-89AF-498D-AF9F-5EB3AE08ED3F}" type="parTrans" cxnId="{6A7E608B-1CDD-410E-9E6B-65441D7042CF}">
      <dgm:prSet/>
      <dgm:spPr/>
      <dgm:t>
        <a:bodyPr/>
        <a:lstStyle/>
        <a:p>
          <a:endParaRPr lang="en-US"/>
        </a:p>
      </dgm:t>
    </dgm:pt>
    <dgm:pt modelId="{68EF23BD-2258-47D6-8B00-67747E4697A4}" type="sibTrans" cxnId="{6A7E608B-1CDD-410E-9E6B-65441D7042CF}">
      <dgm:prSet/>
      <dgm:spPr/>
      <dgm:t>
        <a:bodyPr/>
        <a:lstStyle/>
        <a:p>
          <a:endParaRPr lang="en-US"/>
        </a:p>
      </dgm:t>
    </dgm:pt>
    <dgm:pt modelId="{7F3CB92D-D07A-4968-AA50-B516A09A581E}">
      <dgm:prSet/>
      <dgm:spPr/>
      <dgm:t>
        <a:bodyPr/>
        <a:lstStyle/>
        <a:p>
          <a:pPr algn="l" rtl="0"/>
          <a:endParaRPr lang="fi-FI" sz="1000" dirty="0">
            <a:latin typeface="Times New Roman"/>
            <a:cs typeface="Times New Roman"/>
          </a:endParaRPr>
        </a:p>
      </dgm:t>
    </dgm:pt>
    <dgm:pt modelId="{DDC2C976-D0EE-493B-85D7-ADC8E11721B5}" type="parTrans" cxnId="{8B602B58-68F7-42BA-AB0E-743ABD935655}">
      <dgm:prSet/>
      <dgm:spPr/>
      <dgm:t>
        <a:bodyPr/>
        <a:lstStyle/>
        <a:p>
          <a:endParaRPr lang="en-US"/>
        </a:p>
      </dgm:t>
    </dgm:pt>
    <dgm:pt modelId="{9B66C6CD-46AF-43A4-9AFA-FBFD7884D253}" type="sibTrans" cxnId="{8B602B58-68F7-42BA-AB0E-743ABD935655}">
      <dgm:prSet/>
      <dgm:spPr/>
      <dgm:t>
        <a:bodyPr/>
        <a:lstStyle/>
        <a:p>
          <a:endParaRPr lang="en-US"/>
        </a:p>
      </dgm:t>
    </dgm:pt>
    <dgm:pt modelId="{BF6E8F7F-0754-4CF6-AAE2-8058824C2737}">
      <dgm:prSet/>
      <dgm:spPr/>
      <dgm:t>
        <a:bodyPr/>
        <a:lstStyle/>
        <a:p>
          <a:pPr algn="l" rtl="0"/>
          <a:r>
            <a:rPr lang="fi-FI" sz="1000" dirty="0" err="1">
              <a:latin typeface="Times New Roman"/>
              <a:cs typeface="Times New Roman"/>
            </a:rPr>
            <a:t>Obtaining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interactional</a:t>
          </a:r>
          <a:r>
            <a:rPr lang="fi-FI" sz="1000" dirty="0">
              <a:latin typeface="Times New Roman"/>
              <a:cs typeface="Times New Roman"/>
            </a:rPr>
            <a:t> help </a:t>
          </a:r>
          <a:r>
            <a:rPr lang="fi-FI" sz="1000" dirty="0" err="1">
              <a:latin typeface="Times New Roman"/>
              <a:cs typeface="Times New Roman"/>
            </a:rPr>
            <a:t>from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staff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during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onboarding</a:t>
          </a:r>
          <a:endParaRPr lang="fi-FI" sz="1000" dirty="0">
            <a:latin typeface="Times New Roman"/>
            <a:cs typeface="Times New Roman"/>
          </a:endParaRPr>
        </a:p>
      </dgm:t>
    </dgm:pt>
    <dgm:pt modelId="{CF16C300-A674-41F1-8253-A9198B5ACF2E}" type="parTrans" cxnId="{0A732CCD-EED6-4ADA-AA9C-DA73AE4C925A}">
      <dgm:prSet/>
      <dgm:spPr/>
      <dgm:t>
        <a:bodyPr/>
        <a:lstStyle/>
        <a:p>
          <a:endParaRPr lang="en-US"/>
        </a:p>
      </dgm:t>
    </dgm:pt>
    <dgm:pt modelId="{172A02C8-A89C-412C-A65D-A567D1FBE383}" type="sibTrans" cxnId="{0A732CCD-EED6-4ADA-AA9C-DA73AE4C925A}">
      <dgm:prSet/>
      <dgm:spPr/>
      <dgm:t>
        <a:bodyPr/>
        <a:lstStyle/>
        <a:p>
          <a:endParaRPr lang="en-US"/>
        </a:p>
      </dgm:t>
    </dgm:pt>
    <dgm:pt modelId="{5F2A99F2-7AB0-48C8-9CF9-06B14AB961AE}">
      <dgm:prSet/>
      <dgm:spPr/>
      <dgm:t>
        <a:bodyPr/>
        <a:lstStyle/>
        <a:p>
          <a:pPr algn="l" rtl="0"/>
          <a:r>
            <a:rPr lang="fi-FI" sz="1000" dirty="0" err="1">
              <a:latin typeface="Times New Roman"/>
              <a:cs typeface="Times New Roman"/>
            </a:rPr>
            <a:t>Lack</a:t>
          </a:r>
          <a:r>
            <a:rPr lang="fi-FI" sz="1000" dirty="0">
              <a:latin typeface="Times New Roman"/>
              <a:cs typeface="Times New Roman"/>
            </a:rPr>
            <a:t> of </a:t>
          </a:r>
          <a:r>
            <a:rPr lang="fi-FI" sz="1000" dirty="0" err="1">
              <a:latin typeface="Times New Roman"/>
              <a:cs typeface="Times New Roman"/>
            </a:rPr>
            <a:t>community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support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during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onboarding</a:t>
          </a:r>
          <a:endParaRPr lang="fi-FI" sz="1000" dirty="0">
            <a:latin typeface="Times New Roman"/>
            <a:cs typeface="Times New Roman"/>
          </a:endParaRPr>
        </a:p>
      </dgm:t>
    </dgm:pt>
    <dgm:pt modelId="{E0242CE3-4689-4752-89D5-26605BDA3C00}" type="parTrans" cxnId="{D58F4887-339D-40A3-BDCB-389A1DA1D652}">
      <dgm:prSet/>
      <dgm:spPr/>
      <dgm:t>
        <a:bodyPr/>
        <a:lstStyle/>
        <a:p>
          <a:endParaRPr lang="en-US"/>
        </a:p>
      </dgm:t>
    </dgm:pt>
    <dgm:pt modelId="{B953A73C-720D-4D5D-820E-946835123CCF}" type="sibTrans" cxnId="{D58F4887-339D-40A3-BDCB-389A1DA1D652}">
      <dgm:prSet/>
      <dgm:spPr/>
      <dgm:t>
        <a:bodyPr/>
        <a:lstStyle/>
        <a:p>
          <a:endParaRPr lang="en-US"/>
        </a:p>
      </dgm:t>
    </dgm:pt>
    <dgm:pt modelId="{109FB078-1D64-45E2-927C-AD621D0F18E1}">
      <dgm:prSet/>
      <dgm:spPr/>
      <dgm:t>
        <a:bodyPr/>
        <a:lstStyle/>
        <a:p>
          <a:pPr algn="l" rtl="0"/>
          <a:r>
            <a:rPr lang="fi-FI" sz="1000" dirty="0" err="1">
              <a:latin typeface="Times New Roman"/>
              <a:cs typeface="Times New Roman"/>
            </a:rPr>
            <a:t>Including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regular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guidance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from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one’s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supervisor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during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onboarding</a:t>
          </a:r>
          <a:endParaRPr lang="fi-FI" sz="1000" dirty="0">
            <a:latin typeface="Times New Roman"/>
            <a:cs typeface="Times New Roman"/>
          </a:endParaRPr>
        </a:p>
      </dgm:t>
    </dgm:pt>
    <dgm:pt modelId="{0AD442A6-44FF-4E45-84E5-FDAE17EE87C7}" type="parTrans" cxnId="{DBB9B811-F024-4D8D-A4FB-3BB32FA159D9}">
      <dgm:prSet/>
      <dgm:spPr/>
      <dgm:t>
        <a:bodyPr/>
        <a:lstStyle/>
        <a:p>
          <a:endParaRPr lang="en-US"/>
        </a:p>
      </dgm:t>
    </dgm:pt>
    <dgm:pt modelId="{CD080529-7946-4283-8348-81FB666EF45A}" type="sibTrans" cxnId="{DBB9B811-F024-4D8D-A4FB-3BB32FA159D9}">
      <dgm:prSet/>
      <dgm:spPr/>
      <dgm:t>
        <a:bodyPr/>
        <a:lstStyle/>
        <a:p>
          <a:endParaRPr lang="en-US"/>
        </a:p>
      </dgm:t>
    </dgm:pt>
    <dgm:pt modelId="{5C152A59-8838-4F00-BCFE-50F813575CC8}">
      <dgm:prSet/>
      <dgm:spPr/>
      <dgm:t>
        <a:bodyPr/>
        <a:lstStyle/>
        <a:p>
          <a:pPr algn="l" rtl="0"/>
          <a:r>
            <a:rPr lang="fi-FI" sz="1000" dirty="0">
              <a:latin typeface="Times New Roman"/>
              <a:cs typeface="Times New Roman"/>
            </a:rPr>
            <a:t>Using </a:t>
          </a:r>
          <a:r>
            <a:rPr lang="fi-FI" sz="1000" dirty="0" err="1">
              <a:latin typeface="Times New Roman"/>
              <a:cs typeface="Times New Roman"/>
            </a:rPr>
            <a:t>mentoring</a:t>
          </a:r>
          <a:r>
            <a:rPr lang="fi-FI" sz="1000" dirty="0">
              <a:latin typeface="Times New Roman"/>
              <a:cs typeface="Times New Roman"/>
            </a:rPr>
            <a:t> as an </a:t>
          </a:r>
          <a:r>
            <a:rPr lang="fi-FI" sz="1000" dirty="0" err="1">
              <a:latin typeface="Times New Roman"/>
              <a:cs typeface="Times New Roman"/>
            </a:rPr>
            <a:t>effective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method</a:t>
          </a:r>
          <a:r>
            <a:rPr lang="fi-FI" sz="1000" dirty="0">
              <a:latin typeface="Times New Roman"/>
              <a:cs typeface="Times New Roman"/>
            </a:rPr>
            <a:t> of </a:t>
          </a:r>
          <a:r>
            <a:rPr lang="fi-FI" sz="1000" dirty="0" err="1">
              <a:latin typeface="Times New Roman"/>
              <a:cs typeface="Times New Roman"/>
            </a:rPr>
            <a:t>supporting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the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onboarding</a:t>
          </a:r>
          <a:r>
            <a:rPr lang="fi-FI" sz="1000" dirty="0">
              <a:latin typeface="Times New Roman"/>
              <a:cs typeface="Times New Roman"/>
            </a:rPr>
            <a:t> </a:t>
          </a:r>
          <a:r>
            <a:rPr lang="fi-FI" sz="1000" dirty="0" err="1">
              <a:latin typeface="Times New Roman"/>
              <a:cs typeface="Times New Roman"/>
            </a:rPr>
            <a:t>process</a:t>
          </a:r>
          <a:endParaRPr lang="fi-FI" sz="1000" dirty="0">
            <a:latin typeface="Times New Roman"/>
            <a:cs typeface="Times New Roman"/>
          </a:endParaRPr>
        </a:p>
      </dgm:t>
    </dgm:pt>
    <dgm:pt modelId="{D94C4C54-5EF8-48EE-A67E-37A2AC94401E}" type="parTrans" cxnId="{34B1B024-96CA-441C-A2D4-25D9420EB4B8}">
      <dgm:prSet/>
      <dgm:spPr/>
      <dgm:t>
        <a:bodyPr/>
        <a:lstStyle/>
        <a:p>
          <a:endParaRPr lang="en-US"/>
        </a:p>
      </dgm:t>
    </dgm:pt>
    <dgm:pt modelId="{895F2A68-2519-4F84-8EEA-5716FD9EED62}" type="sibTrans" cxnId="{34B1B024-96CA-441C-A2D4-25D9420EB4B8}">
      <dgm:prSet/>
      <dgm:spPr/>
      <dgm:t>
        <a:bodyPr/>
        <a:lstStyle/>
        <a:p>
          <a:endParaRPr lang="en-US"/>
        </a:p>
      </dgm:t>
    </dgm:pt>
    <dgm:pt modelId="{1C81D12C-3185-4C06-BB54-C4F12C9CC418}">
      <dgm:prSet/>
      <dgm:spPr/>
      <dgm:t>
        <a:bodyPr/>
        <a:lstStyle/>
        <a:p>
          <a:pPr algn="l"/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Having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ganisational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guideline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to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upport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E86D96C-6EF2-410A-8364-054866F85D4A}" type="parTrans" cxnId="{D7971B0E-E6A1-486E-90A8-BDA78F6B6EB0}">
      <dgm:prSet/>
      <dgm:spPr/>
      <dgm:t>
        <a:bodyPr/>
        <a:lstStyle/>
        <a:p>
          <a:endParaRPr lang="en-US"/>
        </a:p>
      </dgm:t>
    </dgm:pt>
    <dgm:pt modelId="{92ACBEB0-4D1E-49FE-8A4F-3255A1EE48B3}" type="sibTrans" cxnId="{D7971B0E-E6A1-486E-90A8-BDA78F6B6EB0}">
      <dgm:prSet/>
      <dgm:spPr/>
      <dgm:t>
        <a:bodyPr/>
        <a:lstStyle/>
        <a:p>
          <a:endParaRPr lang="en-US"/>
        </a:p>
      </dgm:t>
    </dgm:pt>
    <dgm:pt modelId="{A46583E9-C525-4B80-9CB0-AE41090E0878}">
      <dgm:prSet/>
      <dgm:spPr/>
      <dgm:t>
        <a:bodyPr/>
        <a:lstStyle/>
        <a:p>
          <a:pPr algn="l"/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Using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ganisational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upport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ervice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to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rovid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induction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raining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2C64CC2-42F9-44FE-8CC6-590D12199FBA}" type="parTrans" cxnId="{1685B032-B280-4901-8962-73C1E37431BE}">
      <dgm:prSet/>
      <dgm:spPr/>
      <dgm:t>
        <a:bodyPr/>
        <a:lstStyle/>
        <a:p>
          <a:endParaRPr lang="en-US"/>
        </a:p>
      </dgm:t>
    </dgm:pt>
    <dgm:pt modelId="{65B980DF-A4D4-4F80-B102-4B1BD571B0EC}" type="sibTrans" cxnId="{1685B032-B280-4901-8962-73C1E37431BE}">
      <dgm:prSet/>
      <dgm:spPr/>
      <dgm:t>
        <a:bodyPr/>
        <a:lstStyle/>
        <a:p>
          <a:endParaRPr lang="en-US"/>
        </a:p>
      </dgm:t>
    </dgm:pt>
    <dgm:pt modelId="{5BA581A6-B235-4547-944E-94088AC3B1D6}">
      <dgm:prSet/>
      <dgm:spPr/>
      <dgm:t>
        <a:bodyPr/>
        <a:lstStyle/>
        <a:p>
          <a:pPr algn="l"/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Gaining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insight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into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ganisation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D7B94CE-CC7B-47D2-93F8-E872854A6E5A}" type="parTrans" cxnId="{9A2CCA39-CC5D-489A-903E-4086F5C86162}">
      <dgm:prSet/>
      <dgm:spPr/>
      <dgm:t>
        <a:bodyPr/>
        <a:lstStyle/>
        <a:p>
          <a:endParaRPr lang="en-US"/>
        </a:p>
      </dgm:t>
    </dgm:pt>
    <dgm:pt modelId="{EC362E97-28F8-4E50-86A0-7865A4FE2819}" type="sibTrans" cxnId="{9A2CCA39-CC5D-489A-903E-4086F5C86162}">
      <dgm:prSet/>
      <dgm:spPr/>
      <dgm:t>
        <a:bodyPr/>
        <a:lstStyle/>
        <a:p>
          <a:endParaRPr lang="en-US"/>
        </a:p>
      </dgm:t>
    </dgm:pt>
    <dgm:pt modelId="{15B28189-93D1-48A5-AFEA-6EE89273BDE3}">
      <dgm:prSet/>
      <dgm:spPr/>
      <dgm:t>
        <a:bodyPr/>
        <a:lstStyle/>
        <a:p>
          <a:pPr algn="l"/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ientation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on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work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unit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and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it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olicies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3B58EF7-1EA2-4C3E-93E7-C661214FE717}" type="parTrans" cxnId="{C9E91EBF-8D10-4C1D-9BFA-7D7E312B3461}">
      <dgm:prSet/>
      <dgm:spPr/>
      <dgm:t>
        <a:bodyPr/>
        <a:lstStyle/>
        <a:p>
          <a:endParaRPr lang="en-US"/>
        </a:p>
      </dgm:t>
    </dgm:pt>
    <dgm:pt modelId="{F6E3A289-9280-4DD7-8A6C-D2F8ECD425F8}" type="sibTrans" cxnId="{C9E91EBF-8D10-4C1D-9BFA-7D7E312B3461}">
      <dgm:prSet/>
      <dgm:spPr/>
      <dgm:t>
        <a:bodyPr/>
        <a:lstStyle/>
        <a:p>
          <a:endParaRPr lang="en-US"/>
        </a:p>
      </dgm:t>
    </dgm:pt>
    <dgm:pt modelId="{FFE66D08-26BF-4B45-A829-5C3134D9B2E3}">
      <dgm:prSet/>
      <dgm:spPr/>
      <dgm:t>
        <a:bodyPr/>
        <a:lstStyle/>
        <a:p>
          <a:pPr algn="l"/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Networking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with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artners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within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ganisation</a:t>
          </a:r>
          <a:endParaRPr lang="fi-FI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66713ED-64D2-466D-80F3-5CABAFE09DE1}" type="parTrans" cxnId="{AF101A7D-2521-48B2-AF9B-BDE2DB953AF8}">
      <dgm:prSet/>
      <dgm:spPr/>
      <dgm:t>
        <a:bodyPr/>
        <a:lstStyle/>
        <a:p>
          <a:endParaRPr lang="en-US"/>
        </a:p>
      </dgm:t>
    </dgm:pt>
    <dgm:pt modelId="{40CBD0DE-DC58-4236-B7C9-7DBD0C861282}" type="sibTrans" cxnId="{AF101A7D-2521-48B2-AF9B-BDE2DB953AF8}">
      <dgm:prSet/>
      <dgm:spPr/>
      <dgm:t>
        <a:bodyPr/>
        <a:lstStyle/>
        <a:p>
          <a:endParaRPr lang="en-US"/>
        </a:p>
      </dgm:t>
    </dgm:pt>
    <dgm:pt modelId="{ACFC4516-89DA-4AE2-96DA-52B588E5C962}">
      <dgm:prSet/>
      <dgm:spPr/>
      <dgm:t>
        <a:bodyPr/>
        <a:lstStyle/>
        <a:p>
          <a:pPr algn="l"/>
          <a:r>
            <a:rPr lang="fi-FI" sz="1000" i="0" dirty="0" err="1">
              <a:latin typeface="Times New Roman"/>
              <a:cs typeface="Times New Roman"/>
            </a:rPr>
            <a:t>Gaining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the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trust</a:t>
          </a:r>
          <a:r>
            <a:rPr lang="fi-FI" sz="1000" i="0" dirty="0">
              <a:latin typeface="Times New Roman"/>
              <a:cs typeface="Times New Roman"/>
            </a:rPr>
            <a:t> of </a:t>
          </a:r>
          <a:r>
            <a:rPr lang="fi-FI" sz="1000" i="0" dirty="0" err="1">
              <a:latin typeface="Times New Roman"/>
              <a:cs typeface="Times New Roman"/>
            </a:rPr>
            <a:t>the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new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work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community</a:t>
          </a:r>
          <a:endParaRPr lang="fi-FI" sz="1000" i="0" dirty="0">
            <a:latin typeface="Times New Roman"/>
            <a:cs typeface="Times New Roman"/>
          </a:endParaRPr>
        </a:p>
      </dgm:t>
    </dgm:pt>
    <dgm:pt modelId="{CAE586C0-B9F6-4377-953A-90CDE4140912}" type="parTrans" cxnId="{544BDD1A-3A7B-4BB2-BC93-CAB6DFDE001E}">
      <dgm:prSet/>
      <dgm:spPr/>
      <dgm:t>
        <a:bodyPr/>
        <a:lstStyle/>
        <a:p>
          <a:endParaRPr lang="en-US"/>
        </a:p>
      </dgm:t>
    </dgm:pt>
    <dgm:pt modelId="{FC5BCEA2-6A4B-4AA2-BEAD-D5B485F4EC88}" type="sibTrans" cxnId="{544BDD1A-3A7B-4BB2-BC93-CAB6DFDE001E}">
      <dgm:prSet/>
      <dgm:spPr/>
      <dgm:t>
        <a:bodyPr/>
        <a:lstStyle/>
        <a:p>
          <a:endParaRPr lang="en-US"/>
        </a:p>
      </dgm:t>
    </dgm:pt>
    <dgm:pt modelId="{C0B00076-F166-44BC-AB38-7732F97C67B3}">
      <dgm:prSet/>
      <dgm:spPr/>
      <dgm:t>
        <a:bodyPr/>
        <a:lstStyle/>
        <a:p>
          <a:pPr algn="l"/>
          <a:r>
            <a:rPr lang="fi-FI" sz="1000" i="0" dirty="0" err="1">
              <a:latin typeface="Times New Roman"/>
              <a:cs typeface="Times New Roman"/>
            </a:rPr>
            <a:t>Introduction</a:t>
          </a:r>
          <a:r>
            <a:rPr lang="fi-FI" sz="1000" i="0" dirty="0">
              <a:latin typeface="Times New Roman"/>
              <a:cs typeface="Times New Roman"/>
            </a:rPr>
            <a:t> to </a:t>
          </a:r>
          <a:r>
            <a:rPr lang="fi-FI" sz="1000" i="0" dirty="0" err="1">
              <a:latin typeface="Times New Roman"/>
              <a:cs typeface="Times New Roman"/>
            </a:rPr>
            <a:t>the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word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community</a:t>
          </a:r>
          <a:r>
            <a:rPr lang="fi-FI" sz="1000" i="0" dirty="0">
              <a:latin typeface="Times New Roman"/>
              <a:cs typeface="Times New Roman"/>
            </a:rPr>
            <a:t> at </a:t>
          </a:r>
          <a:r>
            <a:rPr lang="fi-FI" sz="1000" i="0" dirty="0" err="1">
              <a:latin typeface="Times New Roman"/>
              <a:cs typeface="Times New Roman"/>
            </a:rPr>
            <a:t>the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beginning</a:t>
          </a:r>
          <a:r>
            <a:rPr lang="fi-FI" sz="1000" i="0" dirty="0">
              <a:latin typeface="Times New Roman"/>
              <a:cs typeface="Times New Roman"/>
            </a:rPr>
            <a:t> of </a:t>
          </a:r>
          <a:r>
            <a:rPr lang="fi-FI" sz="1000" i="0" dirty="0" err="1">
              <a:latin typeface="Times New Roman"/>
              <a:cs typeface="Times New Roman"/>
            </a:rPr>
            <a:t>the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onboarding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process</a:t>
          </a:r>
          <a:endParaRPr lang="fi-FI" sz="1000" i="0" dirty="0">
            <a:latin typeface="Times New Roman"/>
            <a:cs typeface="Times New Roman"/>
          </a:endParaRPr>
        </a:p>
      </dgm:t>
    </dgm:pt>
    <dgm:pt modelId="{3CACDB9F-14E3-4EC1-8F7E-43C278BE6E97}" type="parTrans" cxnId="{8D11DD2A-C87E-45C1-BC1A-426825822C67}">
      <dgm:prSet/>
      <dgm:spPr/>
      <dgm:t>
        <a:bodyPr/>
        <a:lstStyle/>
        <a:p>
          <a:endParaRPr lang="en-US"/>
        </a:p>
      </dgm:t>
    </dgm:pt>
    <dgm:pt modelId="{95811814-5827-4419-9CAA-4535A7B1961B}" type="sibTrans" cxnId="{8D11DD2A-C87E-45C1-BC1A-426825822C67}">
      <dgm:prSet/>
      <dgm:spPr/>
      <dgm:t>
        <a:bodyPr/>
        <a:lstStyle/>
        <a:p>
          <a:endParaRPr lang="en-US"/>
        </a:p>
      </dgm:t>
    </dgm:pt>
    <dgm:pt modelId="{1DAAE30F-7CFF-416D-B728-0B92BBCC3D76}">
      <dgm:prSet/>
      <dgm:spPr/>
      <dgm:t>
        <a:bodyPr/>
        <a:lstStyle/>
        <a:p>
          <a:pPr algn="l"/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Familiarisation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with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the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work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community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during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the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onboarding</a:t>
          </a:r>
          <a:r>
            <a:rPr lang="fi-FI" sz="1000" i="0" dirty="0">
              <a:latin typeface="Times New Roman"/>
              <a:cs typeface="Times New Roman"/>
            </a:rPr>
            <a:t> </a:t>
          </a:r>
          <a:r>
            <a:rPr lang="fi-FI" sz="1000" i="0" dirty="0" err="1">
              <a:latin typeface="Times New Roman"/>
              <a:cs typeface="Times New Roman"/>
            </a:rPr>
            <a:t>process</a:t>
          </a:r>
          <a:endParaRPr lang="fi-FI" sz="1000" i="0" dirty="0">
            <a:latin typeface="Times New Roman"/>
            <a:cs typeface="Times New Roman"/>
          </a:endParaRPr>
        </a:p>
      </dgm:t>
    </dgm:pt>
    <dgm:pt modelId="{0B40D4A5-B567-42A7-880F-B78AF23A9A49}" type="parTrans" cxnId="{82A0232A-00A3-4D94-9FA8-B31D3D5296C4}">
      <dgm:prSet/>
      <dgm:spPr/>
      <dgm:t>
        <a:bodyPr/>
        <a:lstStyle/>
        <a:p>
          <a:endParaRPr lang="en-US"/>
        </a:p>
      </dgm:t>
    </dgm:pt>
    <dgm:pt modelId="{CFAAFBC6-BA56-4FF2-9CB8-ECA3815C270F}" type="sibTrans" cxnId="{82A0232A-00A3-4D94-9FA8-B31D3D5296C4}">
      <dgm:prSet/>
      <dgm:spPr/>
      <dgm:t>
        <a:bodyPr/>
        <a:lstStyle/>
        <a:p>
          <a:endParaRPr lang="en-US"/>
        </a:p>
      </dgm:t>
    </dgm:pt>
    <dgm:pt modelId="{8055C405-B35C-42DD-A6F2-A3BC17BDFFA2}" type="pres">
      <dgm:prSet presAssocID="{893F0751-D47E-4BB9-B645-6BEEAFE2C817}" presName="diagram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7F2BCE39-FCBC-42C1-BEC2-5B6F3A0649E8}" type="pres">
      <dgm:prSet presAssocID="{297261F1-B47E-4081-8072-475D81429D3F}" presName="root" presStyleCnt="0"/>
      <dgm:spPr/>
    </dgm:pt>
    <dgm:pt modelId="{8CB42C98-93A3-4FBA-9DF4-9721AC4DB5BE}" type="pres">
      <dgm:prSet presAssocID="{297261F1-B47E-4081-8072-475D81429D3F}" presName="rootComposite" presStyleCnt="0"/>
      <dgm:spPr/>
    </dgm:pt>
    <dgm:pt modelId="{C8B32F1A-73F6-4CFB-898E-1F375A02F0F4}" type="pres">
      <dgm:prSet presAssocID="{297261F1-B47E-4081-8072-475D81429D3F}" presName="rootText" presStyleLbl="node1" presStyleIdx="0" presStyleCnt="5" custLinFactNeighborX="-49006" custLinFactNeighborY="1265"/>
      <dgm:spPr/>
    </dgm:pt>
    <dgm:pt modelId="{5261EC4F-3933-4FAB-9475-8005C9CAA956}" type="pres">
      <dgm:prSet presAssocID="{297261F1-B47E-4081-8072-475D81429D3F}" presName="rootConnector" presStyleLbl="node1" presStyleIdx="0" presStyleCnt="5"/>
      <dgm:spPr/>
    </dgm:pt>
    <dgm:pt modelId="{1C61BBCE-4397-4A88-97FE-CE5D2CC5A8A9}" type="pres">
      <dgm:prSet presAssocID="{297261F1-B47E-4081-8072-475D81429D3F}" presName="childShape" presStyleCnt="0"/>
      <dgm:spPr/>
    </dgm:pt>
    <dgm:pt modelId="{9AE2C79E-BC68-43E0-BC4E-715CB5FCF97A}" type="pres">
      <dgm:prSet presAssocID="{A50B0178-386D-4B04-97AC-0F1BA17C552B}" presName="Name13" presStyleLbl="parChTrans1D2" presStyleIdx="0" presStyleCnt="12"/>
      <dgm:spPr/>
    </dgm:pt>
    <dgm:pt modelId="{17E8B4A8-E390-4378-88F9-519EC8D6B3B2}" type="pres">
      <dgm:prSet presAssocID="{9E929A1C-7E79-4F59-BF92-1EC752367064}" presName="childText" presStyleLbl="bgAcc1" presStyleIdx="0" presStyleCnt="12" custScaleX="148583" custScaleY="260238" custLinFactNeighborX="-62157" custLinFactNeighborY="-7598">
        <dgm:presLayoutVars>
          <dgm:bulletEnabled val="1"/>
        </dgm:presLayoutVars>
      </dgm:prSet>
      <dgm:spPr/>
    </dgm:pt>
    <dgm:pt modelId="{A7FA9AA2-52DA-4463-B75D-11B958130DDE}" type="pres">
      <dgm:prSet presAssocID="{E754FF20-94C7-4043-8AD6-612DEBA9F151}" presName="Name13" presStyleLbl="parChTrans1D2" presStyleIdx="1" presStyleCnt="12"/>
      <dgm:spPr/>
    </dgm:pt>
    <dgm:pt modelId="{449115D0-14DF-47B5-AEBD-E09E5F564E47}" type="pres">
      <dgm:prSet presAssocID="{5EB792F6-8149-4598-BF41-27A8C76D4E62}" presName="childText" presStyleLbl="bgAcc1" presStyleIdx="1" presStyleCnt="12" custScaleX="152729" custScaleY="223224" custLinFactNeighborX="-60236" custLinFactNeighborY="-20972">
        <dgm:presLayoutVars>
          <dgm:bulletEnabled val="1"/>
        </dgm:presLayoutVars>
      </dgm:prSet>
      <dgm:spPr/>
    </dgm:pt>
    <dgm:pt modelId="{DBD8B98C-089C-43A2-8F82-DADF84FC0BF5}" type="pres">
      <dgm:prSet presAssocID="{DC867B4B-A820-42FF-BACF-A0E8628C5955}" presName="root" presStyleCnt="0"/>
      <dgm:spPr/>
    </dgm:pt>
    <dgm:pt modelId="{103EA590-D5C8-4A2F-B402-75522693669C}" type="pres">
      <dgm:prSet presAssocID="{DC867B4B-A820-42FF-BACF-A0E8628C5955}" presName="rootComposite" presStyleCnt="0"/>
      <dgm:spPr/>
    </dgm:pt>
    <dgm:pt modelId="{FE6B8099-4A47-40E3-8559-45ABD104E908}" type="pres">
      <dgm:prSet presAssocID="{DC867B4B-A820-42FF-BACF-A0E8628C5955}" presName="rootText" presStyleLbl="node1" presStyleIdx="1" presStyleCnt="5" custLinFactNeighborX="-33019" custLinFactNeighborY="1427"/>
      <dgm:spPr/>
    </dgm:pt>
    <dgm:pt modelId="{3214E0C3-0C43-4222-8D1A-58631F415EE6}" type="pres">
      <dgm:prSet presAssocID="{DC867B4B-A820-42FF-BACF-A0E8628C5955}" presName="rootConnector" presStyleLbl="node1" presStyleIdx="1" presStyleCnt="5"/>
      <dgm:spPr/>
    </dgm:pt>
    <dgm:pt modelId="{B370E7C7-E0EA-467A-B960-0E30D4503EE3}" type="pres">
      <dgm:prSet presAssocID="{DC867B4B-A820-42FF-BACF-A0E8628C5955}" presName="childShape" presStyleCnt="0"/>
      <dgm:spPr/>
    </dgm:pt>
    <dgm:pt modelId="{6994500D-BDC7-4786-B3D5-FE7E95D025D2}" type="pres">
      <dgm:prSet presAssocID="{4233DC9A-F633-494E-AD57-B74858058BA5}" presName="Name13" presStyleLbl="parChTrans1D2" presStyleIdx="2" presStyleCnt="12"/>
      <dgm:spPr/>
    </dgm:pt>
    <dgm:pt modelId="{B3D54134-D905-479E-85DE-EC84232694C6}" type="pres">
      <dgm:prSet presAssocID="{44AA9650-19D7-470B-908F-5A9769B3401B}" presName="childText" presStyleLbl="bgAcc1" presStyleIdx="2" presStyleCnt="12" custScaleX="149247" custScaleY="284882" custLinFactNeighborX="-38602" custLinFactNeighborY="-7248">
        <dgm:presLayoutVars>
          <dgm:bulletEnabled val="1"/>
        </dgm:presLayoutVars>
      </dgm:prSet>
      <dgm:spPr/>
    </dgm:pt>
    <dgm:pt modelId="{2CFF75CE-C3C6-463D-BDCB-66D43867374C}" type="pres">
      <dgm:prSet presAssocID="{A28C5AF5-8334-4553-9D15-827FCCE27E62}" presName="Name13" presStyleLbl="parChTrans1D2" presStyleIdx="3" presStyleCnt="12"/>
      <dgm:spPr/>
    </dgm:pt>
    <dgm:pt modelId="{E4862357-1B75-49C8-B375-5825B56D3CFB}" type="pres">
      <dgm:prSet presAssocID="{222D38C2-1955-4DCC-B96C-556179080A76}" presName="childText" presStyleLbl="bgAcc1" presStyleIdx="3" presStyleCnt="12" custScaleX="149997" custScaleY="269170" custLinFactNeighborX="-35291" custLinFactNeighborY="-20616">
        <dgm:presLayoutVars>
          <dgm:bulletEnabled val="1"/>
        </dgm:presLayoutVars>
      </dgm:prSet>
      <dgm:spPr/>
    </dgm:pt>
    <dgm:pt modelId="{F6A44199-9779-421F-9C9C-0B5235464190}" type="pres">
      <dgm:prSet presAssocID="{B8ECFFBD-07BD-4193-8F11-82F35AC636CE}" presName="root" presStyleCnt="0"/>
      <dgm:spPr/>
    </dgm:pt>
    <dgm:pt modelId="{0D8164E1-1BC7-4A2F-965E-60E66B52D6FE}" type="pres">
      <dgm:prSet presAssocID="{B8ECFFBD-07BD-4193-8F11-82F35AC636CE}" presName="rootComposite" presStyleCnt="0"/>
      <dgm:spPr/>
    </dgm:pt>
    <dgm:pt modelId="{76B1507D-EFE9-4062-951E-2DFE45BFB9AC}" type="pres">
      <dgm:prSet presAssocID="{B8ECFFBD-07BD-4193-8F11-82F35AC636CE}" presName="rootText" presStyleLbl="node1" presStyleIdx="2" presStyleCnt="5" custLinFactNeighborX="-18316" custLinFactNeighborY="4132"/>
      <dgm:spPr/>
    </dgm:pt>
    <dgm:pt modelId="{8C22C424-8443-44A7-86E5-C24BEE7BF0CA}" type="pres">
      <dgm:prSet presAssocID="{B8ECFFBD-07BD-4193-8F11-82F35AC636CE}" presName="rootConnector" presStyleLbl="node1" presStyleIdx="2" presStyleCnt="5"/>
      <dgm:spPr/>
    </dgm:pt>
    <dgm:pt modelId="{EEB48926-A5DA-42E8-9826-A956F4E0FB0A}" type="pres">
      <dgm:prSet presAssocID="{B8ECFFBD-07BD-4193-8F11-82F35AC636CE}" presName="childShape" presStyleCnt="0"/>
      <dgm:spPr/>
    </dgm:pt>
    <dgm:pt modelId="{33CA7DCE-096A-4947-8AA9-FA531401B7B7}" type="pres">
      <dgm:prSet presAssocID="{DB37F87B-B9D8-4ADC-8806-3F7694FDEE0E}" presName="Name13" presStyleLbl="parChTrans1D2" presStyleIdx="4" presStyleCnt="12"/>
      <dgm:spPr/>
    </dgm:pt>
    <dgm:pt modelId="{BCDFBFD8-E2A7-4F02-8C16-8707D887B47C}" type="pres">
      <dgm:prSet presAssocID="{29BDDE00-60A0-4927-88FE-53B31686FD82}" presName="childText" presStyleLbl="bgAcc1" presStyleIdx="4" presStyleCnt="12" custScaleX="165455" custScaleY="291601" custLinFactNeighborX="-25149" custLinFactNeighborY="-7442">
        <dgm:presLayoutVars>
          <dgm:bulletEnabled val="1"/>
        </dgm:presLayoutVars>
      </dgm:prSet>
      <dgm:spPr/>
    </dgm:pt>
    <dgm:pt modelId="{234CAFC8-4202-4E1F-852E-D3EEC6C4809C}" type="pres">
      <dgm:prSet presAssocID="{25F20FC7-470C-45C3-941D-97A0EE3E2009}" presName="Name13" presStyleLbl="parChTrans1D2" presStyleIdx="5" presStyleCnt="12"/>
      <dgm:spPr/>
    </dgm:pt>
    <dgm:pt modelId="{246F6227-BDA5-45E4-AC46-BCC4A68282B7}" type="pres">
      <dgm:prSet presAssocID="{F5E20EA8-EEFF-4ED3-8E08-9BAB1CB1C5A6}" presName="childText" presStyleLbl="bgAcc1" presStyleIdx="5" presStyleCnt="12" custScaleX="162885" custScaleY="194881" custLinFactNeighborX="-24979" custLinFactNeighborY="-22760">
        <dgm:presLayoutVars>
          <dgm:bulletEnabled val="1"/>
        </dgm:presLayoutVars>
      </dgm:prSet>
      <dgm:spPr/>
    </dgm:pt>
    <dgm:pt modelId="{9E3FBBAC-94E7-4B65-AF4B-E872E3FF67DF}" type="pres">
      <dgm:prSet presAssocID="{87D99917-73A7-4372-8991-450DB201FA27}" presName="Name13" presStyleLbl="parChTrans1D2" presStyleIdx="6" presStyleCnt="12"/>
      <dgm:spPr/>
    </dgm:pt>
    <dgm:pt modelId="{C7A11A55-1569-46E4-B948-373D5F38B2C7}" type="pres">
      <dgm:prSet presAssocID="{57013B7D-D6B4-4F4D-99B9-7C03A52D51FD}" presName="childText" presStyleLbl="bgAcc1" presStyleIdx="6" presStyleCnt="12" custScaleX="164456" custScaleY="184860" custLinFactNeighborX="-24514" custLinFactNeighborY="-31158">
        <dgm:presLayoutVars>
          <dgm:bulletEnabled val="1"/>
        </dgm:presLayoutVars>
      </dgm:prSet>
      <dgm:spPr/>
    </dgm:pt>
    <dgm:pt modelId="{45F0C578-9E94-4458-B715-C182453DB63B}" type="pres">
      <dgm:prSet presAssocID="{86C41EAC-5A50-484B-AA3F-D7C380B3245D}" presName="Name13" presStyleLbl="parChTrans1D2" presStyleIdx="7" presStyleCnt="12"/>
      <dgm:spPr/>
    </dgm:pt>
    <dgm:pt modelId="{A8022D62-A605-4344-BA60-65FA3DF18E0F}" type="pres">
      <dgm:prSet presAssocID="{03463784-F76F-4DA8-9126-19A615600ABC}" presName="childText" presStyleLbl="bgAcc1" presStyleIdx="7" presStyleCnt="12" custScaleX="169218" custScaleY="205724" custLinFactNeighborX="-23645" custLinFactNeighborY="-40950">
        <dgm:presLayoutVars>
          <dgm:bulletEnabled val="1"/>
        </dgm:presLayoutVars>
      </dgm:prSet>
      <dgm:spPr/>
    </dgm:pt>
    <dgm:pt modelId="{4581664E-C40F-4963-9889-F726ACBCD62B}" type="pres">
      <dgm:prSet presAssocID="{F36AE307-C90B-4AB6-A594-E607BC09EF70}" presName="root" presStyleCnt="0"/>
      <dgm:spPr/>
    </dgm:pt>
    <dgm:pt modelId="{A003C58D-623D-4E15-858E-C996FB0C695C}" type="pres">
      <dgm:prSet presAssocID="{F36AE307-C90B-4AB6-A594-E607BC09EF70}" presName="rootComposite" presStyleCnt="0"/>
      <dgm:spPr/>
    </dgm:pt>
    <dgm:pt modelId="{B2E6FE4C-3F7B-4F5B-9BC5-BDD10AA7FFA8}" type="pres">
      <dgm:prSet presAssocID="{F36AE307-C90B-4AB6-A594-E607BC09EF70}" presName="rootText" presStyleLbl="node1" presStyleIdx="3" presStyleCnt="5" custLinFactNeighborX="456" custLinFactNeighborY="6684"/>
      <dgm:spPr/>
    </dgm:pt>
    <dgm:pt modelId="{D3029FBD-B1A5-45FC-A376-F1B66570AE50}" type="pres">
      <dgm:prSet presAssocID="{F36AE307-C90B-4AB6-A594-E607BC09EF70}" presName="rootConnector" presStyleLbl="node1" presStyleIdx="3" presStyleCnt="5"/>
      <dgm:spPr/>
    </dgm:pt>
    <dgm:pt modelId="{26AEE05E-5524-413F-BB5A-7B89ECD878C8}" type="pres">
      <dgm:prSet presAssocID="{F36AE307-C90B-4AB6-A594-E607BC09EF70}" presName="childShape" presStyleCnt="0"/>
      <dgm:spPr/>
    </dgm:pt>
    <dgm:pt modelId="{2247C5F2-0CBB-4EFA-82D1-2DEFA9957229}" type="pres">
      <dgm:prSet presAssocID="{34BC541A-547D-448E-89A0-7A57401B86DF}" presName="Name13" presStyleLbl="parChTrans1D2" presStyleIdx="8" presStyleCnt="12"/>
      <dgm:spPr/>
    </dgm:pt>
    <dgm:pt modelId="{DEC44420-1736-4D8C-A947-4BCCD5D9D134}" type="pres">
      <dgm:prSet presAssocID="{0DFF0C05-9C69-4ED9-94D2-2FDE7282B4B6}" presName="childText" presStyleLbl="bgAcc1" presStyleIdx="8" presStyleCnt="12" custScaleX="147914" custScaleY="476443" custLinFactNeighborX="766" custLinFactNeighborY="-6053">
        <dgm:presLayoutVars>
          <dgm:bulletEnabled val="1"/>
        </dgm:presLayoutVars>
      </dgm:prSet>
      <dgm:spPr/>
    </dgm:pt>
    <dgm:pt modelId="{00F92ED2-8383-4C75-934C-DD3E3B3E92E2}" type="pres">
      <dgm:prSet presAssocID="{171903E8-8D60-4FD4-BDEB-07D086B43978}" presName="Name13" presStyleLbl="parChTrans1D2" presStyleIdx="9" presStyleCnt="12"/>
      <dgm:spPr/>
    </dgm:pt>
    <dgm:pt modelId="{B53836E7-3FB0-46DA-AFC2-3771AA2A0B7F}" type="pres">
      <dgm:prSet presAssocID="{93B39D24-82A3-43AF-ABD4-2EAE2A701584}" presName="childText" presStyleLbl="bgAcc1" presStyleIdx="9" presStyleCnt="12" custScaleX="146193" custScaleY="244406" custLinFactNeighborX="1958" custLinFactNeighborY="-17223">
        <dgm:presLayoutVars>
          <dgm:bulletEnabled val="1"/>
        </dgm:presLayoutVars>
      </dgm:prSet>
      <dgm:spPr/>
    </dgm:pt>
    <dgm:pt modelId="{747108F3-764B-4428-B57B-64CA8E95A763}" type="pres">
      <dgm:prSet presAssocID="{080216A2-EFD9-4017-85D0-DD531BB8A780}" presName="root" presStyleCnt="0"/>
      <dgm:spPr/>
    </dgm:pt>
    <dgm:pt modelId="{3A037DEB-EDDE-4DC9-BB12-57C9C4DCB426}" type="pres">
      <dgm:prSet presAssocID="{080216A2-EFD9-4017-85D0-DD531BB8A780}" presName="rootComposite" presStyleCnt="0"/>
      <dgm:spPr/>
    </dgm:pt>
    <dgm:pt modelId="{965CA15E-62FB-4179-B46A-579BF35E0EBB}" type="pres">
      <dgm:prSet presAssocID="{080216A2-EFD9-4017-85D0-DD531BB8A780}" presName="rootText" presStyleLbl="node1" presStyleIdx="4" presStyleCnt="5" custLinFactNeighborX="20953" custLinFactNeighborY="907"/>
      <dgm:spPr/>
    </dgm:pt>
    <dgm:pt modelId="{573D7137-9D81-4FA1-BAA3-DF136D77CE35}" type="pres">
      <dgm:prSet presAssocID="{080216A2-EFD9-4017-85D0-DD531BB8A780}" presName="rootConnector" presStyleLbl="node1" presStyleIdx="4" presStyleCnt="5"/>
      <dgm:spPr/>
    </dgm:pt>
    <dgm:pt modelId="{86AA9F94-6726-4DCE-8B94-AACAF2BB7287}" type="pres">
      <dgm:prSet presAssocID="{080216A2-EFD9-4017-85D0-DD531BB8A780}" presName="childShape" presStyleCnt="0"/>
      <dgm:spPr/>
    </dgm:pt>
    <dgm:pt modelId="{B8AD6272-8DDB-4B30-97DF-AC2AE814334E}" type="pres">
      <dgm:prSet presAssocID="{0F786998-1123-420F-B3B8-A4E68067FF90}" presName="Name13" presStyleLbl="parChTrans1D2" presStyleIdx="10" presStyleCnt="12"/>
      <dgm:spPr/>
    </dgm:pt>
    <dgm:pt modelId="{BEA6F7D1-713E-4973-AC32-EC1DC3C18412}" type="pres">
      <dgm:prSet presAssocID="{5DDEBA9C-B63C-43C5-9D57-54767F35CE3D}" presName="childText" presStyleLbl="bgAcc1" presStyleIdx="10" presStyleCnt="12" custScaleX="158626" custScaleY="248182" custLinFactNeighborX="27333" custLinFactNeighborY="-6149">
        <dgm:presLayoutVars>
          <dgm:bulletEnabled val="1"/>
        </dgm:presLayoutVars>
      </dgm:prSet>
      <dgm:spPr/>
    </dgm:pt>
    <dgm:pt modelId="{440E5204-EE43-4489-8F31-6EE4118839F5}" type="pres">
      <dgm:prSet presAssocID="{5FC7FCB2-AFBD-4F22-BE6E-7870B17B29DB}" presName="Name13" presStyleLbl="parChTrans1D2" presStyleIdx="11" presStyleCnt="12"/>
      <dgm:spPr/>
    </dgm:pt>
    <dgm:pt modelId="{F9EC0132-64F1-423F-9C1E-EC1E02508013}" type="pres">
      <dgm:prSet presAssocID="{9FB30D70-5F68-4597-8A56-D1A8E64DE511}" presName="childText" presStyleLbl="bgAcc1" presStyleIdx="11" presStyleCnt="12" custScaleX="159821" custScaleY="289654" custLinFactNeighborX="29125" custLinFactNeighborY="-18748">
        <dgm:presLayoutVars>
          <dgm:bulletEnabled val="1"/>
        </dgm:presLayoutVars>
      </dgm:prSet>
      <dgm:spPr/>
    </dgm:pt>
  </dgm:ptLst>
  <dgm:cxnLst>
    <dgm:cxn modelId="{73888401-B6F6-4171-971D-C08C93C8ACAF}" type="presOf" srcId="{9FB30D70-5F68-4597-8A56-D1A8E64DE511}" destId="{F9EC0132-64F1-423F-9C1E-EC1E02508013}" srcOrd="0" destOrd="0" presId="urn:microsoft.com/office/officeart/2005/8/layout/hierarchy3"/>
    <dgm:cxn modelId="{580B0402-8F3B-41A6-8956-8DDC48CAA00E}" srcId="{F5E20EA8-EEFF-4ED3-8E08-9BAB1CB1C5A6}" destId="{8166AFF3-841C-4469-A984-03D0021E2262}" srcOrd="1" destOrd="0" parTransId="{64A1CAAA-5F63-4E20-83E7-95394816AC24}" sibTransId="{47F584DE-0298-4272-9627-68D41C0B6141}"/>
    <dgm:cxn modelId="{AD8CB902-1CB8-40E1-8965-6C658D512568}" type="presOf" srcId="{F5E20EA8-EEFF-4ED3-8E08-9BAB1CB1C5A6}" destId="{246F6227-BDA5-45E4-AC46-BCC4A68282B7}" srcOrd="0" destOrd="0" presId="urn:microsoft.com/office/officeart/2005/8/layout/hierarchy3"/>
    <dgm:cxn modelId="{BCDCEA09-6E58-4D97-AB6B-8B28BCE4F7C3}" srcId="{03463784-F76F-4DA8-9126-19A615600ABC}" destId="{1CF7D7CA-1F01-44AA-9811-D9C19122DBBA}" srcOrd="0" destOrd="0" parTransId="{7721E666-65A9-4F9B-9245-A13452DB1E91}" sibTransId="{7CAD9F83-C75D-4438-8148-ED98009F2CC1}"/>
    <dgm:cxn modelId="{D7971B0E-E6A1-486E-90A8-BDA78F6B6EB0}" srcId="{93B39D24-82A3-43AF-ABD4-2EAE2A701584}" destId="{1C81D12C-3185-4C06-BB54-C4F12C9CC418}" srcOrd="0" destOrd="0" parTransId="{BE86D96C-6EF2-410A-8364-054866F85D4A}" sibTransId="{92ACBEB0-4D1E-49FE-8A4F-3255A1EE48B3}"/>
    <dgm:cxn modelId="{15C6250F-497A-48B2-B1AA-E40ED24BC174}" type="presOf" srcId="{E8AAAD70-5BDF-440F-8A73-ED43FD473D86}" destId="{A8022D62-A605-4344-BA60-65FA3DF18E0F}" srcOrd="0" destOrd="3" presId="urn:microsoft.com/office/officeart/2005/8/layout/hierarchy3"/>
    <dgm:cxn modelId="{DBB9B811-F024-4D8D-A4FB-3BB32FA159D9}" srcId="{0DFF0C05-9C69-4ED9-94D2-2FDE7282B4B6}" destId="{109FB078-1D64-45E2-927C-AD621D0F18E1}" srcOrd="3" destOrd="0" parTransId="{0AD442A6-44FF-4E45-84E5-FDAE17EE87C7}" sibTransId="{CD080529-7946-4283-8348-81FB666EF45A}"/>
    <dgm:cxn modelId="{E8F0C511-D245-4F79-863D-7678017F61E9}" type="presOf" srcId="{E754FF20-94C7-4043-8AD6-612DEBA9F151}" destId="{A7FA9AA2-52DA-4463-B75D-11B958130DDE}" srcOrd="0" destOrd="0" presId="urn:microsoft.com/office/officeart/2005/8/layout/hierarchy3"/>
    <dgm:cxn modelId="{BBA86E12-FA6D-4B9F-84BB-3E426BA08F98}" type="presOf" srcId="{7A342A2B-8DAD-4672-9A4B-1E6980E71830}" destId="{17E8B4A8-E390-4378-88F9-519EC8D6B3B2}" srcOrd="0" destOrd="1" presId="urn:microsoft.com/office/officeart/2005/8/layout/hierarchy3"/>
    <dgm:cxn modelId="{051EE112-55BA-4737-B45A-C4723C2D6FEA}" srcId="{893F0751-D47E-4BB9-B645-6BEEAFE2C817}" destId="{DC867B4B-A820-42FF-BACF-A0E8628C5955}" srcOrd="1" destOrd="0" parTransId="{66CB9B47-1B6F-4AF4-AF7E-8E7C8D771BE0}" sibTransId="{13E4B097-3195-4682-9FD2-E6407A5671E7}"/>
    <dgm:cxn modelId="{EBA85514-79FD-4CD1-98B1-89FD4BE492EC}" type="presOf" srcId="{5F2A99F2-7AB0-48C8-9CF9-06B14AB961AE}" destId="{DEC44420-1736-4D8C-A947-4BCCD5D9D134}" srcOrd="0" destOrd="3" presId="urn:microsoft.com/office/officeart/2005/8/layout/hierarchy3"/>
    <dgm:cxn modelId="{16371616-6619-4498-9A80-33AEFB04AA30}" srcId="{9E929A1C-7E79-4F59-BF92-1EC752367064}" destId="{011521D6-CD2E-401D-B6FF-CD0DE01F0EF4}" srcOrd="1" destOrd="0" parTransId="{8DDB9F96-41BA-4B92-A605-98BBB49FCF26}" sibTransId="{5B7D905B-0390-4441-9E73-64D0340A71EA}"/>
    <dgm:cxn modelId="{37180018-01D5-4B35-BFD6-44620F8AEA6F}" type="presOf" srcId="{5BA581A6-B235-4547-944E-94088AC3B1D6}" destId="{BEA6F7D1-713E-4973-AC32-EC1DC3C18412}" srcOrd="0" destOrd="1" presId="urn:microsoft.com/office/officeart/2005/8/layout/hierarchy3"/>
    <dgm:cxn modelId="{544BDD1A-3A7B-4BB2-BC93-CAB6DFDE001E}" srcId="{9FB30D70-5F68-4597-8A56-D1A8E64DE511}" destId="{ACFC4516-89DA-4AE2-96DA-52B588E5C962}" srcOrd="0" destOrd="0" parTransId="{CAE586C0-B9F6-4377-953A-90CDE4140912}" sibTransId="{FC5BCEA2-6A4B-4AA2-BEAD-D5B485F4EC88}"/>
    <dgm:cxn modelId="{DA205D1B-D030-4C7D-A83D-0C92CB60429A}" srcId="{893F0751-D47E-4BB9-B645-6BEEAFE2C817}" destId="{297261F1-B47E-4081-8072-475D81429D3F}" srcOrd="0" destOrd="0" parTransId="{65AF07E4-9CE7-456F-B0A0-CCA5B6EA9C41}" sibTransId="{27756B92-734E-45A5-872E-99594912BCEE}"/>
    <dgm:cxn modelId="{BBC93B1C-12F7-41A7-8F26-2DE315CA1150}" type="presOf" srcId="{87D99917-73A7-4372-8991-450DB201FA27}" destId="{9E3FBBAC-94E7-4B65-AF4B-E872E3FF67DF}" srcOrd="0" destOrd="0" presId="urn:microsoft.com/office/officeart/2005/8/layout/hierarchy3"/>
    <dgm:cxn modelId="{1C759F1D-EA25-4938-9275-CD4972978E05}" type="presOf" srcId="{ED7A4674-DA27-4317-B778-0BA4FCE9724B}" destId="{B3D54134-D905-479E-85DE-EC84232694C6}" srcOrd="0" destOrd="3" presId="urn:microsoft.com/office/officeart/2005/8/layout/hierarchy3"/>
    <dgm:cxn modelId="{BDC78D1E-D2D6-4E78-B2A4-BA6C3045176C}" type="presOf" srcId="{0300C804-132B-4963-8252-6E02B4F5B108}" destId="{C7A11A55-1569-46E4-B948-373D5F38B2C7}" srcOrd="0" destOrd="1" presId="urn:microsoft.com/office/officeart/2005/8/layout/hierarchy3"/>
    <dgm:cxn modelId="{2DDF7220-794C-433C-BA40-61EDAE30F5B1}" type="presOf" srcId="{BAFB43B3-5BA5-45A5-8D23-521FE6920C66}" destId="{B3D54134-D905-479E-85DE-EC84232694C6}" srcOrd="0" destOrd="1" presId="urn:microsoft.com/office/officeart/2005/8/layout/hierarchy3"/>
    <dgm:cxn modelId="{D0BFCA23-0608-47C0-B725-DB53170A913A}" type="presOf" srcId="{8166AFF3-841C-4469-A984-03D0021E2262}" destId="{246F6227-BDA5-45E4-AC46-BCC4A68282B7}" srcOrd="0" destOrd="2" presId="urn:microsoft.com/office/officeart/2005/8/layout/hierarchy3"/>
    <dgm:cxn modelId="{34B1B024-96CA-441C-A2D4-25D9420EB4B8}" srcId="{0DFF0C05-9C69-4ED9-94D2-2FDE7282B4B6}" destId="{5C152A59-8838-4F00-BCFE-50F813575CC8}" srcOrd="4" destOrd="0" parTransId="{D94C4C54-5EF8-48EE-A67E-37A2AC94401E}" sibTransId="{895F2A68-2519-4F84-8EEA-5716FD9EED62}"/>
    <dgm:cxn modelId="{82A0232A-00A3-4D94-9FA8-B31D3D5296C4}" srcId="{9FB30D70-5F68-4597-8A56-D1A8E64DE511}" destId="{1DAAE30F-7CFF-416D-B728-0B92BBCC3D76}" srcOrd="2" destOrd="0" parTransId="{0B40D4A5-B567-42A7-880F-B78AF23A9A49}" sibTransId="{CFAAFBC6-BA56-4FF2-9CB8-ECA3815C270F}"/>
    <dgm:cxn modelId="{8D11DD2A-C87E-45C1-BC1A-426825822C67}" srcId="{9FB30D70-5F68-4597-8A56-D1A8E64DE511}" destId="{C0B00076-F166-44BC-AB38-7732F97C67B3}" srcOrd="1" destOrd="0" parTransId="{3CACDB9F-14E3-4EC1-8F7E-43C278BE6E97}" sibTransId="{95811814-5827-4419-9CAA-4535A7B1961B}"/>
    <dgm:cxn modelId="{E9779E32-6CE6-4F57-B92C-CA22554A3F95}" type="presOf" srcId="{B8ECFFBD-07BD-4193-8F11-82F35AC636CE}" destId="{76B1507D-EFE9-4062-951E-2DFE45BFB9AC}" srcOrd="0" destOrd="0" presId="urn:microsoft.com/office/officeart/2005/8/layout/hierarchy3"/>
    <dgm:cxn modelId="{1685B032-B280-4901-8962-73C1E37431BE}" srcId="{93B39D24-82A3-43AF-ABD4-2EAE2A701584}" destId="{A46583E9-C525-4B80-9CB0-AE41090E0878}" srcOrd="1" destOrd="0" parTransId="{62C64CC2-42F9-44FE-8CC6-590D12199FBA}" sibTransId="{65B980DF-A4D4-4F80-B102-4B1BD571B0EC}"/>
    <dgm:cxn modelId="{657BA333-CB3D-4109-B551-566781A88EDB}" type="presOf" srcId="{A50B0178-386D-4B04-97AC-0F1BA17C552B}" destId="{9AE2C79E-BC68-43E0-BC4E-715CB5FCF97A}" srcOrd="0" destOrd="0" presId="urn:microsoft.com/office/officeart/2005/8/layout/hierarchy3"/>
    <dgm:cxn modelId="{49553638-D352-48D0-8F41-F9F48DA8DA60}" type="presOf" srcId="{1C81D12C-3185-4C06-BB54-C4F12C9CC418}" destId="{B53836E7-3FB0-46DA-AFC2-3771AA2A0B7F}" srcOrd="0" destOrd="1" presId="urn:microsoft.com/office/officeart/2005/8/layout/hierarchy3"/>
    <dgm:cxn modelId="{9A2CCA39-CC5D-489A-903E-4086F5C86162}" srcId="{5DDEBA9C-B63C-43C5-9D57-54767F35CE3D}" destId="{5BA581A6-B235-4547-944E-94088AC3B1D6}" srcOrd="0" destOrd="0" parTransId="{9D7B94CE-CC7B-47D2-93F8-E872854A6E5A}" sibTransId="{EC362E97-28F8-4E50-86A0-7865A4FE2819}"/>
    <dgm:cxn modelId="{7080323A-1FBE-4C33-B35B-320E8F2241F1}" srcId="{080216A2-EFD9-4017-85D0-DD531BB8A780}" destId="{5DDEBA9C-B63C-43C5-9D57-54767F35CE3D}" srcOrd="0" destOrd="0" parTransId="{0F786998-1123-420F-B3B8-A4E68067FF90}" sibTransId="{0677A488-3BC2-4160-B6D5-65F3570F019D}"/>
    <dgm:cxn modelId="{10506A3E-AADE-4FE0-9980-E583A4405840}" type="presOf" srcId="{171903E8-8D60-4FD4-BDEB-07D086B43978}" destId="{00F92ED2-8383-4C75-934C-DD3E3B3E92E2}" srcOrd="0" destOrd="0" presId="urn:microsoft.com/office/officeart/2005/8/layout/hierarchy3"/>
    <dgm:cxn modelId="{DB21CB40-CE45-4BB7-866E-640BEACA2CF9}" type="presOf" srcId="{37A4A9C7-17F1-47A9-B079-F49C9DA9791B}" destId="{BCDFBFD8-E2A7-4F02-8C16-8707D887B47C}" srcOrd="0" destOrd="3" presId="urn:microsoft.com/office/officeart/2005/8/layout/hierarchy3"/>
    <dgm:cxn modelId="{0A0DE140-81DA-4F24-80B5-5D9B432F5019}" type="presOf" srcId="{15B28189-93D1-48A5-AFEA-6EE89273BDE3}" destId="{BEA6F7D1-713E-4973-AC32-EC1DC3C18412}" srcOrd="0" destOrd="2" presId="urn:microsoft.com/office/officeart/2005/8/layout/hierarchy3"/>
    <dgm:cxn modelId="{5C0D4C5D-3F81-49C1-8F1D-E1D6ADFF4D0F}" type="presOf" srcId="{8BC2E66F-731A-46EA-9259-F00C3B6FEE11}" destId="{246F6227-BDA5-45E4-AC46-BCC4A68282B7}" srcOrd="0" destOrd="1" presId="urn:microsoft.com/office/officeart/2005/8/layout/hierarchy3"/>
    <dgm:cxn modelId="{12AE555F-BF8C-4328-A91B-A7EB26270DE5}" srcId="{DC867B4B-A820-42FF-BACF-A0E8628C5955}" destId="{222D38C2-1955-4DCC-B96C-556179080A76}" srcOrd="1" destOrd="0" parTransId="{A28C5AF5-8334-4553-9D15-827FCCE27E62}" sibTransId="{9365377D-E868-425F-A471-0BED27C01600}"/>
    <dgm:cxn modelId="{0698C460-4463-4337-AFAC-A39BFB356BEA}" type="presOf" srcId="{34BC541A-547D-448E-89A0-7A57401B86DF}" destId="{2247C5F2-0CBB-4EFA-82D1-2DEFA9957229}" srcOrd="0" destOrd="0" presId="urn:microsoft.com/office/officeart/2005/8/layout/hierarchy3"/>
    <dgm:cxn modelId="{A19A0062-EACA-4C94-A4C1-1D7384E7CBBD}" type="presOf" srcId="{CDCCDA22-9AAE-4E96-88F7-DD4A4E8D8CB0}" destId="{449115D0-14DF-47B5-AEBD-E09E5F564E47}" srcOrd="0" destOrd="2" presId="urn:microsoft.com/office/officeart/2005/8/layout/hierarchy3"/>
    <dgm:cxn modelId="{54391B42-BCA5-4C60-ACDD-F66F4F76A1E8}" type="presOf" srcId="{C0B00076-F166-44BC-AB38-7732F97C67B3}" destId="{F9EC0132-64F1-423F-9C1E-EC1E02508013}" srcOrd="0" destOrd="2" presId="urn:microsoft.com/office/officeart/2005/8/layout/hierarchy3"/>
    <dgm:cxn modelId="{B38DEB42-C6BD-4356-9891-736AE33D08AE}" type="presOf" srcId="{893F0751-D47E-4BB9-B645-6BEEAFE2C817}" destId="{8055C405-B35C-42DD-A6F2-A3BC17BDFFA2}" srcOrd="0" destOrd="0" presId="urn:microsoft.com/office/officeart/2005/8/layout/hierarchy3"/>
    <dgm:cxn modelId="{E96F1264-2FBE-4B5C-8F21-48B96A7121AA}" srcId="{297261F1-B47E-4081-8072-475D81429D3F}" destId="{5EB792F6-8149-4598-BF41-27A8C76D4E62}" srcOrd="1" destOrd="0" parTransId="{E754FF20-94C7-4043-8AD6-612DEBA9F151}" sibTransId="{E998111D-14D5-4C53-B1A7-42363988C1AC}"/>
    <dgm:cxn modelId="{D31EB265-B7C7-401C-B279-3F5E5E22A164}" type="presOf" srcId="{E22BC852-6AF9-470E-BE5B-26EA51BCBB11}" destId="{B3D54134-D905-479E-85DE-EC84232694C6}" srcOrd="0" destOrd="2" presId="urn:microsoft.com/office/officeart/2005/8/layout/hierarchy3"/>
    <dgm:cxn modelId="{E7211366-BF75-45F0-8CA7-0B78CCB7B56E}" type="presOf" srcId="{9E929A1C-7E79-4F59-BF92-1EC752367064}" destId="{17E8B4A8-E390-4378-88F9-519EC8D6B3B2}" srcOrd="0" destOrd="0" presId="urn:microsoft.com/office/officeart/2005/8/layout/hierarchy3"/>
    <dgm:cxn modelId="{8EAFAA66-CE5E-4CC6-9016-AECF397203DD}" type="presOf" srcId="{1DAAE30F-7CFF-416D-B728-0B92BBCC3D76}" destId="{F9EC0132-64F1-423F-9C1E-EC1E02508013}" srcOrd="0" destOrd="3" presId="urn:microsoft.com/office/officeart/2005/8/layout/hierarchy3"/>
    <dgm:cxn modelId="{C321CA46-332A-43B0-9413-EC87C4329428}" srcId="{29BDDE00-60A0-4927-88FE-53B31686FD82}" destId="{4B008D41-2728-4EA6-A964-76BD415F05AE}" srcOrd="1" destOrd="0" parTransId="{A3DF0071-62E4-48BB-BC9A-8D764B127C7B}" sibTransId="{9371E4D9-982C-4D07-873F-A0AC1B850DA1}"/>
    <dgm:cxn modelId="{12681D67-A663-4680-97F7-AAA6A1D5A047}" type="presOf" srcId="{B4197589-FB93-4EAF-BA08-67ADD7E567B7}" destId="{C7A11A55-1569-46E4-B948-373D5F38B2C7}" srcOrd="0" destOrd="2" presId="urn:microsoft.com/office/officeart/2005/8/layout/hierarchy3"/>
    <dgm:cxn modelId="{93E33367-0544-4B2F-B4DD-FB974E2FE88B}" srcId="{F5E20EA8-EEFF-4ED3-8E08-9BAB1CB1C5A6}" destId="{8BC2E66F-731A-46EA-9259-F00C3B6FEE11}" srcOrd="0" destOrd="0" parTransId="{BC101435-5E8F-45D4-9A32-76F653569F0F}" sibTransId="{2B1229EB-AECB-4E05-90D7-090BBEDE7090}"/>
    <dgm:cxn modelId="{E9F81D49-A8BE-4635-8795-4AA5AC2CB083}" srcId="{03463784-F76F-4DA8-9126-19A615600ABC}" destId="{9E29546F-8092-46C0-8BA5-43575C7B3AE4}" srcOrd="1" destOrd="0" parTransId="{8E19DEE0-C468-463B-8710-1DC253C69049}" sibTransId="{71D663F8-7F15-4F8E-B9AD-081EEBE0F201}"/>
    <dgm:cxn modelId="{784DA46C-6C8E-4D6E-A1E6-A00EE8C19C79}" type="presOf" srcId="{25F20FC7-470C-45C3-941D-97A0EE3E2009}" destId="{234CAFC8-4202-4E1F-852E-D3EEC6C4809C}" srcOrd="0" destOrd="0" presId="urn:microsoft.com/office/officeart/2005/8/layout/hierarchy3"/>
    <dgm:cxn modelId="{8C0C4B6F-1E4E-4D07-A0AB-258B483D65D2}" srcId="{9E929A1C-7E79-4F59-BF92-1EC752367064}" destId="{7A342A2B-8DAD-4672-9A4B-1E6980E71830}" srcOrd="0" destOrd="0" parTransId="{60D0E8F8-B918-42B2-A4AB-FA90144E0F83}" sibTransId="{12FD97A2-45C0-4FBA-AEA7-19A28F398238}"/>
    <dgm:cxn modelId="{8A796850-4160-4C5F-A366-63DB6AE70868}" srcId="{5EB792F6-8149-4598-BF41-27A8C76D4E62}" destId="{611E7A9C-196C-4A17-A7A2-A0B8B708E605}" srcOrd="0" destOrd="0" parTransId="{48881E2C-45FD-46B7-8EDC-E0DB7F97128E}" sibTransId="{A5A04712-1B4F-467F-9AE0-7AB73111626A}"/>
    <dgm:cxn modelId="{002F0351-3097-472C-9C41-B2DE436BEC0A}" type="presOf" srcId="{611E7A9C-196C-4A17-A7A2-A0B8B708E605}" destId="{449115D0-14DF-47B5-AEBD-E09E5F564E47}" srcOrd="0" destOrd="1" presId="urn:microsoft.com/office/officeart/2005/8/layout/hierarchy3"/>
    <dgm:cxn modelId="{AF3A1052-1C86-4503-AA51-439F760D2F18}" type="presOf" srcId="{E53BD961-CED2-4F02-A553-B7FBEE94C8E1}" destId="{DEC44420-1736-4D8C-A947-4BCCD5D9D134}" srcOrd="0" destOrd="1" presId="urn:microsoft.com/office/officeart/2005/8/layout/hierarchy3"/>
    <dgm:cxn modelId="{E37E7453-A1C6-41B4-964D-45902C26C517}" type="presOf" srcId="{9E29546F-8092-46C0-8BA5-43575C7B3AE4}" destId="{A8022D62-A605-4344-BA60-65FA3DF18E0F}" srcOrd="0" destOrd="2" presId="urn:microsoft.com/office/officeart/2005/8/layout/hierarchy3"/>
    <dgm:cxn modelId="{6E7FE156-DEAC-42C4-A513-6FC186B8A4FC}" type="presOf" srcId="{0DFF0C05-9C69-4ED9-94D2-2FDE7282B4B6}" destId="{DEC44420-1736-4D8C-A947-4BCCD5D9D134}" srcOrd="0" destOrd="0" presId="urn:microsoft.com/office/officeart/2005/8/layout/hierarchy3"/>
    <dgm:cxn modelId="{E5677277-E084-4650-9046-EE5D63FF8295}" type="presOf" srcId="{7F3CB92D-D07A-4968-AA50-B516A09A581E}" destId="{DEC44420-1736-4D8C-A947-4BCCD5D9D134}" srcOrd="0" destOrd="6" presId="urn:microsoft.com/office/officeart/2005/8/layout/hierarchy3"/>
    <dgm:cxn modelId="{F2E4C557-1E63-48E6-9E29-1A711875B502}" type="presOf" srcId="{B8ECFFBD-07BD-4193-8F11-82F35AC636CE}" destId="{8C22C424-8443-44A7-86E5-C24BEE7BF0CA}" srcOrd="1" destOrd="0" presId="urn:microsoft.com/office/officeart/2005/8/layout/hierarchy3"/>
    <dgm:cxn modelId="{8B602B58-68F7-42BA-AB0E-743ABD935655}" srcId="{0DFF0C05-9C69-4ED9-94D2-2FDE7282B4B6}" destId="{7F3CB92D-D07A-4968-AA50-B516A09A581E}" srcOrd="5" destOrd="0" parTransId="{DDC2C976-D0EE-493B-85D7-ADC8E11721B5}" sibTransId="{9B66C6CD-46AF-43A4-9AFA-FBFD7884D253}"/>
    <dgm:cxn modelId="{D88C7958-D7EA-4D85-B17A-99F689642B94}" srcId="{B8ECFFBD-07BD-4193-8F11-82F35AC636CE}" destId="{03463784-F76F-4DA8-9126-19A615600ABC}" srcOrd="3" destOrd="0" parTransId="{86C41EAC-5A50-484B-AA3F-D7C380B3245D}" sibTransId="{50B24858-AF7E-4304-B387-523CAB17423B}"/>
    <dgm:cxn modelId="{90EF6379-6321-4D6A-9AE6-61BD3C21795A}" type="presOf" srcId="{4B008D41-2728-4EA6-A964-76BD415F05AE}" destId="{BCDFBFD8-E2A7-4F02-8C16-8707D887B47C}" srcOrd="0" destOrd="2" presId="urn:microsoft.com/office/officeart/2005/8/layout/hierarchy3"/>
    <dgm:cxn modelId="{D2838679-576F-4B73-9D45-0C3BA588FF7F}" type="presOf" srcId="{222D38C2-1955-4DCC-B96C-556179080A76}" destId="{E4862357-1B75-49C8-B375-5825B56D3CFB}" srcOrd="0" destOrd="0" presId="urn:microsoft.com/office/officeart/2005/8/layout/hierarchy3"/>
    <dgm:cxn modelId="{B9AEA17A-EB40-4199-A12C-042907598347}" type="presOf" srcId="{297261F1-B47E-4081-8072-475D81429D3F}" destId="{5261EC4F-3933-4FAB-9475-8005C9CAA956}" srcOrd="1" destOrd="0" presId="urn:microsoft.com/office/officeart/2005/8/layout/hierarchy3"/>
    <dgm:cxn modelId="{2928CD5A-10E0-401C-A2EE-2B3FA0690E31}" type="presOf" srcId="{DC867B4B-A820-42FF-BACF-A0E8628C5955}" destId="{3214E0C3-0C43-4222-8D1A-58631F415EE6}" srcOrd="1" destOrd="0" presId="urn:microsoft.com/office/officeart/2005/8/layout/hierarchy3"/>
    <dgm:cxn modelId="{036F6E7B-E1D9-484C-999F-E5E7CF9B5EE3}" type="presOf" srcId="{011521D6-CD2E-401D-B6FF-CD0DE01F0EF4}" destId="{17E8B4A8-E390-4378-88F9-519EC8D6B3B2}" srcOrd="0" destOrd="2" presId="urn:microsoft.com/office/officeart/2005/8/layout/hierarchy3"/>
    <dgm:cxn modelId="{E554B97B-444B-4A76-ADEA-2F7C53A0CF41}" type="presOf" srcId="{5C152A59-8838-4F00-BCFE-50F813575CC8}" destId="{DEC44420-1736-4D8C-A947-4BCCD5D9D134}" srcOrd="0" destOrd="5" presId="urn:microsoft.com/office/officeart/2005/8/layout/hierarchy3"/>
    <dgm:cxn modelId="{D116117D-A300-4A99-A8CA-6DA9C488AACC}" type="presOf" srcId="{1CF7D7CA-1F01-44AA-9811-D9C19122DBBA}" destId="{A8022D62-A605-4344-BA60-65FA3DF18E0F}" srcOrd="0" destOrd="1" presId="urn:microsoft.com/office/officeart/2005/8/layout/hierarchy3"/>
    <dgm:cxn modelId="{AF101A7D-2521-48B2-AF9B-BDE2DB953AF8}" srcId="{5DDEBA9C-B63C-43C5-9D57-54767F35CE3D}" destId="{FFE66D08-26BF-4B45-A829-5C3134D9B2E3}" srcOrd="2" destOrd="0" parTransId="{166713ED-64D2-466D-80F3-5CABAFE09DE1}" sibTransId="{40CBD0DE-DC58-4236-B7C9-7DBD0C861282}"/>
    <dgm:cxn modelId="{69ED217D-E5AB-439A-AB1E-4C0570386A1B}" srcId="{DC867B4B-A820-42FF-BACF-A0E8628C5955}" destId="{44AA9650-19D7-470B-908F-5A9769B3401B}" srcOrd="0" destOrd="0" parTransId="{4233DC9A-F633-494E-AD57-B74858058BA5}" sibTransId="{2CE25AA9-04DA-4D5C-91C8-B3E54AA13C7E}"/>
    <dgm:cxn modelId="{A0EB747E-FC88-42A4-94E2-BD28EE49018B}" type="presOf" srcId="{5DDEBA9C-B63C-43C5-9D57-54767F35CE3D}" destId="{BEA6F7D1-713E-4973-AC32-EC1DC3C18412}" srcOrd="0" destOrd="0" presId="urn:microsoft.com/office/officeart/2005/8/layout/hierarchy3"/>
    <dgm:cxn modelId="{0C88727F-394A-4E98-94A2-1E987A7BB28E}" srcId="{893F0751-D47E-4BB9-B645-6BEEAFE2C817}" destId="{F36AE307-C90B-4AB6-A594-E607BC09EF70}" srcOrd="3" destOrd="0" parTransId="{EB7C2F43-750A-4A8C-9945-E2AD3F81E77F}" sibTransId="{15451F22-553A-44F3-B3E5-A2E71543CE5A}"/>
    <dgm:cxn modelId="{BD261780-30C9-4F06-9E8A-637121B0625C}" srcId="{29BDDE00-60A0-4927-88FE-53B31686FD82}" destId="{37A4A9C7-17F1-47A9-B079-F49C9DA9791B}" srcOrd="2" destOrd="0" parTransId="{F13ADE65-A626-427B-850B-D5C240DB0E77}" sibTransId="{81DBC288-EBFD-4F6E-BF71-49E6E07CFB3E}"/>
    <dgm:cxn modelId="{5C638D81-CB04-49DE-A67D-DD5AA5B250BD}" type="presOf" srcId="{297261F1-B47E-4081-8072-475D81429D3F}" destId="{C8B32F1A-73F6-4CFB-898E-1F375A02F0F4}" srcOrd="0" destOrd="0" presId="urn:microsoft.com/office/officeart/2005/8/layout/hierarchy3"/>
    <dgm:cxn modelId="{0E002E86-D7CA-4BB0-BCC5-48E47A6ED356}" type="presOf" srcId="{A0CEF768-7728-4132-A981-ED989985080F}" destId="{B53836E7-3FB0-46DA-AFC2-3771AA2A0B7F}" srcOrd="0" destOrd="3" presId="urn:microsoft.com/office/officeart/2005/8/layout/hierarchy3"/>
    <dgm:cxn modelId="{D58F4887-339D-40A3-BDCB-389A1DA1D652}" srcId="{0DFF0C05-9C69-4ED9-94D2-2FDE7282B4B6}" destId="{5F2A99F2-7AB0-48C8-9CF9-06B14AB961AE}" srcOrd="2" destOrd="0" parTransId="{E0242CE3-4689-4752-89D5-26605BDA3C00}" sibTransId="{B953A73C-720D-4D5D-820E-946835123CCF}"/>
    <dgm:cxn modelId="{4E52EC88-750D-4A20-AE22-FBA3D75E30FD}" type="presOf" srcId="{A28C5AF5-8334-4553-9D15-827FCCE27E62}" destId="{2CFF75CE-C3C6-463D-BDCB-66D43867374C}" srcOrd="0" destOrd="0" presId="urn:microsoft.com/office/officeart/2005/8/layout/hierarchy3"/>
    <dgm:cxn modelId="{3C70AC89-D8B3-4A0A-AC2D-DD7FE15F664C}" srcId="{44AA9650-19D7-470B-908F-5A9769B3401B}" destId="{ED7A4674-DA27-4317-B778-0BA4FCE9724B}" srcOrd="2" destOrd="0" parTransId="{42C88B20-37E8-4313-A978-AE3527ACCDC4}" sibTransId="{895DCD8B-E5F7-4A55-B258-D6EF32143B6B}"/>
    <dgm:cxn modelId="{6A7E608B-1CDD-410E-9E6B-65441D7042CF}" srcId="{0DFF0C05-9C69-4ED9-94D2-2FDE7282B4B6}" destId="{E53BD961-CED2-4F02-A553-B7FBEE94C8E1}" srcOrd="0" destOrd="0" parTransId="{F76F3F1F-89AF-498D-AF9F-5EB3AE08ED3F}" sibTransId="{68EF23BD-2258-47D6-8B00-67747E4697A4}"/>
    <dgm:cxn modelId="{046EB88E-3C12-4941-A14B-7B0AD0E5C7BD}" type="presOf" srcId="{FFE66D08-26BF-4B45-A829-5C3134D9B2E3}" destId="{BEA6F7D1-713E-4973-AC32-EC1DC3C18412}" srcOrd="0" destOrd="3" presId="urn:microsoft.com/office/officeart/2005/8/layout/hierarchy3"/>
    <dgm:cxn modelId="{D4BC0A8F-5D31-436D-82DD-AA6E2E3DA50F}" type="presOf" srcId="{0F786998-1123-420F-B3B8-A4E68067FF90}" destId="{B8AD6272-8DDB-4B30-97DF-AC2AE814334E}" srcOrd="0" destOrd="0" presId="urn:microsoft.com/office/officeart/2005/8/layout/hierarchy3"/>
    <dgm:cxn modelId="{6796908F-C1B8-41A9-A214-0446D6CAB285}" srcId="{93B39D24-82A3-43AF-ABD4-2EAE2A701584}" destId="{A0CEF768-7728-4132-A981-ED989985080F}" srcOrd="2" destOrd="0" parTransId="{42EA6686-8073-4C55-BB60-445182F24AA8}" sibTransId="{25E5B05C-4801-4250-93A4-867CFC2C5D82}"/>
    <dgm:cxn modelId="{474815A3-B067-44EA-B790-3DC02D5F5E89}" type="presOf" srcId="{DB37F87B-B9D8-4ADC-8806-3F7694FDEE0E}" destId="{33CA7DCE-096A-4947-8AA9-FA531401B7B7}" srcOrd="0" destOrd="0" presId="urn:microsoft.com/office/officeart/2005/8/layout/hierarchy3"/>
    <dgm:cxn modelId="{AA701DA6-496A-46CC-BD5F-AB103F005C38}" type="presOf" srcId="{F2442C08-3556-4A62-9016-5CF2273C2006}" destId="{BCDFBFD8-E2A7-4F02-8C16-8707D887B47C}" srcOrd="0" destOrd="1" presId="urn:microsoft.com/office/officeart/2005/8/layout/hierarchy3"/>
    <dgm:cxn modelId="{439D1FA6-563D-4D66-81C3-E46624D1E3DD}" type="presOf" srcId="{ABBB9EE4-0A81-45DE-8CB2-C11436DAA077}" destId="{E4862357-1B75-49C8-B375-5825B56D3CFB}" srcOrd="0" destOrd="1" presId="urn:microsoft.com/office/officeart/2005/8/layout/hierarchy3"/>
    <dgm:cxn modelId="{94C02AA8-D332-45DE-8F6D-5E12EEB4F99E}" type="presOf" srcId="{2625232C-CF28-41CD-BCE2-4A7053ED617D}" destId="{F9EC0132-64F1-423F-9C1E-EC1E02508013}" srcOrd="0" destOrd="4" presId="urn:microsoft.com/office/officeart/2005/8/layout/hierarchy3"/>
    <dgm:cxn modelId="{EE58E7AB-8AD3-445B-8D76-E14364BCFED2}" srcId="{B8ECFFBD-07BD-4193-8F11-82F35AC636CE}" destId="{29BDDE00-60A0-4927-88FE-53B31686FD82}" srcOrd="0" destOrd="0" parTransId="{DB37F87B-B9D8-4ADC-8806-3F7694FDEE0E}" sibTransId="{3DCE6546-9E26-4AAB-9C50-477E20312F22}"/>
    <dgm:cxn modelId="{27F5CCAC-B938-4297-8A82-5F3B15D92C86}" srcId="{29BDDE00-60A0-4927-88FE-53B31686FD82}" destId="{D952E32F-E49D-4E36-980F-AB3070184515}" srcOrd="3" destOrd="0" parTransId="{9F0F259E-F733-437F-BA86-6564A3149EF3}" sibTransId="{0A820BCB-A5DF-4CE9-AF77-BD4E42D6EA90}"/>
    <dgm:cxn modelId="{C7AF07AF-E4F8-4AB1-9467-AAEAF025B47F}" type="presOf" srcId="{44AA9650-19D7-470B-908F-5A9769B3401B}" destId="{B3D54134-D905-479E-85DE-EC84232694C6}" srcOrd="0" destOrd="0" presId="urn:microsoft.com/office/officeart/2005/8/layout/hierarchy3"/>
    <dgm:cxn modelId="{7CD7C3AF-E3A9-414A-99B7-CDC528A2D1EF}" srcId="{080216A2-EFD9-4017-85D0-DD531BB8A780}" destId="{9FB30D70-5F68-4597-8A56-D1A8E64DE511}" srcOrd="1" destOrd="0" parTransId="{5FC7FCB2-AFBD-4F22-BE6E-7870B17B29DB}" sibTransId="{A6ACC729-5C02-4A7F-9C39-446D67A89B2E}"/>
    <dgm:cxn modelId="{525369B2-E555-4BA4-90F7-74AA2DA9CAFC}" srcId="{B8ECFFBD-07BD-4193-8F11-82F35AC636CE}" destId="{F5E20EA8-EEFF-4ED3-8E08-9BAB1CB1C5A6}" srcOrd="1" destOrd="0" parTransId="{25F20FC7-470C-45C3-941D-97A0EE3E2009}" sibTransId="{8ED03595-9DCF-48AE-B9E2-3F4B31B6075C}"/>
    <dgm:cxn modelId="{3945E9B3-8C93-4247-9803-C5C15F224608}" srcId="{F36AE307-C90B-4AB6-A594-E607BC09EF70}" destId="{93B39D24-82A3-43AF-ABD4-2EAE2A701584}" srcOrd="1" destOrd="0" parTransId="{171903E8-8D60-4FD4-BDEB-07D086B43978}" sibTransId="{2AD44546-204D-4031-AF11-2D69786A1FDE}"/>
    <dgm:cxn modelId="{DFDCA1B5-2549-4C87-B3A9-D7B94F3834CB}" type="presOf" srcId="{F36AE307-C90B-4AB6-A594-E607BC09EF70}" destId="{B2E6FE4C-3F7B-4F5B-9BC5-BDD10AA7FFA8}" srcOrd="0" destOrd="0" presId="urn:microsoft.com/office/officeart/2005/8/layout/hierarchy3"/>
    <dgm:cxn modelId="{9E161EB6-582D-4175-94BC-D59DE6943815}" type="presOf" srcId="{4233DC9A-F633-494E-AD57-B74858058BA5}" destId="{6994500D-BDC7-4786-B3D5-FE7E95D025D2}" srcOrd="0" destOrd="0" presId="urn:microsoft.com/office/officeart/2005/8/layout/hierarchy3"/>
    <dgm:cxn modelId="{AFD534BA-3797-45A3-9624-62D6C6FED3FA}" type="presOf" srcId="{F36AE307-C90B-4AB6-A594-E607BC09EF70}" destId="{D3029FBD-B1A5-45FC-A376-F1B66570AE50}" srcOrd="1" destOrd="0" presId="urn:microsoft.com/office/officeart/2005/8/layout/hierarchy3"/>
    <dgm:cxn modelId="{41EEF3BB-F8B2-4797-B42B-3D020FCB74D1}" srcId="{B8ECFFBD-07BD-4193-8F11-82F35AC636CE}" destId="{57013B7D-D6B4-4F4D-99B9-7C03A52D51FD}" srcOrd="2" destOrd="0" parTransId="{87D99917-73A7-4372-8991-450DB201FA27}" sibTransId="{AAC5403C-1C94-418B-94BE-597806E9E52F}"/>
    <dgm:cxn modelId="{DE6478BD-800D-4CA4-9459-5D612AF5C838}" type="presOf" srcId="{93B39D24-82A3-43AF-ABD4-2EAE2A701584}" destId="{B53836E7-3FB0-46DA-AFC2-3771AA2A0B7F}" srcOrd="0" destOrd="0" presId="urn:microsoft.com/office/officeart/2005/8/layout/hierarchy3"/>
    <dgm:cxn modelId="{C9E91EBF-8D10-4C1D-9BFA-7D7E312B3461}" srcId="{5DDEBA9C-B63C-43C5-9D57-54767F35CE3D}" destId="{15B28189-93D1-48A5-AFEA-6EE89273BDE3}" srcOrd="1" destOrd="0" parTransId="{13B58EF7-1EA2-4C3E-93E7-C661214FE717}" sibTransId="{F6E3A289-9280-4DD7-8A6C-D2F8ECD425F8}"/>
    <dgm:cxn modelId="{AE9760C1-EF9E-45D4-A3AE-BE1075C7D5E6}" type="presOf" srcId="{57013B7D-D6B4-4F4D-99B9-7C03A52D51FD}" destId="{C7A11A55-1569-46E4-B948-373D5F38B2C7}" srcOrd="0" destOrd="0" presId="urn:microsoft.com/office/officeart/2005/8/layout/hierarchy3"/>
    <dgm:cxn modelId="{ED5E65C4-1936-4E0F-BB21-82E9CF9C8B87}" srcId="{893F0751-D47E-4BB9-B645-6BEEAFE2C817}" destId="{080216A2-EFD9-4017-85D0-DD531BB8A780}" srcOrd="4" destOrd="0" parTransId="{18F5D4BE-AB2C-4969-ADD3-8D3D8F35CC32}" sibTransId="{EC203338-8153-45EB-B7DA-01C648C1EE18}"/>
    <dgm:cxn modelId="{5E933EC7-1435-4635-9827-9147499EC467}" srcId="{9FB30D70-5F68-4597-8A56-D1A8E64DE511}" destId="{2625232C-CF28-41CD-BCE2-4A7053ED617D}" srcOrd="3" destOrd="0" parTransId="{B42677F7-92DF-4763-B2A6-23399022B84C}" sibTransId="{FCC54A7B-448F-466F-B03A-5F652185F065}"/>
    <dgm:cxn modelId="{03982ACA-27F9-43B8-80ED-1D431D2A4CFF}" type="presOf" srcId="{DC867B4B-A820-42FF-BACF-A0E8628C5955}" destId="{FE6B8099-4A47-40E3-8559-45ABD104E908}" srcOrd="0" destOrd="0" presId="urn:microsoft.com/office/officeart/2005/8/layout/hierarchy3"/>
    <dgm:cxn modelId="{E12015CD-DBF7-4F51-AC7C-A2502BD151B8}" srcId="{03463784-F76F-4DA8-9126-19A615600ABC}" destId="{E8AAAD70-5BDF-440F-8A73-ED43FD473D86}" srcOrd="2" destOrd="0" parTransId="{0398A42D-A088-40AD-B347-7DAAF07E43A4}" sibTransId="{5B2614FF-A06B-492D-8B18-7BAB10AD68BD}"/>
    <dgm:cxn modelId="{0A732CCD-EED6-4ADA-AA9C-DA73AE4C925A}" srcId="{0DFF0C05-9C69-4ED9-94D2-2FDE7282B4B6}" destId="{BF6E8F7F-0754-4CF6-AAE2-8058824C2737}" srcOrd="1" destOrd="0" parTransId="{CF16C300-A674-41F1-8253-A9198B5ACF2E}" sibTransId="{172A02C8-A89C-412C-A65D-A567D1FBE383}"/>
    <dgm:cxn modelId="{0E90A6CD-F849-481D-BEDD-5638A3D53AED}" srcId="{5EB792F6-8149-4598-BF41-27A8C76D4E62}" destId="{CDCCDA22-9AAE-4E96-88F7-DD4A4E8D8CB0}" srcOrd="1" destOrd="0" parTransId="{87FF50F7-B7EC-46DF-A7AD-CA9A53A965FC}" sibTransId="{D4E9B2FD-4509-4BFF-97C4-E468704F8B51}"/>
    <dgm:cxn modelId="{55C021CE-1120-4BEB-84D3-0414B98FED2C}" type="presOf" srcId="{29BDDE00-60A0-4927-88FE-53B31686FD82}" destId="{BCDFBFD8-E2A7-4F02-8C16-8707D887B47C}" srcOrd="0" destOrd="0" presId="urn:microsoft.com/office/officeart/2005/8/layout/hierarchy3"/>
    <dgm:cxn modelId="{CC590ED1-C476-4EDC-804A-6837A953C97A}" type="presOf" srcId="{86C41EAC-5A50-484B-AA3F-D7C380B3245D}" destId="{45F0C578-9E94-4458-B715-C182453DB63B}" srcOrd="0" destOrd="0" presId="urn:microsoft.com/office/officeart/2005/8/layout/hierarchy3"/>
    <dgm:cxn modelId="{63CAF0D3-832B-4F19-80C3-6F1D5F289524}" srcId="{297261F1-B47E-4081-8072-475D81429D3F}" destId="{9E929A1C-7E79-4F59-BF92-1EC752367064}" srcOrd="0" destOrd="0" parTransId="{A50B0178-386D-4B04-97AC-0F1BA17C552B}" sibTransId="{FBFC792B-1CEB-4FBE-A8F6-E0B6286194E5}"/>
    <dgm:cxn modelId="{74ACAAD7-2928-45E7-AE88-0729AD2546B1}" type="presOf" srcId="{080216A2-EFD9-4017-85D0-DD531BB8A780}" destId="{965CA15E-62FB-4179-B46A-579BF35E0EBB}" srcOrd="0" destOrd="0" presId="urn:microsoft.com/office/officeart/2005/8/layout/hierarchy3"/>
    <dgm:cxn modelId="{906863D8-39E6-433F-9C4F-BC10DB2E0889}" srcId="{44AA9650-19D7-470B-908F-5A9769B3401B}" destId="{E22BC852-6AF9-470E-BE5B-26EA51BCBB11}" srcOrd="1" destOrd="0" parTransId="{27115AF9-1271-44FC-8C35-E8F7DF739076}" sibTransId="{AAFBF712-FC91-4A8B-B1F3-8C74A4D59D98}"/>
    <dgm:cxn modelId="{BB8B6FD8-27F3-4B8F-BE58-A3E745DEF55F}" type="presOf" srcId="{ACFC4516-89DA-4AE2-96DA-52B588E5C962}" destId="{F9EC0132-64F1-423F-9C1E-EC1E02508013}" srcOrd="0" destOrd="1" presId="urn:microsoft.com/office/officeart/2005/8/layout/hierarchy3"/>
    <dgm:cxn modelId="{171073DA-463C-4BFF-ABCD-8EF3E28FD85C}" srcId="{F36AE307-C90B-4AB6-A594-E607BC09EF70}" destId="{0DFF0C05-9C69-4ED9-94D2-2FDE7282B4B6}" srcOrd="0" destOrd="0" parTransId="{34BC541A-547D-448E-89A0-7A57401B86DF}" sibTransId="{C05046EC-DA8B-45EB-99AE-1AEA03ACDDC2}"/>
    <dgm:cxn modelId="{F3B9E6DC-4A3C-475F-B2DF-869D8B4E7413}" type="presOf" srcId="{03463784-F76F-4DA8-9126-19A615600ABC}" destId="{A8022D62-A605-4344-BA60-65FA3DF18E0F}" srcOrd="0" destOrd="0" presId="urn:microsoft.com/office/officeart/2005/8/layout/hierarchy3"/>
    <dgm:cxn modelId="{E42CC3E0-1C5D-4A02-A752-B6E7FA3693CE}" srcId="{222D38C2-1955-4DCC-B96C-556179080A76}" destId="{ABBB9EE4-0A81-45DE-8CB2-C11436DAA077}" srcOrd="0" destOrd="0" parTransId="{A0ECDD02-C11B-4A08-9293-E3207BFA19A9}" sibTransId="{246A7579-C681-4BAC-A5F2-9179969C7646}"/>
    <dgm:cxn modelId="{933067E2-2C41-4872-BBCE-806BBA415FA6}" type="presOf" srcId="{080216A2-EFD9-4017-85D0-DD531BB8A780}" destId="{573D7137-9D81-4FA1-BAA3-DF136D77CE35}" srcOrd="1" destOrd="0" presId="urn:microsoft.com/office/officeart/2005/8/layout/hierarchy3"/>
    <dgm:cxn modelId="{1A8109E3-DCBF-4136-A634-575322B50A72}" srcId="{222D38C2-1955-4DCC-B96C-556179080A76}" destId="{EDA613EA-62A5-438B-BECC-F592F0CD08BF}" srcOrd="1" destOrd="0" parTransId="{7A028AE3-65DD-44D5-BCE3-87B46C2DEFB7}" sibTransId="{E7CDAC86-985B-48DC-8A8A-DD41526D27B6}"/>
    <dgm:cxn modelId="{6F61BAE5-EC86-4993-868A-BDCB0795A977}" type="presOf" srcId="{BF6E8F7F-0754-4CF6-AAE2-8058824C2737}" destId="{DEC44420-1736-4D8C-A947-4BCCD5D9D134}" srcOrd="0" destOrd="2" presId="urn:microsoft.com/office/officeart/2005/8/layout/hierarchy3"/>
    <dgm:cxn modelId="{897BA7E6-F4B8-4C08-A11F-1D65DB7A97B9}" srcId="{29BDDE00-60A0-4927-88FE-53B31686FD82}" destId="{F2442C08-3556-4A62-9016-5CF2273C2006}" srcOrd="0" destOrd="0" parTransId="{0FA89687-AF21-4118-9C91-B45961419DD0}" sibTransId="{7572CAD0-DA83-468C-96E7-0AB1C3C3C624}"/>
    <dgm:cxn modelId="{598E1FE7-0A76-4552-B5B1-589251F68D27}" type="presOf" srcId="{EDA613EA-62A5-438B-BECC-F592F0CD08BF}" destId="{E4862357-1B75-49C8-B375-5825B56D3CFB}" srcOrd="0" destOrd="2" presId="urn:microsoft.com/office/officeart/2005/8/layout/hierarchy3"/>
    <dgm:cxn modelId="{46DBA1EE-E4DE-4556-BD48-4CC2D70B8515}" type="presOf" srcId="{5EB792F6-8149-4598-BF41-27A8C76D4E62}" destId="{449115D0-14DF-47B5-AEBD-E09E5F564E47}" srcOrd="0" destOrd="0" presId="urn:microsoft.com/office/officeart/2005/8/layout/hierarchy3"/>
    <dgm:cxn modelId="{391E1FF0-5167-4725-AA5F-7453D59B4EDC}" type="presOf" srcId="{D952E32F-E49D-4E36-980F-AB3070184515}" destId="{BCDFBFD8-E2A7-4F02-8C16-8707D887B47C}" srcOrd="0" destOrd="4" presId="urn:microsoft.com/office/officeart/2005/8/layout/hierarchy3"/>
    <dgm:cxn modelId="{F9E41CF1-B7BB-42B7-889B-F795CF640912}" type="presOf" srcId="{A46583E9-C525-4B80-9CB0-AE41090E0878}" destId="{B53836E7-3FB0-46DA-AFC2-3771AA2A0B7F}" srcOrd="0" destOrd="2" presId="urn:microsoft.com/office/officeart/2005/8/layout/hierarchy3"/>
    <dgm:cxn modelId="{607AF9F2-2CB3-4A61-9C12-E449B3D0E41E}" type="presOf" srcId="{109FB078-1D64-45E2-927C-AD621D0F18E1}" destId="{DEC44420-1736-4D8C-A947-4BCCD5D9D134}" srcOrd="0" destOrd="4" presId="urn:microsoft.com/office/officeart/2005/8/layout/hierarchy3"/>
    <dgm:cxn modelId="{F6530EF3-BFA2-4638-BD80-5EB2C5C47126}" srcId="{57013B7D-D6B4-4F4D-99B9-7C03A52D51FD}" destId="{0300C804-132B-4963-8252-6E02B4F5B108}" srcOrd="0" destOrd="0" parTransId="{BA002FB6-604B-4083-83F8-086C720F2F08}" sibTransId="{597B167D-37E8-4D53-9D18-A6CA6C8189FB}"/>
    <dgm:cxn modelId="{67C107F7-6E99-4502-815F-7D3202F4D294}" srcId="{893F0751-D47E-4BB9-B645-6BEEAFE2C817}" destId="{B8ECFFBD-07BD-4193-8F11-82F35AC636CE}" srcOrd="2" destOrd="0" parTransId="{AC5F1FE9-FE99-4A10-BAD9-B42D7701399D}" sibTransId="{05E9DA59-9F12-494D-BEE3-8238BE691661}"/>
    <dgm:cxn modelId="{91EBD8FB-3D0F-429F-9743-6E6C1827C834}" srcId="{44AA9650-19D7-470B-908F-5A9769B3401B}" destId="{BAFB43B3-5BA5-45A5-8D23-521FE6920C66}" srcOrd="0" destOrd="0" parTransId="{B2A46E3F-45B8-4644-8CF8-EB44DBED1464}" sibTransId="{7BED8A7A-F4E3-4120-A0E1-AF42C3A4B89A}"/>
    <dgm:cxn modelId="{2C76E1FD-AC0A-43F0-B536-7B03D18F53AD}" type="presOf" srcId="{5FC7FCB2-AFBD-4F22-BE6E-7870B17B29DB}" destId="{440E5204-EE43-4489-8F31-6EE4118839F5}" srcOrd="0" destOrd="0" presId="urn:microsoft.com/office/officeart/2005/8/layout/hierarchy3"/>
    <dgm:cxn modelId="{B4D9E7FD-5F80-4601-AD83-3FC77F5C8ADF}" srcId="{57013B7D-D6B4-4F4D-99B9-7C03A52D51FD}" destId="{B4197589-FB93-4EAF-BA08-67ADD7E567B7}" srcOrd="1" destOrd="0" parTransId="{AE174E02-237C-4C8E-8CF2-B09E9A757DC5}" sibTransId="{0C8D6C1B-472D-4FE5-8E95-2D012B05C770}"/>
    <dgm:cxn modelId="{B7701A0A-AAB4-4FDA-81B2-8C468B150CC0}" type="presParOf" srcId="{8055C405-B35C-42DD-A6F2-A3BC17BDFFA2}" destId="{7F2BCE39-FCBC-42C1-BEC2-5B6F3A0649E8}" srcOrd="0" destOrd="0" presId="urn:microsoft.com/office/officeart/2005/8/layout/hierarchy3"/>
    <dgm:cxn modelId="{48660006-7FCB-4C0D-BB7A-1F7856B42F73}" type="presParOf" srcId="{7F2BCE39-FCBC-42C1-BEC2-5B6F3A0649E8}" destId="{8CB42C98-93A3-4FBA-9DF4-9721AC4DB5BE}" srcOrd="0" destOrd="0" presId="urn:microsoft.com/office/officeart/2005/8/layout/hierarchy3"/>
    <dgm:cxn modelId="{F606A5E2-46A5-4587-A5E4-EF000DC8DC95}" type="presParOf" srcId="{8CB42C98-93A3-4FBA-9DF4-9721AC4DB5BE}" destId="{C8B32F1A-73F6-4CFB-898E-1F375A02F0F4}" srcOrd="0" destOrd="0" presId="urn:microsoft.com/office/officeart/2005/8/layout/hierarchy3"/>
    <dgm:cxn modelId="{3578F7A1-F410-404B-BEF6-EB9C64B33077}" type="presParOf" srcId="{8CB42C98-93A3-4FBA-9DF4-9721AC4DB5BE}" destId="{5261EC4F-3933-4FAB-9475-8005C9CAA956}" srcOrd="1" destOrd="0" presId="urn:microsoft.com/office/officeart/2005/8/layout/hierarchy3"/>
    <dgm:cxn modelId="{F2220A13-8C27-478E-B0AF-05AF0B0C47D9}" type="presParOf" srcId="{7F2BCE39-FCBC-42C1-BEC2-5B6F3A0649E8}" destId="{1C61BBCE-4397-4A88-97FE-CE5D2CC5A8A9}" srcOrd="1" destOrd="0" presId="urn:microsoft.com/office/officeart/2005/8/layout/hierarchy3"/>
    <dgm:cxn modelId="{7DEE2A66-7C3B-49A1-AB57-C7D6D7C6B057}" type="presParOf" srcId="{1C61BBCE-4397-4A88-97FE-CE5D2CC5A8A9}" destId="{9AE2C79E-BC68-43E0-BC4E-715CB5FCF97A}" srcOrd="0" destOrd="0" presId="urn:microsoft.com/office/officeart/2005/8/layout/hierarchy3"/>
    <dgm:cxn modelId="{C918A830-9625-44D1-B021-ABF51BBCDC4E}" type="presParOf" srcId="{1C61BBCE-4397-4A88-97FE-CE5D2CC5A8A9}" destId="{17E8B4A8-E390-4378-88F9-519EC8D6B3B2}" srcOrd="1" destOrd="0" presId="urn:microsoft.com/office/officeart/2005/8/layout/hierarchy3"/>
    <dgm:cxn modelId="{1B59414E-2584-4914-BBEA-32AED83DD24D}" type="presParOf" srcId="{1C61BBCE-4397-4A88-97FE-CE5D2CC5A8A9}" destId="{A7FA9AA2-52DA-4463-B75D-11B958130DDE}" srcOrd="2" destOrd="0" presId="urn:microsoft.com/office/officeart/2005/8/layout/hierarchy3"/>
    <dgm:cxn modelId="{59B677D7-D9D3-4DC6-825C-6075B7E22A09}" type="presParOf" srcId="{1C61BBCE-4397-4A88-97FE-CE5D2CC5A8A9}" destId="{449115D0-14DF-47B5-AEBD-E09E5F564E47}" srcOrd="3" destOrd="0" presId="urn:microsoft.com/office/officeart/2005/8/layout/hierarchy3"/>
    <dgm:cxn modelId="{5A783CB8-7589-4175-AA4F-CF3B3F7883C7}" type="presParOf" srcId="{8055C405-B35C-42DD-A6F2-A3BC17BDFFA2}" destId="{DBD8B98C-089C-43A2-8F82-DADF84FC0BF5}" srcOrd="1" destOrd="0" presId="urn:microsoft.com/office/officeart/2005/8/layout/hierarchy3"/>
    <dgm:cxn modelId="{8752C75A-8185-4E77-AFD9-CF839CC157F3}" type="presParOf" srcId="{DBD8B98C-089C-43A2-8F82-DADF84FC0BF5}" destId="{103EA590-D5C8-4A2F-B402-75522693669C}" srcOrd="0" destOrd="0" presId="urn:microsoft.com/office/officeart/2005/8/layout/hierarchy3"/>
    <dgm:cxn modelId="{05B22549-21EF-4126-A93B-3CEEA1E0EB67}" type="presParOf" srcId="{103EA590-D5C8-4A2F-B402-75522693669C}" destId="{FE6B8099-4A47-40E3-8559-45ABD104E908}" srcOrd="0" destOrd="0" presId="urn:microsoft.com/office/officeart/2005/8/layout/hierarchy3"/>
    <dgm:cxn modelId="{9B62C6A4-1674-4932-9E0A-C22B41BD22FC}" type="presParOf" srcId="{103EA590-D5C8-4A2F-B402-75522693669C}" destId="{3214E0C3-0C43-4222-8D1A-58631F415EE6}" srcOrd="1" destOrd="0" presId="urn:microsoft.com/office/officeart/2005/8/layout/hierarchy3"/>
    <dgm:cxn modelId="{6CBCAE61-A27B-4A9F-9E25-23C1F5ED9228}" type="presParOf" srcId="{DBD8B98C-089C-43A2-8F82-DADF84FC0BF5}" destId="{B370E7C7-E0EA-467A-B960-0E30D4503EE3}" srcOrd="1" destOrd="0" presId="urn:microsoft.com/office/officeart/2005/8/layout/hierarchy3"/>
    <dgm:cxn modelId="{94C6CE33-C173-4BC7-B413-0DE502BD1E26}" type="presParOf" srcId="{B370E7C7-E0EA-467A-B960-0E30D4503EE3}" destId="{6994500D-BDC7-4786-B3D5-FE7E95D025D2}" srcOrd="0" destOrd="0" presId="urn:microsoft.com/office/officeart/2005/8/layout/hierarchy3"/>
    <dgm:cxn modelId="{79087266-5B31-4341-804D-1BA1784F7DFB}" type="presParOf" srcId="{B370E7C7-E0EA-467A-B960-0E30D4503EE3}" destId="{B3D54134-D905-479E-85DE-EC84232694C6}" srcOrd="1" destOrd="0" presId="urn:microsoft.com/office/officeart/2005/8/layout/hierarchy3"/>
    <dgm:cxn modelId="{5E993172-F597-45B1-8F1F-20BD11EDB8AD}" type="presParOf" srcId="{B370E7C7-E0EA-467A-B960-0E30D4503EE3}" destId="{2CFF75CE-C3C6-463D-BDCB-66D43867374C}" srcOrd="2" destOrd="0" presId="urn:microsoft.com/office/officeart/2005/8/layout/hierarchy3"/>
    <dgm:cxn modelId="{74F54034-6391-4350-8BDF-D663C3CE85E2}" type="presParOf" srcId="{B370E7C7-E0EA-467A-B960-0E30D4503EE3}" destId="{E4862357-1B75-49C8-B375-5825B56D3CFB}" srcOrd="3" destOrd="0" presId="urn:microsoft.com/office/officeart/2005/8/layout/hierarchy3"/>
    <dgm:cxn modelId="{CD9801A1-E024-4825-A3D2-AB5427C5D6EE}" type="presParOf" srcId="{8055C405-B35C-42DD-A6F2-A3BC17BDFFA2}" destId="{F6A44199-9779-421F-9C9C-0B5235464190}" srcOrd="2" destOrd="0" presId="urn:microsoft.com/office/officeart/2005/8/layout/hierarchy3"/>
    <dgm:cxn modelId="{2BE36295-F7F9-40B3-A604-E29556F6CE97}" type="presParOf" srcId="{F6A44199-9779-421F-9C9C-0B5235464190}" destId="{0D8164E1-1BC7-4A2F-965E-60E66B52D6FE}" srcOrd="0" destOrd="0" presId="urn:microsoft.com/office/officeart/2005/8/layout/hierarchy3"/>
    <dgm:cxn modelId="{35E24002-B8A3-4AAE-A0EE-D1F272A5F7B7}" type="presParOf" srcId="{0D8164E1-1BC7-4A2F-965E-60E66B52D6FE}" destId="{76B1507D-EFE9-4062-951E-2DFE45BFB9AC}" srcOrd="0" destOrd="0" presId="urn:microsoft.com/office/officeart/2005/8/layout/hierarchy3"/>
    <dgm:cxn modelId="{E025F77A-7BA5-4805-B842-04A164EEEE37}" type="presParOf" srcId="{0D8164E1-1BC7-4A2F-965E-60E66B52D6FE}" destId="{8C22C424-8443-44A7-86E5-C24BEE7BF0CA}" srcOrd="1" destOrd="0" presId="urn:microsoft.com/office/officeart/2005/8/layout/hierarchy3"/>
    <dgm:cxn modelId="{FD97FC72-7580-4063-BB62-C3C4059B9720}" type="presParOf" srcId="{F6A44199-9779-421F-9C9C-0B5235464190}" destId="{EEB48926-A5DA-42E8-9826-A956F4E0FB0A}" srcOrd="1" destOrd="0" presId="urn:microsoft.com/office/officeart/2005/8/layout/hierarchy3"/>
    <dgm:cxn modelId="{733F031C-6610-456B-957A-6C1520D77F70}" type="presParOf" srcId="{EEB48926-A5DA-42E8-9826-A956F4E0FB0A}" destId="{33CA7DCE-096A-4947-8AA9-FA531401B7B7}" srcOrd="0" destOrd="0" presId="urn:microsoft.com/office/officeart/2005/8/layout/hierarchy3"/>
    <dgm:cxn modelId="{2FB1BF69-2C9D-46C9-9AAA-177C96E0AF9C}" type="presParOf" srcId="{EEB48926-A5DA-42E8-9826-A956F4E0FB0A}" destId="{BCDFBFD8-E2A7-4F02-8C16-8707D887B47C}" srcOrd="1" destOrd="0" presId="urn:microsoft.com/office/officeart/2005/8/layout/hierarchy3"/>
    <dgm:cxn modelId="{CCDB301A-AF6D-4F1E-A5E5-F2B3AE7F8CC9}" type="presParOf" srcId="{EEB48926-A5DA-42E8-9826-A956F4E0FB0A}" destId="{234CAFC8-4202-4E1F-852E-D3EEC6C4809C}" srcOrd="2" destOrd="0" presId="urn:microsoft.com/office/officeart/2005/8/layout/hierarchy3"/>
    <dgm:cxn modelId="{8CB8DD3F-AD1A-455C-8269-B4FDD0699723}" type="presParOf" srcId="{EEB48926-A5DA-42E8-9826-A956F4E0FB0A}" destId="{246F6227-BDA5-45E4-AC46-BCC4A68282B7}" srcOrd="3" destOrd="0" presId="urn:microsoft.com/office/officeart/2005/8/layout/hierarchy3"/>
    <dgm:cxn modelId="{975C96DD-1D36-4274-90A0-334B3173A753}" type="presParOf" srcId="{EEB48926-A5DA-42E8-9826-A956F4E0FB0A}" destId="{9E3FBBAC-94E7-4B65-AF4B-E872E3FF67DF}" srcOrd="4" destOrd="0" presId="urn:microsoft.com/office/officeart/2005/8/layout/hierarchy3"/>
    <dgm:cxn modelId="{BB9779D5-A866-43E1-9013-38D0720ABAFA}" type="presParOf" srcId="{EEB48926-A5DA-42E8-9826-A956F4E0FB0A}" destId="{C7A11A55-1569-46E4-B948-373D5F38B2C7}" srcOrd="5" destOrd="0" presId="urn:microsoft.com/office/officeart/2005/8/layout/hierarchy3"/>
    <dgm:cxn modelId="{E6DCA46F-F304-4790-95BE-BD09A2A5BA52}" type="presParOf" srcId="{EEB48926-A5DA-42E8-9826-A956F4E0FB0A}" destId="{45F0C578-9E94-4458-B715-C182453DB63B}" srcOrd="6" destOrd="0" presId="urn:microsoft.com/office/officeart/2005/8/layout/hierarchy3"/>
    <dgm:cxn modelId="{F29AB4E9-14C3-4403-8D73-2229022B7A9E}" type="presParOf" srcId="{EEB48926-A5DA-42E8-9826-A956F4E0FB0A}" destId="{A8022D62-A605-4344-BA60-65FA3DF18E0F}" srcOrd="7" destOrd="0" presId="urn:microsoft.com/office/officeart/2005/8/layout/hierarchy3"/>
    <dgm:cxn modelId="{4B5D3E42-1687-421D-8BC3-1F7ACD50F838}" type="presParOf" srcId="{8055C405-B35C-42DD-A6F2-A3BC17BDFFA2}" destId="{4581664E-C40F-4963-9889-F726ACBCD62B}" srcOrd="3" destOrd="0" presId="urn:microsoft.com/office/officeart/2005/8/layout/hierarchy3"/>
    <dgm:cxn modelId="{28AC2D32-EF7D-4B21-8820-690B00B33770}" type="presParOf" srcId="{4581664E-C40F-4963-9889-F726ACBCD62B}" destId="{A003C58D-623D-4E15-858E-C996FB0C695C}" srcOrd="0" destOrd="0" presId="urn:microsoft.com/office/officeart/2005/8/layout/hierarchy3"/>
    <dgm:cxn modelId="{8653FEC9-432A-444C-80C7-C3FBC6319F0F}" type="presParOf" srcId="{A003C58D-623D-4E15-858E-C996FB0C695C}" destId="{B2E6FE4C-3F7B-4F5B-9BC5-BDD10AA7FFA8}" srcOrd="0" destOrd="0" presId="urn:microsoft.com/office/officeart/2005/8/layout/hierarchy3"/>
    <dgm:cxn modelId="{F55FE785-A1FA-4FEF-8E33-DB0B2CF325CF}" type="presParOf" srcId="{A003C58D-623D-4E15-858E-C996FB0C695C}" destId="{D3029FBD-B1A5-45FC-A376-F1B66570AE50}" srcOrd="1" destOrd="0" presId="urn:microsoft.com/office/officeart/2005/8/layout/hierarchy3"/>
    <dgm:cxn modelId="{8EEECC2D-BEC6-468E-B899-9660DB916AB6}" type="presParOf" srcId="{4581664E-C40F-4963-9889-F726ACBCD62B}" destId="{26AEE05E-5524-413F-BB5A-7B89ECD878C8}" srcOrd="1" destOrd="0" presId="urn:microsoft.com/office/officeart/2005/8/layout/hierarchy3"/>
    <dgm:cxn modelId="{E0D3E5C0-F2BC-453A-BA98-6F88C56C9F04}" type="presParOf" srcId="{26AEE05E-5524-413F-BB5A-7B89ECD878C8}" destId="{2247C5F2-0CBB-4EFA-82D1-2DEFA9957229}" srcOrd="0" destOrd="0" presId="urn:microsoft.com/office/officeart/2005/8/layout/hierarchy3"/>
    <dgm:cxn modelId="{FE74CE0D-C493-4A17-9B8A-C7EA5E81A90E}" type="presParOf" srcId="{26AEE05E-5524-413F-BB5A-7B89ECD878C8}" destId="{DEC44420-1736-4D8C-A947-4BCCD5D9D134}" srcOrd="1" destOrd="0" presId="urn:microsoft.com/office/officeart/2005/8/layout/hierarchy3"/>
    <dgm:cxn modelId="{87284E29-E1BF-4468-9F6C-E73861055264}" type="presParOf" srcId="{26AEE05E-5524-413F-BB5A-7B89ECD878C8}" destId="{00F92ED2-8383-4C75-934C-DD3E3B3E92E2}" srcOrd="2" destOrd="0" presId="urn:microsoft.com/office/officeart/2005/8/layout/hierarchy3"/>
    <dgm:cxn modelId="{A40ADB4F-0286-42E3-A2C7-45D2D1F36D90}" type="presParOf" srcId="{26AEE05E-5524-413F-BB5A-7B89ECD878C8}" destId="{B53836E7-3FB0-46DA-AFC2-3771AA2A0B7F}" srcOrd="3" destOrd="0" presId="urn:microsoft.com/office/officeart/2005/8/layout/hierarchy3"/>
    <dgm:cxn modelId="{23C0CC79-118F-4748-B117-F429122398A8}" type="presParOf" srcId="{8055C405-B35C-42DD-A6F2-A3BC17BDFFA2}" destId="{747108F3-764B-4428-B57B-64CA8E95A763}" srcOrd="4" destOrd="0" presId="urn:microsoft.com/office/officeart/2005/8/layout/hierarchy3"/>
    <dgm:cxn modelId="{B0BFFD0A-18CF-4BD2-8BCE-C604AB695E4E}" type="presParOf" srcId="{747108F3-764B-4428-B57B-64CA8E95A763}" destId="{3A037DEB-EDDE-4DC9-BB12-57C9C4DCB426}" srcOrd="0" destOrd="0" presId="urn:microsoft.com/office/officeart/2005/8/layout/hierarchy3"/>
    <dgm:cxn modelId="{244D9E58-9A08-4559-8852-55CD4C032E18}" type="presParOf" srcId="{3A037DEB-EDDE-4DC9-BB12-57C9C4DCB426}" destId="{965CA15E-62FB-4179-B46A-579BF35E0EBB}" srcOrd="0" destOrd="0" presId="urn:microsoft.com/office/officeart/2005/8/layout/hierarchy3"/>
    <dgm:cxn modelId="{825C90AE-0148-44A6-8FE1-B5C23B00ACBC}" type="presParOf" srcId="{3A037DEB-EDDE-4DC9-BB12-57C9C4DCB426}" destId="{573D7137-9D81-4FA1-BAA3-DF136D77CE35}" srcOrd="1" destOrd="0" presId="urn:microsoft.com/office/officeart/2005/8/layout/hierarchy3"/>
    <dgm:cxn modelId="{D4F52148-F867-48BA-BE64-F6DFEC85DD13}" type="presParOf" srcId="{747108F3-764B-4428-B57B-64CA8E95A763}" destId="{86AA9F94-6726-4DCE-8B94-AACAF2BB7287}" srcOrd="1" destOrd="0" presId="urn:microsoft.com/office/officeart/2005/8/layout/hierarchy3"/>
    <dgm:cxn modelId="{55C76E89-3E3B-4AA8-B6EA-F6C5F0005814}" type="presParOf" srcId="{86AA9F94-6726-4DCE-8B94-AACAF2BB7287}" destId="{B8AD6272-8DDB-4B30-97DF-AC2AE814334E}" srcOrd="0" destOrd="0" presId="urn:microsoft.com/office/officeart/2005/8/layout/hierarchy3"/>
    <dgm:cxn modelId="{69C7F5F2-683E-4224-8984-6E951531AE11}" type="presParOf" srcId="{86AA9F94-6726-4DCE-8B94-AACAF2BB7287}" destId="{BEA6F7D1-713E-4973-AC32-EC1DC3C18412}" srcOrd="1" destOrd="0" presId="urn:microsoft.com/office/officeart/2005/8/layout/hierarchy3"/>
    <dgm:cxn modelId="{930B94BE-9E6B-493A-B3E8-2DAD4B05521F}" type="presParOf" srcId="{86AA9F94-6726-4DCE-8B94-AACAF2BB7287}" destId="{440E5204-EE43-4489-8F31-6EE4118839F5}" srcOrd="2" destOrd="0" presId="urn:microsoft.com/office/officeart/2005/8/layout/hierarchy3"/>
    <dgm:cxn modelId="{FC322003-C745-44E8-B6A7-3EF84C52088B}" type="presParOf" srcId="{86AA9F94-6726-4DCE-8B94-AACAF2BB7287}" destId="{F9EC0132-64F1-423F-9C1E-EC1E02508013}" srcOrd="3" destOrd="0" presId="urn:microsoft.com/office/officeart/2005/8/layout/hierarchy3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8B32F1A-73F6-4CFB-898E-1F375A02F0F4}">
      <dsp:nvSpPr>
        <dsp:cNvPr id="0" name=""/>
        <dsp:cNvSpPr/>
      </dsp:nvSpPr>
      <dsp:spPr>
        <a:xfrm>
          <a:off x="84027" y="9681"/>
          <a:ext cx="1226626" cy="613313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i-FI" sz="1000" kern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Developing leadership growth through onboarding</a:t>
          </a:r>
        </a:p>
      </dsp:txBody>
      <dsp:txXfrm>
        <a:off x="101990" y="27644"/>
        <a:ext cx="1190700" cy="577387"/>
      </dsp:txXfrm>
    </dsp:sp>
    <dsp:sp modelId="{9AE2C79E-BC68-43E0-BC4E-715CB5FCF97A}">
      <dsp:nvSpPr>
        <dsp:cNvPr id="0" name=""/>
        <dsp:cNvSpPr/>
      </dsp:nvSpPr>
      <dsp:spPr>
        <a:xfrm>
          <a:off x="206690" y="622994"/>
          <a:ext cx="113835" cy="89700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97007"/>
              </a:lnTo>
              <a:lnTo>
                <a:pt x="113835" y="897007"/>
              </a:lnTo>
            </a:path>
          </a:pathLst>
        </a:cu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7E8B4A8-E390-4378-88F9-519EC8D6B3B2}">
      <dsp:nvSpPr>
        <dsp:cNvPr id="0" name=""/>
        <dsp:cNvSpPr/>
      </dsp:nvSpPr>
      <dsp:spPr>
        <a:xfrm>
          <a:off x="320525" y="721964"/>
          <a:ext cx="1458046" cy="1596074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Increasing motivation for the manager position with onboarding </a:t>
          </a: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Increasing attraction to the position with onboarding</a:t>
          </a: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Increasing the commitment of the front-line nurse manager to their work through onboarding</a:t>
          </a:r>
        </a:p>
      </dsp:txBody>
      <dsp:txXfrm>
        <a:off x="363230" y="764669"/>
        <a:ext cx="1372636" cy="1510664"/>
      </dsp:txXfrm>
    </dsp:sp>
    <dsp:sp modelId="{A7FA9AA2-52DA-4463-B75D-11B958130DDE}">
      <dsp:nvSpPr>
        <dsp:cNvPr id="0" name=""/>
        <dsp:cNvSpPr/>
      </dsp:nvSpPr>
      <dsp:spPr>
        <a:xfrm>
          <a:off x="206690" y="622994"/>
          <a:ext cx="132686" cy="245087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450879"/>
              </a:lnTo>
              <a:lnTo>
                <a:pt x="132686" y="2450879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49115D0-14DF-47B5-AEBD-E09E5F564E47}">
      <dsp:nvSpPr>
        <dsp:cNvPr id="0" name=""/>
        <dsp:cNvSpPr/>
      </dsp:nvSpPr>
      <dsp:spPr>
        <a:xfrm>
          <a:off x="339376" y="2389342"/>
          <a:ext cx="1498731" cy="1369062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Developing attachment to the role of manager 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Growing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into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anagerial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rol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during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learly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highlighting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job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description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and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responsibilitie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of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anager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79474" y="2429440"/>
        <a:ext cx="1418535" cy="1288866"/>
      </dsp:txXfrm>
    </dsp:sp>
    <dsp:sp modelId="{FE6B8099-4A47-40E3-8559-45ABD104E908}">
      <dsp:nvSpPr>
        <dsp:cNvPr id="0" name=""/>
        <dsp:cNvSpPr/>
      </dsp:nvSpPr>
      <dsp:spPr>
        <a:xfrm>
          <a:off x="2085516" y="10674"/>
          <a:ext cx="1226626" cy="613313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i-FI" sz="1000" kern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larifying leadership foundations in onboarding</a:t>
          </a:r>
        </a:p>
      </dsp:txBody>
      <dsp:txXfrm>
        <a:off x="2103479" y="28637"/>
        <a:ext cx="1190700" cy="577387"/>
      </dsp:txXfrm>
    </dsp:sp>
    <dsp:sp modelId="{6994500D-BDC7-4786-B3D5-FE7E95D025D2}">
      <dsp:nvSpPr>
        <dsp:cNvPr id="0" name=""/>
        <dsp:cNvSpPr/>
      </dsp:nvSpPr>
      <dsp:spPr>
        <a:xfrm>
          <a:off x="2208178" y="623988"/>
          <a:ext cx="148880" cy="97373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973732"/>
              </a:lnTo>
              <a:lnTo>
                <a:pt x="148880" y="973732"/>
              </a:lnTo>
            </a:path>
          </a:pathLst>
        </a:cu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3D54134-D905-479E-85DE-EC84232694C6}">
      <dsp:nvSpPr>
        <dsp:cNvPr id="0" name=""/>
        <dsp:cNvSpPr/>
      </dsp:nvSpPr>
      <dsp:spPr>
        <a:xfrm>
          <a:off x="2357059" y="724111"/>
          <a:ext cx="1464562" cy="1747218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Thorough overview of required managerial and leadership qualities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Building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mpetenc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related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to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managerial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work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Ensur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ompetenc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in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h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ervic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chain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management</a:t>
          </a: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elf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-management and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leadership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kill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as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art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of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sp:txBody>
      <dsp:txXfrm>
        <a:off x="2399955" y="767007"/>
        <a:ext cx="1378770" cy="1661426"/>
      </dsp:txXfrm>
    </dsp:sp>
    <dsp:sp modelId="{2CFF75CE-C3C6-463D-BDCB-66D43867374C}">
      <dsp:nvSpPr>
        <dsp:cNvPr id="0" name=""/>
        <dsp:cNvSpPr/>
      </dsp:nvSpPr>
      <dsp:spPr>
        <a:xfrm>
          <a:off x="2208178" y="623988"/>
          <a:ext cx="181371" cy="274411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744110"/>
              </a:lnTo>
              <a:lnTo>
                <a:pt x="181371" y="2744110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4862357-1B75-49C8-B375-5825B56D3CFB}">
      <dsp:nvSpPr>
        <dsp:cNvPr id="0" name=""/>
        <dsp:cNvSpPr/>
      </dsp:nvSpPr>
      <dsp:spPr>
        <a:xfrm>
          <a:off x="2389550" y="2542671"/>
          <a:ext cx="1471922" cy="1650855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Highlighting theoretical and practical aspects of management work in onboarding 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Includ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management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ractice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and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heorie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in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Orientation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on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human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resource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management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ractice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dur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sp:txBody>
      <dsp:txXfrm>
        <a:off x="2432661" y="2585782"/>
        <a:ext cx="1385700" cy="1564633"/>
      </dsp:txXfrm>
    </dsp:sp>
    <dsp:sp modelId="{76B1507D-EFE9-4062-951E-2DFE45BFB9AC}">
      <dsp:nvSpPr>
        <dsp:cNvPr id="0" name=""/>
        <dsp:cNvSpPr/>
      </dsp:nvSpPr>
      <dsp:spPr>
        <a:xfrm>
          <a:off x="4044445" y="27265"/>
          <a:ext cx="1226626" cy="613313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marL="0" lvl="0" indent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i-FI" sz="1000" kern="1200" dirty="0">
              <a:solidFill>
                <a:schemeClr val="tx1"/>
              </a:solidFill>
              <a:latin typeface="Times New Roman"/>
              <a:cs typeface="Times New Roman"/>
            </a:rPr>
            <a:t>Designing a high-standard  and up-to-</a:t>
          </a:r>
          <a:r>
            <a:rPr lang="fi-FI" sz="1000" kern="1200" dirty="0" err="1">
              <a:solidFill>
                <a:schemeClr val="tx1"/>
              </a:solidFill>
              <a:latin typeface="Times New Roman"/>
              <a:cs typeface="Times New Roman"/>
            </a:rPr>
            <a:t>date</a:t>
          </a:r>
          <a:r>
            <a:rPr lang="fi-FI" sz="1000" kern="1200" dirty="0">
              <a:solidFill>
                <a:schemeClr val="tx1"/>
              </a:solidFill>
              <a:latin typeface="Times New Roman"/>
              <a:cs typeface="Times New Roman"/>
            </a:rPr>
            <a:t> onboarding process</a:t>
          </a:r>
        </a:p>
      </dsp:txBody>
      <dsp:txXfrm>
        <a:off x="4062408" y="45228"/>
        <a:ext cx="1190700" cy="577387"/>
      </dsp:txXfrm>
    </dsp:sp>
    <dsp:sp modelId="{33CA7DCE-096A-4947-8AA9-FA531401B7B7}">
      <dsp:nvSpPr>
        <dsp:cNvPr id="0" name=""/>
        <dsp:cNvSpPr/>
      </dsp:nvSpPr>
      <dsp:spPr>
        <a:xfrm>
          <a:off x="4167108" y="640578"/>
          <a:ext cx="100544" cy="97655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976557"/>
              </a:lnTo>
              <a:lnTo>
                <a:pt x="100544" y="976557"/>
              </a:lnTo>
            </a:path>
          </a:pathLst>
        </a:cu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CDFBFD8-E2A7-4F02-8C16-8707D887B47C}">
      <dsp:nvSpPr>
        <dsp:cNvPr id="0" name=""/>
        <dsp:cNvSpPr/>
      </dsp:nvSpPr>
      <dsp:spPr>
        <a:xfrm>
          <a:off x="4267652" y="722921"/>
          <a:ext cx="1623611" cy="1788427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Constructing technology-enhanced onboarding 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ientation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on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echnological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ystem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hallenge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relating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to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echnological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ool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during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lear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digital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ientation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aterial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to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upport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Using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functional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ool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and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environment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in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315206" y="770475"/>
        <a:ext cx="1528503" cy="1693319"/>
      </dsp:txXfrm>
    </dsp:sp>
    <dsp:sp modelId="{234CAFC8-4202-4E1F-852E-D3EEC6C4809C}">
      <dsp:nvSpPr>
        <dsp:cNvPr id="0" name=""/>
        <dsp:cNvSpPr/>
      </dsp:nvSpPr>
      <dsp:spPr>
        <a:xfrm>
          <a:off x="4167108" y="640578"/>
          <a:ext cx="102212" cy="25277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527767"/>
              </a:lnTo>
              <a:lnTo>
                <a:pt x="102212" y="2527767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46F6227-BDA5-45E4-AC46-BCC4A68282B7}">
      <dsp:nvSpPr>
        <dsp:cNvPr id="0" name=""/>
        <dsp:cNvSpPr/>
      </dsp:nvSpPr>
      <dsp:spPr>
        <a:xfrm>
          <a:off x="4269320" y="2570730"/>
          <a:ext cx="1598392" cy="1195230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Designing structured and well-planned content for onboarding 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Using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up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to-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dat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ientation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aterial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upport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tructurality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of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304327" y="2605737"/>
        <a:ext cx="1528378" cy="1125216"/>
      </dsp:txXfrm>
    </dsp:sp>
    <dsp:sp modelId="{9E3FBBAC-94E7-4B65-AF4B-E872E3FF67DF}">
      <dsp:nvSpPr>
        <dsp:cNvPr id="0" name=""/>
        <dsp:cNvSpPr/>
      </dsp:nvSpPr>
      <dsp:spPr>
        <a:xfrm>
          <a:off x="4167108" y="640578"/>
          <a:ext cx="106775" cy="379409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794090"/>
              </a:lnTo>
              <a:lnTo>
                <a:pt x="106775" y="3794090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7A11A55-1569-46E4-B948-373D5F38B2C7}">
      <dsp:nvSpPr>
        <dsp:cNvPr id="0" name=""/>
        <dsp:cNvSpPr/>
      </dsp:nvSpPr>
      <dsp:spPr>
        <a:xfrm>
          <a:off x="4273883" y="3867783"/>
          <a:ext cx="1613808" cy="1133770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Individually tailoring 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  <a:p>
          <a:pPr marL="0" lvl="0" indent="0" algn="l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Arial" panose="020B0604020202020204" pitchFamily="34" charset="0"/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Proactivity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from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th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new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manager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in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adequat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om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  <a:p>
          <a:pPr marL="0" lvl="0" indent="0" algn="l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Arial" panose="020B0604020202020204" pitchFamily="34" charset="0"/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Customis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onboard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to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th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need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of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th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individual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</dsp:txBody>
      <dsp:txXfrm>
        <a:off x="4307090" y="3900990"/>
        <a:ext cx="1547394" cy="1067356"/>
      </dsp:txXfrm>
    </dsp:sp>
    <dsp:sp modelId="{45F0C578-9E94-4458-B715-C182453DB63B}">
      <dsp:nvSpPr>
        <dsp:cNvPr id="0" name=""/>
        <dsp:cNvSpPr/>
      </dsp:nvSpPr>
      <dsp:spPr>
        <a:xfrm>
          <a:off x="4167108" y="640578"/>
          <a:ext cx="115302" cy="508511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085114"/>
              </a:lnTo>
              <a:lnTo>
                <a:pt x="115302" y="508511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8022D62-A605-4344-BA60-65FA3DF18E0F}">
      <dsp:nvSpPr>
        <dsp:cNvPr id="0" name=""/>
        <dsp:cNvSpPr/>
      </dsp:nvSpPr>
      <dsp:spPr>
        <a:xfrm>
          <a:off x="4282411" y="5094826"/>
          <a:ext cx="1660538" cy="1261732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Investing proper resources for onboarding 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Allocat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adequat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tim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for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Appoint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a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support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person to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coordinate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Involving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specialists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in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interdiciplinary</a:t>
          </a:r>
          <a:r>
            <a:rPr lang="fi-FI" sz="1000" kern="1200" dirty="0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 </a:t>
          </a:r>
          <a:r>
            <a:rPr lang="fi-FI" sz="1000" kern="1200" dirty="0" err="1">
              <a:solidFill>
                <a:prstClr val="black">
                  <a:hueOff val="0"/>
                  <a:satOff val="0"/>
                  <a:lumOff val="0"/>
                  <a:alphaOff val="0"/>
                </a:prstClr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+mn-cs"/>
            </a:rPr>
            <a:t>onboarding</a:t>
          </a:r>
          <a:endParaRPr lang="fi-FI" sz="1000" kern="1200" dirty="0">
            <a:solidFill>
              <a:prstClr val="black">
                <a:hueOff val="0"/>
                <a:satOff val="0"/>
                <a:lumOff val="0"/>
                <a:alphaOff val="0"/>
              </a:prstClr>
            </a:solidFill>
            <a:effectLst/>
            <a:latin typeface="Times New Roman" panose="02020603050405020304" pitchFamily="18" charset="0"/>
            <a:ea typeface="Times New Roman" panose="02020603050405020304" pitchFamily="18" charset="0"/>
            <a:cs typeface="+mn-cs"/>
          </a:endParaRPr>
        </a:p>
      </dsp:txBody>
      <dsp:txXfrm>
        <a:off x="4319366" y="5131781"/>
        <a:ext cx="1586628" cy="1187822"/>
      </dsp:txXfrm>
    </dsp:sp>
    <dsp:sp modelId="{B2E6FE4C-3F7B-4F5B-9BC5-BDD10AA7FFA8}">
      <dsp:nvSpPr>
        <dsp:cNvPr id="0" name=""/>
        <dsp:cNvSpPr/>
      </dsp:nvSpPr>
      <dsp:spPr>
        <a:xfrm>
          <a:off x="6204976" y="42916"/>
          <a:ext cx="1226626" cy="613313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marL="0" lvl="0" indent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fi-FI" sz="1000" kern="1200" dirty="0">
              <a:solidFill>
                <a:schemeClr val="tx1"/>
              </a:solidFill>
              <a:latin typeface="Times New Roman"/>
              <a:cs typeface="Times New Roman"/>
            </a:rPr>
            <a:t>Ensuring well-rounded onboarding support</a:t>
          </a:r>
          <a:endParaRPr lang="fi-FI" sz="1000" kern="1200" dirty="0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6222939" y="60879"/>
        <a:ext cx="1190700" cy="577387"/>
      </dsp:txXfrm>
    </dsp:sp>
    <dsp:sp modelId="{2247C5F2-0CBB-4EFA-82D1-2DEFA9957229}">
      <dsp:nvSpPr>
        <dsp:cNvPr id="0" name=""/>
        <dsp:cNvSpPr/>
      </dsp:nvSpPr>
      <dsp:spPr>
        <a:xfrm>
          <a:off x="6327639" y="656230"/>
          <a:ext cx="124585" cy="153625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536254"/>
              </a:lnTo>
              <a:lnTo>
                <a:pt x="124585" y="1536254"/>
              </a:lnTo>
            </a:path>
          </a:pathLst>
        </a:cu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EC44420-1736-4D8C-A947-4BCCD5D9D134}">
      <dsp:nvSpPr>
        <dsp:cNvPr id="0" name=""/>
        <dsp:cNvSpPr/>
      </dsp:nvSpPr>
      <dsp:spPr>
        <a:xfrm>
          <a:off x="6452225" y="731440"/>
          <a:ext cx="1451481" cy="2922087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Receiving support from the work community </a:t>
          </a:r>
          <a:endParaRPr lang="fi-FI" sz="1000" kern="1200" dirty="0">
            <a:latin typeface="Times New Roman"/>
            <a:cs typeface="Times New Roman"/>
          </a:endParaRP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/>
              <a:cs typeface="Times New Roman"/>
            </a:rPr>
            <a:t>Getting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versitile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assistance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from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collegues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during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onboarding</a:t>
          </a:r>
          <a:endParaRPr lang="fi-FI" sz="1000" kern="1200" dirty="0">
            <a:latin typeface="Times New Roman"/>
            <a:cs typeface="Times New Roman"/>
          </a:endParaRP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/>
              <a:cs typeface="Times New Roman"/>
            </a:rPr>
            <a:t>Obtaining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interactional</a:t>
          </a:r>
          <a:r>
            <a:rPr lang="fi-FI" sz="1000" kern="1200" dirty="0">
              <a:latin typeface="Times New Roman"/>
              <a:cs typeface="Times New Roman"/>
            </a:rPr>
            <a:t> help </a:t>
          </a:r>
          <a:r>
            <a:rPr lang="fi-FI" sz="1000" kern="1200" dirty="0" err="1">
              <a:latin typeface="Times New Roman"/>
              <a:cs typeface="Times New Roman"/>
            </a:rPr>
            <a:t>from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staff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during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onboarding</a:t>
          </a:r>
          <a:endParaRPr lang="fi-FI" sz="1000" kern="1200" dirty="0">
            <a:latin typeface="Times New Roman"/>
            <a:cs typeface="Times New Roman"/>
          </a:endParaRP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/>
              <a:cs typeface="Times New Roman"/>
            </a:rPr>
            <a:t>Lack</a:t>
          </a:r>
          <a:r>
            <a:rPr lang="fi-FI" sz="1000" kern="1200" dirty="0">
              <a:latin typeface="Times New Roman"/>
              <a:cs typeface="Times New Roman"/>
            </a:rPr>
            <a:t> of </a:t>
          </a:r>
          <a:r>
            <a:rPr lang="fi-FI" sz="1000" kern="1200" dirty="0" err="1">
              <a:latin typeface="Times New Roman"/>
              <a:cs typeface="Times New Roman"/>
            </a:rPr>
            <a:t>community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support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during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onboarding</a:t>
          </a:r>
          <a:endParaRPr lang="fi-FI" sz="1000" kern="1200" dirty="0">
            <a:latin typeface="Times New Roman"/>
            <a:cs typeface="Times New Roman"/>
          </a:endParaRP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/>
              <a:cs typeface="Times New Roman"/>
            </a:rPr>
            <a:t>Including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regular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guidance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from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one’s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supervisor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during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onboarding</a:t>
          </a:r>
          <a:endParaRPr lang="fi-FI" sz="1000" kern="1200" dirty="0">
            <a:latin typeface="Times New Roman"/>
            <a:cs typeface="Times New Roman"/>
          </a:endParaRP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>
              <a:latin typeface="Times New Roman"/>
              <a:cs typeface="Times New Roman"/>
            </a:rPr>
            <a:t>Using </a:t>
          </a:r>
          <a:r>
            <a:rPr lang="fi-FI" sz="1000" kern="1200" dirty="0" err="1">
              <a:latin typeface="Times New Roman"/>
              <a:cs typeface="Times New Roman"/>
            </a:rPr>
            <a:t>mentoring</a:t>
          </a:r>
          <a:r>
            <a:rPr lang="fi-FI" sz="1000" kern="1200" dirty="0">
              <a:latin typeface="Times New Roman"/>
              <a:cs typeface="Times New Roman"/>
            </a:rPr>
            <a:t> as an </a:t>
          </a:r>
          <a:r>
            <a:rPr lang="fi-FI" sz="1000" kern="1200" dirty="0" err="1">
              <a:latin typeface="Times New Roman"/>
              <a:cs typeface="Times New Roman"/>
            </a:rPr>
            <a:t>effective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method</a:t>
          </a:r>
          <a:r>
            <a:rPr lang="fi-FI" sz="1000" kern="1200" dirty="0">
              <a:latin typeface="Times New Roman"/>
              <a:cs typeface="Times New Roman"/>
            </a:rPr>
            <a:t> of </a:t>
          </a:r>
          <a:r>
            <a:rPr lang="fi-FI" sz="1000" kern="1200" dirty="0" err="1">
              <a:latin typeface="Times New Roman"/>
              <a:cs typeface="Times New Roman"/>
            </a:rPr>
            <a:t>supporting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the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onboarding</a:t>
          </a:r>
          <a:r>
            <a:rPr lang="fi-FI" sz="1000" kern="1200" dirty="0">
              <a:latin typeface="Times New Roman"/>
              <a:cs typeface="Times New Roman"/>
            </a:rPr>
            <a:t> </a:t>
          </a:r>
          <a:r>
            <a:rPr lang="fi-FI" sz="1000" kern="1200" dirty="0" err="1">
              <a:latin typeface="Times New Roman"/>
              <a:cs typeface="Times New Roman"/>
            </a:rPr>
            <a:t>process</a:t>
          </a:r>
          <a:endParaRPr lang="fi-FI" sz="1000" kern="1200" dirty="0">
            <a:latin typeface="Times New Roman"/>
            <a:cs typeface="Times New Roman"/>
          </a:endParaRPr>
        </a:p>
        <a:p>
          <a:pPr marL="57150" lvl="1" indent="-57150" algn="l" defTabSz="4445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fi-FI" sz="1000" kern="1200" dirty="0">
            <a:latin typeface="Times New Roman"/>
            <a:cs typeface="Times New Roman"/>
          </a:endParaRPr>
        </a:p>
      </dsp:txBody>
      <dsp:txXfrm>
        <a:off x="6494737" y="773952"/>
        <a:ext cx="1366457" cy="2837063"/>
      </dsp:txXfrm>
    </dsp:sp>
    <dsp:sp modelId="{00F92ED2-8383-4C75-934C-DD3E3B3E92E2}">
      <dsp:nvSpPr>
        <dsp:cNvPr id="0" name=""/>
        <dsp:cNvSpPr/>
      </dsp:nvSpPr>
      <dsp:spPr>
        <a:xfrm>
          <a:off x="6327639" y="656230"/>
          <a:ext cx="136283" cy="3831606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831606"/>
              </a:lnTo>
              <a:lnTo>
                <a:pt x="136283" y="3831606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53836E7-3FB0-46DA-AFC2-3771AA2A0B7F}">
      <dsp:nvSpPr>
        <dsp:cNvPr id="0" name=""/>
        <dsp:cNvSpPr/>
      </dsp:nvSpPr>
      <dsp:spPr>
        <a:xfrm>
          <a:off x="6463922" y="3738349"/>
          <a:ext cx="1434593" cy="1498974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Getting organisational support during onboarding 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Having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ganisational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guideline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to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upport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nboarding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Using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ganisational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upport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ervice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to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rovid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induction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raining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fi-FI" sz="1000" kern="1200">
            <a:latin typeface="Times New Roman"/>
            <a:cs typeface="Times New Roman"/>
          </a:endParaRPr>
        </a:p>
      </dsp:txBody>
      <dsp:txXfrm>
        <a:off x="6505940" y="3780367"/>
        <a:ext cx="1350557" cy="1414938"/>
      </dsp:txXfrm>
    </dsp:sp>
    <dsp:sp modelId="{965CA15E-62FB-4179-B46A-579BF35E0EBB}">
      <dsp:nvSpPr>
        <dsp:cNvPr id="0" name=""/>
        <dsp:cNvSpPr/>
      </dsp:nvSpPr>
      <dsp:spPr>
        <a:xfrm>
          <a:off x="8214536" y="7485"/>
          <a:ext cx="1226626" cy="613313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i-FI" sz="1000" kern="1200" dirty="0">
              <a:solidFill>
                <a:schemeClr val="tx1"/>
              </a:solidFill>
              <a:latin typeface="Times New Roman"/>
              <a:cs typeface="Times New Roman"/>
            </a:rPr>
            <a:t>Strengthening workplace bounds through onboarding</a:t>
          </a:r>
        </a:p>
      </dsp:txBody>
      <dsp:txXfrm>
        <a:off x="8232499" y="25448"/>
        <a:ext cx="1190700" cy="577387"/>
      </dsp:txXfrm>
    </dsp:sp>
    <dsp:sp modelId="{B8AD6272-8DDB-4B30-97DF-AC2AE814334E}">
      <dsp:nvSpPr>
        <dsp:cNvPr id="0" name=""/>
        <dsp:cNvSpPr/>
      </dsp:nvSpPr>
      <dsp:spPr>
        <a:xfrm>
          <a:off x="8337199" y="620798"/>
          <a:ext cx="133866" cy="87111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71119"/>
              </a:lnTo>
              <a:lnTo>
                <a:pt x="133866" y="871119"/>
              </a:lnTo>
            </a:path>
          </a:pathLst>
        </a:cu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EA6F7D1-713E-4973-AC32-EC1DC3C18412}">
      <dsp:nvSpPr>
        <dsp:cNvPr id="0" name=""/>
        <dsp:cNvSpPr/>
      </dsp:nvSpPr>
      <dsp:spPr>
        <a:xfrm>
          <a:off x="8471065" y="730851"/>
          <a:ext cx="1556598" cy="1522132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Familiarisation with the organisational working environment during onboarding  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Gaining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insight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into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ganisation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ientation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on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work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unit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and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it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olicies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etworking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with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partners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within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he</a:t>
          </a:r>
          <a:r>
            <a:rPr lang="fi-FI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i-FI" sz="10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organisation</a:t>
          </a:r>
          <a:endParaRPr lang="fi-FI" sz="10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8515647" y="775433"/>
        <a:ext cx="1467434" cy="1432968"/>
      </dsp:txXfrm>
    </dsp:sp>
    <dsp:sp modelId="{440E5204-EE43-4489-8F31-6EE4118839F5}">
      <dsp:nvSpPr>
        <dsp:cNvPr id="0" name=""/>
        <dsp:cNvSpPr/>
      </dsp:nvSpPr>
      <dsp:spPr>
        <a:xfrm>
          <a:off x="8337199" y="620798"/>
          <a:ext cx="151451" cy="259648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596485"/>
              </a:lnTo>
              <a:lnTo>
                <a:pt x="151451" y="2596485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9EC0132-64F1-423F-9C1E-EC1E02508013}">
      <dsp:nvSpPr>
        <dsp:cNvPr id="0" name=""/>
        <dsp:cNvSpPr/>
      </dsp:nvSpPr>
      <dsp:spPr>
        <a:xfrm>
          <a:off x="8488650" y="2329041"/>
          <a:ext cx="1568325" cy="1776486"/>
        </a:xfrm>
        <a:prstGeom prst="roundRect">
          <a:avLst>
            <a:gd name="adj" fmla="val 10000"/>
          </a:avLst>
        </a:prstGeom>
        <a:noFill/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t" anchorCtr="0">
          <a:noAutofit/>
        </a:bodyPr>
        <a:lstStyle/>
        <a:p>
          <a:pPr marL="0" lvl="0" indent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rPr>
            <a:t>Orientation on the work community during onboarding </a:t>
          </a:r>
          <a:endParaRPr lang="fi-FI" sz="1000" i="0" kern="1200" dirty="0">
            <a:latin typeface="Times New Roman"/>
            <a:cs typeface="Times New Roman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i="0" kern="1200" dirty="0" err="1">
              <a:latin typeface="Times New Roman"/>
              <a:cs typeface="Times New Roman"/>
            </a:rPr>
            <a:t>Gaining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the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trust</a:t>
          </a:r>
          <a:r>
            <a:rPr lang="fi-FI" sz="1000" i="0" kern="1200" dirty="0">
              <a:latin typeface="Times New Roman"/>
              <a:cs typeface="Times New Roman"/>
            </a:rPr>
            <a:t> of </a:t>
          </a:r>
          <a:r>
            <a:rPr lang="fi-FI" sz="1000" i="0" kern="1200" dirty="0" err="1">
              <a:latin typeface="Times New Roman"/>
              <a:cs typeface="Times New Roman"/>
            </a:rPr>
            <a:t>the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new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work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community</a:t>
          </a:r>
          <a:endParaRPr lang="fi-FI" sz="1000" i="0" kern="1200" dirty="0">
            <a:latin typeface="Times New Roman"/>
            <a:cs typeface="Times New Roman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i="0" kern="1200" dirty="0" err="1">
              <a:latin typeface="Times New Roman"/>
              <a:cs typeface="Times New Roman"/>
            </a:rPr>
            <a:t>Introduction</a:t>
          </a:r>
          <a:r>
            <a:rPr lang="fi-FI" sz="1000" i="0" kern="1200" dirty="0">
              <a:latin typeface="Times New Roman"/>
              <a:cs typeface="Times New Roman"/>
            </a:rPr>
            <a:t> to </a:t>
          </a:r>
          <a:r>
            <a:rPr lang="fi-FI" sz="1000" i="0" kern="1200" dirty="0" err="1">
              <a:latin typeface="Times New Roman"/>
              <a:cs typeface="Times New Roman"/>
            </a:rPr>
            <a:t>the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word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community</a:t>
          </a:r>
          <a:r>
            <a:rPr lang="fi-FI" sz="1000" i="0" kern="1200" dirty="0">
              <a:latin typeface="Times New Roman"/>
              <a:cs typeface="Times New Roman"/>
            </a:rPr>
            <a:t> at </a:t>
          </a:r>
          <a:r>
            <a:rPr lang="fi-FI" sz="1000" i="0" kern="1200" dirty="0" err="1">
              <a:latin typeface="Times New Roman"/>
              <a:cs typeface="Times New Roman"/>
            </a:rPr>
            <a:t>the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beginning</a:t>
          </a:r>
          <a:r>
            <a:rPr lang="fi-FI" sz="1000" i="0" kern="1200" dirty="0">
              <a:latin typeface="Times New Roman"/>
              <a:cs typeface="Times New Roman"/>
            </a:rPr>
            <a:t> of </a:t>
          </a:r>
          <a:r>
            <a:rPr lang="fi-FI" sz="1000" i="0" kern="1200" dirty="0" err="1">
              <a:latin typeface="Times New Roman"/>
              <a:cs typeface="Times New Roman"/>
            </a:rPr>
            <a:t>the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onboarding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process</a:t>
          </a:r>
          <a:endParaRPr lang="fi-FI" sz="1000" i="0" kern="1200" dirty="0">
            <a:latin typeface="Times New Roman"/>
            <a:cs typeface="Times New Roman"/>
          </a:endParaRPr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Familiarisation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with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the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work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community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during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the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onboarding</a:t>
          </a:r>
          <a:r>
            <a:rPr lang="fi-FI" sz="1000" i="0" kern="1200" dirty="0">
              <a:latin typeface="Times New Roman"/>
              <a:cs typeface="Times New Roman"/>
            </a:rPr>
            <a:t> </a:t>
          </a:r>
          <a:r>
            <a:rPr lang="fi-FI" sz="1000" i="0" kern="1200" dirty="0" err="1">
              <a:latin typeface="Times New Roman"/>
              <a:cs typeface="Times New Roman"/>
            </a:rPr>
            <a:t>process</a:t>
          </a:r>
          <a:endParaRPr lang="fi-FI" sz="1000" i="0" kern="1200" dirty="0">
            <a:latin typeface="Times New Roman"/>
            <a:cs typeface="Times New Roman"/>
          </a:endParaRPr>
        </a:p>
        <a:p>
          <a:pPr marL="57150" lvl="1" indent="-57150" algn="l" defTabSz="355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fi-FI" sz="800" i="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8534585" y="2374976"/>
        <a:ext cx="1476455" cy="168461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3">
  <dgm:title val=""/>
  <dgm:desc val=""/>
  <dgm:catLst>
    <dgm:cat type="hierarchy" pri="7000"/>
    <dgm:cat type="list" pri="23000"/>
    <dgm:cat type="relationship" pri="15000"/>
    <dgm:cat type="convert" pri="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</dgm:ptLst>
      <dgm:cxnLst>
        <dgm:cxn modelId="4" srcId="0" destId="1" srcOrd="0" destOrd="0"/>
        <dgm:cxn modelId="5" srcId="1" destId="11" srcOrd="0" destOrd="0"/>
        <dgm:cxn modelId="6" srcId="1" destId="12" srcOrd="1" destOrd="0"/>
        <dgm:cxn modelId="7" srcId="0" destId="2" srcOrd="1" destOrd="0"/>
        <dgm:cxn modelId="8" srcId="2" destId="21" srcOrd="0" destOrd="0"/>
        <dgm:cxn modelId="9" srcId="2" destId="2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forName="rootText" op="equ" val="65"/>
      <dgm:constr type="primFontSz" for="des" forName="childText" op="equ" val="65"/>
      <dgm:constr type="w" for="des" forName="rootComposite" refType="w"/>
      <dgm:constr type="h" for="des" forName="rootComposite" refType="w" fact="0.5"/>
      <dgm:constr type="w" for="des" forName="childText" refType="w" refFor="des" refForName="rootComposite" fact="0.8"/>
      <dgm:constr type="h" for="des" forName="childText" refType="h" refFor="des" refForName="rootComposite"/>
      <dgm:constr type="sibSp" refType="w" refFor="des" refForName="rootComposite" fact="0.25"/>
      <dgm:constr type="sibSp" for="des" forName="childShape" refType="h" refFor="des" refForName="childText" fact="0.25"/>
      <dgm:constr type="sp" for="des" forName="root" refType="h" refFor="des" refForName="childText" fact="0.25"/>
    </dgm:constrLst>
    <dgm:ruleLst/>
    <dgm:forEach name="Name3" axis="ch">
      <dgm:forEach name="Name4" axis="self" ptType="node" cnt="1">
        <dgm:layoutNode name="root">
          <dgm:choose name="Name5">
            <dgm:if name="Name6" func="var" arg="dir" op="equ" val="norm">
              <dgm:alg type="hierRoot">
                <dgm:param type="hierAlign" val="tL"/>
              </dgm:alg>
            </dgm:if>
            <dgm:else name="Name7">
              <dgm:alg type="hierRoot">
                <dgm:param type="hierAlign" val="tR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>
            <dgm:constr type="alignOff" val="0.2"/>
          </dgm:constrLst>
          <dgm:ruleLst/>
          <dgm:layoutNode name="rootComposite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8">
              <dgm:if name="Name9" func="var" arg="dir" op="equ" val="norm">
                <dgm:constrLst>
                  <dgm:constr type="l" for="ch" forName="rootText"/>
                  <dgm:constr type="t" for="ch" forName="rootText"/>
                  <dgm:constr type="w" for="ch" forName="rootText" refType="w"/>
                  <dgm:constr type="h" for="ch" forName="rootText" refType="h"/>
                  <dgm:constr type="l" for="ch" forName="rootConnector"/>
                  <dgm:constr type="t" for="ch" forName="rootConnector"/>
                  <dgm:constr type="w" for="ch" forName="rootConnector" refType="w" refFor="ch" refForName="rootText" fact="0.2"/>
                  <dgm:constr type="h" for="ch" forName="rootConnector" refType="h" refFor="ch" refForName="rootText"/>
                </dgm:constrLst>
              </dgm:if>
              <dgm:else name="Name10">
                <dgm:constrLst>
                  <dgm:constr type="l" for="ch" forName="rootText"/>
                  <dgm:constr type="t" for="ch" forName="rootText"/>
                  <dgm:constr type="w" for="ch" forName="rootText" refType="w"/>
                  <dgm:constr type="h" for="ch" forName="rootText" refType="h"/>
                  <dgm:constr type="r" for="ch" forName="rootConnector" refType="w"/>
                  <dgm:constr type="t" for="ch" forName="rootConnector"/>
                  <dgm:constr type="w" for="ch" forName="rootConnector" refType="w" refFor="ch" refForName="rootText" fact="0.2"/>
                  <dgm:constr type="h" for="ch" forName="rootConnector" refType="h" refFor="ch" refForName="rootText"/>
                </dgm:constrLst>
              </dgm:else>
            </dgm:choose>
            <dgm:ruleLst/>
            <dgm:layoutNode name="rootText" styleLbl="node1"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 ptType="node" cnt="1"/>
              <dgm:constrLst>
                <dgm:constr type="tMarg" refType="primFontSz" fact="0.1"/>
                <dgm:constr type="bMarg" refType="primFontSz" fact="0.1"/>
                <dgm:constr type="lMarg" refType="primFontSz" fact="0.15"/>
                <dgm:constr type="rMarg" refType="primFontSz" fact="0.15"/>
              </dgm:constrLst>
              <dgm:ruleLst>
                <dgm:rule type="primFontSz" val="5" fact="NaN" max="NaN"/>
              </dgm:ruleLst>
            </dgm:layoutNode>
            <dgm:layoutNode name="rootConnector" moveWith="rootText">
              <dgm:alg type="sp"/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self" ptType="node" cnt="1"/>
              <dgm:constrLst/>
              <dgm:ruleLst/>
            </dgm:layoutNode>
          </dgm:layoutNode>
          <dgm:layoutNode name="childShape">
            <dgm:alg type="hierChild">
              <dgm:param type="chAlign" val="l"/>
              <dgm:param type="linDir" val="fromT"/>
            </dgm:alg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11" axis="ch">
              <dgm:forEach name="Name12" axis="self" ptType="parTrans" cnt="1">
                <dgm:layoutNode name="Name13">
                  <dgm:choose name="Name14">
                    <dgm:if name="Name15" func="var" arg="dir" op="equ" val="norm">
                      <dgm:alg type="conn">
                        <dgm:param type="dim" val="1D"/>
                        <dgm:param type="endSty" val="noArr"/>
                        <dgm:param type="connRout" val="bend"/>
                        <dgm:param type="srcNode" val="rootConnector"/>
                        <dgm:param type="begPts" val="bCtr"/>
                        <dgm:param type="endPts" val="midL"/>
                      </dgm:alg>
                    </dgm:if>
                    <dgm:else name="Name16">
                      <dgm:alg type="conn">
                        <dgm:param type="dim" val="1D"/>
                        <dgm:param type="endSty" val="noArr"/>
                        <dgm:param type="connRout" val="bend"/>
                        <dgm:param type="srcNode" val="rootConnector"/>
                        <dgm:param type="begPts" val="bCtr"/>
                        <dgm:param type="endPts" val="mid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7" axis="self" ptType="node">
                <dgm:layoutNode name="childText" styleLbl="bgAcc1">
                  <dgm:varLst>
                    <dgm:bulletEnabled val="1"/>
                  </dgm:varLst>
                  <dgm:alg type="tx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self desOrSelf" ptType="node node" st="1 1" cnt="1 0"/>
                  <dgm:constrLst>
                    <dgm:constr type="tMarg" refType="primFontSz" fact="0.1"/>
                    <dgm:constr type="bMarg" refType="primFontSz" fact="0.1"/>
                    <dgm:constr type="lMarg" refType="primFontSz" fact="0.15"/>
                    <dgm:constr type="rMarg" refType="primFontSz" fact="0.15"/>
                  </dgm:constrLst>
                  <dgm:ruleLst>
                    <dgm:rule type="primFontSz" val="5" fact="NaN" max="NaN"/>
                  </dgm:ruleLst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E8E304-123B-49B9-BD48-8AA5515823A2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8D8EC1-AC24-464E-B0F6-A5C6D11C4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0920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8D8EC1-AC24-464E-B0F6-A5C6D11C473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5880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2EB15E-FA4D-2303-1D20-8ADF28A1A9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D28C350-5976-42C0-AABD-B61615807E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BBCCDE-9362-415D-39CA-AAF97630E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DFC66B-3452-3F38-C563-758390806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12D2F2-3CDE-7E6C-86A1-A89C78D8C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690632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0D6446-7C9A-C2B1-3CCF-A550EF6B76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A1BC88-9DDF-CFBF-7C4B-6A7D6476F7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7A7936-F917-3503-7D99-6A6B55C6B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89C76F-66E1-D67F-17BF-161BF55E5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DD447A-E130-9D79-B1F4-D75025344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26670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EFBD4F0-A304-D07A-A4EC-BC56D7E78D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5F2C98-19FD-CFD6-6275-69C8FC20F2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6D0E6D-7DB8-9400-C459-A7A242BB9F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59DE2B-0B5F-07C9-DF12-BE4E1CD278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BBFDAF-47C7-BBF3-31FA-8FE7BAF29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810954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ADE85B-27F4-B55C-E332-9FDD76FF5D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526598-6F40-0804-8D29-DDAB468884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E19501-6A3E-C831-87C2-31D5E824E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D370A5-820B-7063-D17E-FE70CEDE7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1675CB-A619-7C19-CB82-C276E4076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115646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65352C-7FB8-B04D-1F9F-112C94A48B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25B49A-2586-794B-2B82-33F699BA05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281D3B-61AB-B3DE-5503-2CE015849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C76DE9-321C-46E8-884C-DC909D871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DD3903-27F1-937B-2F72-E71A6B1CA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577155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E89F4C-E221-2ADF-7007-AFC7A790D4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AE48A9-1F0F-EF22-C451-4D1BED97E8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E89300-F0E5-1A47-5A3C-B846EA704B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D36964-5775-DBFB-B39F-892BF5704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E5E56D-F803-13AF-21FC-18A64FD18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866A49-5CEA-2EE3-964B-975B3882F1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04190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80E20-F07F-B9E5-717E-D51E826DD8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4C6E0B-05CF-A928-E5CC-86B846C384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38EAEE-5727-75F6-3779-4A85CB8172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A1A0AE-358B-4BEA-7605-4F2327D03C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993E00-38BB-E91F-C5B8-52E5E7E5AD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BAAAE9-2E7E-7222-81DE-506A48B41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D7B3F76-0088-6271-3B1B-84DE668E8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97D62F3-ABA3-2D8B-37CC-8626289DD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256124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5CBB06-21AA-5E02-80CE-B50F53C51C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2EE1A0B-DEDC-CAE6-AB94-1CB7A6E269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4C071C-E09F-A34F-2074-DAC394A28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F23128-7F98-4F10-1D10-B702BD481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584670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3F16451-A344-1F42-6BDB-383285EFC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7B79D7-E43B-412E-6561-F6B26A7E4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7A5B3A9-13AC-990B-7897-2F1C37174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524393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E3A8C-C608-E3F5-C582-9273035A1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069CD0-38D2-919F-309B-AC89CDDD0E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8E6BC8-3F99-3535-6FE3-6BCB5CF353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EEBB77-2E90-F1BB-BD06-A5420888A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932890-54B3-8A49-DEED-293DC14FE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643B21-47F8-AC68-4FB0-F946749BF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629192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72B59D-6BDA-4EBB-CF25-862FBD3A90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3152B2-6F25-E3B1-D1DC-45BA694796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1E51EA-5595-B3C4-CB22-367EA03CD2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6A2C5E-A27A-BEC5-C253-6368D69D3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A39372-1C48-9B7C-5F12-0688ED1C9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996566-A352-7279-E6A7-7F5E8606E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78233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30F0C0C-8051-09A3-2837-D97ADD4206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521C6C-F011-60E7-3D6F-00DEF5431A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BDB276-662F-731E-D863-D54B142973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08957-9A49-40A7-ACD0-A61D98EB9210}" type="datetimeFigureOut">
              <a:rPr lang="fi-FI" smtClean="0"/>
              <a:t>19.2.2026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6A8EBA-9A02-8E48-4172-FEC7BD4257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A87A39-637A-7877-F569-E6D4964FC4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6E8452-C19F-40E3-8CE9-D8E5DD0B67E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240389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613D76A-47B7-CBC8-7666-7DDD0F1A5A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38DC22AF-B9D7-843C-EBEC-A9AB656AECE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74231320"/>
              </p:ext>
            </p:extLst>
          </p:nvPr>
        </p:nvGraphicFramePr>
        <p:xfrm>
          <a:off x="501606" y="124183"/>
          <a:ext cx="10456320" cy="660963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312D811-2222-CC9D-A771-CFFE26E5F786}"/>
              </a:ext>
            </a:extLst>
          </p:cNvPr>
          <p:cNvSpPr txBox="1"/>
          <p:nvPr/>
        </p:nvSpPr>
        <p:spPr>
          <a:xfrm>
            <a:off x="696687" y="5718628"/>
            <a:ext cx="33044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 Figure 1. Nurse Managers’ Perceptions on Effective Onboarding for Front-line Nurse Managers in Healthcare (n = 18).  </a:t>
            </a:r>
            <a:endParaRPr lang="fi-FI" sz="1200" dirty="0"/>
          </a:p>
        </p:txBody>
      </p:sp>
    </p:spTree>
    <p:extLst>
      <p:ext uri="{BB962C8B-B14F-4D97-AF65-F5344CB8AC3E}">
        <p14:creationId xmlns:p14="http://schemas.microsoft.com/office/powerpoint/2010/main" val="72621404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D469CF120BEFF4D9342122BFA7DE54A" ma:contentTypeVersion="4" ma:contentTypeDescription="Create a new document." ma:contentTypeScope="" ma:versionID="a9cae2b57e813f9e6a9babe4f99418a5">
  <xsd:schema xmlns:xsd="http://www.w3.org/2001/XMLSchema" xmlns:xs="http://www.w3.org/2001/XMLSchema" xmlns:p="http://schemas.microsoft.com/office/2006/metadata/properties" xmlns:ns2="f3c313ad-3c94-413c-ab63-260349d07e4f" targetNamespace="http://schemas.microsoft.com/office/2006/metadata/properties" ma:root="true" ma:fieldsID="bbf31fa66102db6f10b8da9375979580" ns2:_="">
    <xsd:import namespace="f3c313ad-3c94-413c-ab63-260349d07e4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3c313ad-3c94-413c-ab63-260349d07e4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8B82CA4E-F69C-472D-AE42-403C72E18E5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3c313ad-3c94-413c-ab63-260349d07e4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04B6CCB-D1B1-4D16-B739-D1E85A0B852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02BE0E9-92FF-4950-857B-794AC517D5B9}">
  <ds:schemaRefs>
    <ds:schemaRef ds:uri="http://schemas.microsoft.com/office/2006/documentManagement/types"/>
    <ds:schemaRef ds:uri="http://purl.org/dc/elements/1.1/"/>
    <ds:schemaRef ds:uri="http://purl.org/dc/dcmitype/"/>
    <ds:schemaRef ds:uri="http://purl.org/dc/terms/"/>
    <ds:schemaRef ds:uri="http://schemas.microsoft.com/office/2006/metadata/properties"/>
    <ds:schemaRef ds:uri="http://schemas.microsoft.com/office/infopath/2007/PartnerControls"/>
    <ds:schemaRef ds:uri="http://www.w3.org/XML/1998/namespace"/>
    <ds:schemaRef ds:uri="http://schemas.openxmlformats.org/package/2006/metadata/core-properties"/>
    <ds:schemaRef ds:uri="f3c313ad-3c94-413c-ab63-260349d07e4f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31</TotalTime>
  <Words>370</Words>
  <Application>Microsoft Office PowerPoint</Application>
  <PresentationFormat>Widescreen</PresentationFormat>
  <Paragraphs>5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Company>University of Oul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uvi Kuha</dc:creator>
  <cp:lastModifiedBy>Outi Kanste</cp:lastModifiedBy>
  <cp:revision>2</cp:revision>
  <dcterms:created xsi:type="dcterms:W3CDTF">2025-10-01T09:55:07Z</dcterms:created>
  <dcterms:modified xsi:type="dcterms:W3CDTF">2026-02-19T05:36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D469CF120BEFF4D9342122BFA7DE54A</vt:lpwstr>
  </property>
</Properties>
</file>